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97" r:id="rId2"/>
    <p:sldId id="287" r:id="rId3"/>
    <p:sldId id="302" r:id="rId4"/>
  </p:sldIdLst>
  <p:sldSz cx="6858000" cy="9144000" type="screen4x3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mily Thoday-Kennedy" initials="ET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2B7BA3E-38CC-4BE9-BF73-61915C25F211}" v="1" dt="2021-05-14T00:20:37.882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6588" autoAdjust="0"/>
    <p:restoredTop sz="94590"/>
  </p:normalViewPr>
  <p:slideViewPr>
    <p:cSldViewPr snapToGrid="0">
      <p:cViewPr varScale="1">
        <p:scale>
          <a:sx n="83" d="100"/>
          <a:sy n="83" d="100"/>
        </p:scale>
        <p:origin x="3821" y="8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11" Type="http://schemas.microsoft.com/office/2016/11/relationships/changesInfo" Target="changesInfos/changesInfo1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Emily L Thoday-Kennedy (DJPR)" userId="21326440-ac07-4837-a38f-5acc3ccf5e65" providerId="ADAL" clId="{8533BCE1-0E39-4D95-AEC5-7FF49A1CA237}"/>
    <pc:docChg chg="modSld">
      <pc:chgData name="Emily L Thoday-Kennedy (DJPR)" userId="21326440-ac07-4837-a38f-5acc3ccf5e65" providerId="ADAL" clId="{8533BCE1-0E39-4D95-AEC5-7FF49A1CA237}" dt="2020-07-05T05:06:49.721" v="1" actId="20578"/>
      <pc:docMkLst>
        <pc:docMk/>
      </pc:docMkLst>
      <pc:sldChg chg="modSp">
        <pc:chgData name="Emily L Thoday-Kennedy (DJPR)" userId="21326440-ac07-4837-a38f-5acc3ccf5e65" providerId="ADAL" clId="{8533BCE1-0E39-4D95-AEC5-7FF49A1CA237}" dt="2020-07-05T05:06:49.721" v="1" actId="20578"/>
        <pc:sldMkLst>
          <pc:docMk/>
          <pc:sldMk cId="1714178413" sldId="297"/>
        </pc:sldMkLst>
        <pc:spChg chg="mod">
          <ac:chgData name="Emily L Thoday-Kennedy (DJPR)" userId="21326440-ac07-4837-a38f-5acc3ccf5e65" providerId="ADAL" clId="{8533BCE1-0E39-4D95-AEC5-7FF49A1CA237}" dt="2020-07-05T05:06:49.721" v="1" actId="20578"/>
          <ac:spMkLst>
            <pc:docMk/>
            <pc:sldMk cId="1714178413" sldId="297"/>
            <ac:spMk id="16" creationId="{9EEE3FFE-1C4D-4254-BB5F-4E50E8AB330F}"/>
          </ac:spMkLst>
        </pc:spChg>
      </pc:sldChg>
    </pc:docChg>
  </pc:docChgLst>
  <pc:docChgLst>
    <pc:chgData name="Emily L Thoday-Kennedy (DJPR)" userId="21326440-ac07-4837-a38f-5acc3ccf5e65" providerId="ADAL" clId="{334A6EBA-707A-4593-A136-6347609491F9}"/>
    <pc:docChg chg="undo custSel modSld">
      <pc:chgData name="Emily L Thoday-Kennedy (DJPR)" userId="21326440-ac07-4837-a38f-5acc3ccf5e65" providerId="ADAL" clId="{334A6EBA-707A-4593-A136-6347609491F9}" dt="2020-06-15T04:37:42.095" v="264" actId="20577"/>
      <pc:docMkLst>
        <pc:docMk/>
      </pc:docMkLst>
      <pc:sldChg chg="addSp delSp modSp">
        <pc:chgData name="Emily L Thoday-Kennedy (DJPR)" userId="21326440-ac07-4837-a38f-5acc3ccf5e65" providerId="ADAL" clId="{334A6EBA-707A-4593-A136-6347609491F9}" dt="2020-06-15T04:37:12.593" v="249" actId="1038"/>
        <pc:sldMkLst>
          <pc:docMk/>
          <pc:sldMk cId="2555432452" sldId="287"/>
        </pc:sldMkLst>
        <pc:spChg chg="add del mod">
          <ac:chgData name="Emily L Thoday-Kennedy (DJPR)" userId="21326440-ac07-4837-a38f-5acc3ccf5e65" providerId="ADAL" clId="{334A6EBA-707A-4593-A136-6347609491F9}" dt="2020-06-15T04:35:56.843" v="20" actId="478"/>
          <ac:spMkLst>
            <pc:docMk/>
            <pc:sldMk cId="2555432452" sldId="287"/>
            <ac:spMk id="2" creationId="{68A50B8E-84DC-499C-B249-EE428D980575}"/>
          </ac:spMkLst>
        </pc:spChg>
        <pc:spChg chg="add mod">
          <ac:chgData name="Emily L Thoday-Kennedy (DJPR)" userId="21326440-ac07-4837-a38f-5acc3ccf5e65" providerId="ADAL" clId="{334A6EBA-707A-4593-A136-6347609491F9}" dt="2020-06-15T04:36:34.413" v="36" actId="1036"/>
          <ac:spMkLst>
            <pc:docMk/>
            <pc:sldMk cId="2555432452" sldId="287"/>
            <ac:spMk id="3" creationId="{912F9330-864A-413E-885B-D4C69CE30BFD}"/>
          </ac:spMkLst>
        </pc:spChg>
        <pc:spChg chg="mod">
          <ac:chgData name="Emily L Thoday-Kennedy (DJPR)" userId="21326440-ac07-4837-a38f-5acc3ccf5e65" providerId="ADAL" clId="{334A6EBA-707A-4593-A136-6347609491F9}" dt="2020-06-15T04:35:30.346" v="15" actId="20577"/>
          <ac:spMkLst>
            <pc:docMk/>
            <pc:sldMk cId="2555432452" sldId="287"/>
            <ac:spMk id="8" creationId="{E1F54084-EC5D-44F3-87F8-95952926DEB7}"/>
          </ac:spMkLst>
        </pc:spChg>
        <pc:spChg chg="add mod">
          <ac:chgData name="Emily L Thoday-Kennedy (DJPR)" userId="21326440-ac07-4837-a38f-5acc3ccf5e65" providerId="ADAL" clId="{334A6EBA-707A-4593-A136-6347609491F9}" dt="2020-06-15T04:36:48.839" v="107" actId="1037"/>
          <ac:spMkLst>
            <pc:docMk/>
            <pc:sldMk cId="2555432452" sldId="287"/>
            <ac:spMk id="9" creationId="{10A6BF1A-0D98-460E-9E8C-3F22960BFDB3}"/>
          </ac:spMkLst>
        </pc:spChg>
        <pc:spChg chg="add mod">
          <ac:chgData name="Emily L Thoday-Kennedy (DJPR)" userId="21326440-ac07-4837-a38f-5acc3ccf5e65" providerId="ADAL" clId="{334A6EBA-707A-4593-A136-6347609491F9}" dt="2020-06-15T04:37:00.812" v="180" actId="1037"/>
          <ac:spMkLst>
            <pc:docMk/>
            <pc:sldMk cId="2555432452" sldId="287"/>
            <ac:spMk id="11" creationId="{042A1997-B701-47D1-AE64-4521009C02CA}"/>
          </ac:spMkLst>
        </pc:spChg>
        <pc:spChg chg="add mod">
          <ac:chgData name="Emily L Thoday-Kennedy (DJPR)" userId="21326440-ac07-4837-a38f-5acc3ccf5e65" providerId="ADAL" clId="{334A6EBA-707A-4593-A136-6347609491F9}" dt="2020-06-15T04:37:12.593" v="249" actId="1038"/>
          <ac:spMkLst>
            <pc:docMk/>
            <pc:sldMk cId="2555432452" sldId="287"/>
            <ac:spMk id="12" creationId="{51511A5D-4516-4C7B-959A-5C6E1A523FFB}"/>
          </ac:spMkLst>
        </pc:spChg>
        <pc:graphicFrameChg chg="mod">
          <ac:chgData name="Emily L Thoday-Kennedy (DJPR)" userId="21326440-ac07-4837-a38f-5acc3ccf5e65" providerId="ADAL" clId="{334A6EBA-707A-4593-A136-6347609491F9}" dt="2020-06-15T04:36:05.910" v="21" actId="2711"/>
          <ac:graphicFrameMkLst>
            <pc:docMk/>
            <pc:sldMk cId="2555432452" sldId="287"/>
            <ac:graphicFrameMk id="10" creationId="{B6E06077-0B3C-4C2C-AFD6-91417C8F5123}"/>
          </ac:graphicFrameMkLst>
        </pc:graphicFrameChg>
      </pc:sldChg>
      <pc:sldChg chg="modSp">
        <pc:chgData name="Emily L Thoday-Kennedy (DJPR)" userId="21326440-ac07-4837-a38f-5acc3ccf5e65" providerId="ADAL" clId="{334A6EBA-707A-4593-A136-6347609491F9}" dt="2020-06-15T04:37:42.095" v="264" actId="20577"/>
        <pc:sldMkLst>
          <pc:docMk/>
          <pc:sldMk cId="1714178413" sldId="297"/>
        </pc:sldMkLst>
        <pc:spChg chg="mod">
          <ac:chgData name="Emily L Thoday-Kennedy (DJPR)" userId="21326440-ac07-4837-a38f-5acc3ccf5e65" providerId="ADAL" clId="{334A6EBA-707A-4593-A136-6347609491F9}" dt="2020-06-15T04:37:42.095" v="264" actId="20577"/>
          <ac:spMkLst>
            <pc:docMk/>
            <pc:sldMk cId="1714178413" sldId="297"/>
            <ac:spMk id="16" creationId="{9EEE3FFE-1C4D-4254-BB5F-4E50E8AB330F}"/>
          </ac:spMkLst>
        </pc:spChg>
      </pc:sldChg>
    </pc:docChg>
  </pc:docChgLst>
  <pc:docChgLst>
    <pc:chgData name="Emily L Thoday-Kennedy (DJPR)" userId="21326440-ac07-4837-a38f-5acc3ccf5e65" providerId="ADAL" clId="{566A31EE-1665-48E8-ACE3-4C6387C1CBB9}"/>
    <pc:docChg chg="modSld">
      <pc:chgData name="Emily L Thoday-Kennedy (DJPR)" userId="21326440-ac07-4837-a38f-5acc3ccf5e65" providerId="ADAL" clId="{566A31EE-1665-48E8-ACE3-4C6387C1CBB9}" dt="2021-01-26T21:38:24.308" v="7" actId="20577"/>
      <pc:docMkLst>
        <pc:docMk/>
      </pc:docMkLst>
      <pc:sldChg chg="modSp">
        <pc:chgData name="Emily L Thoday-Kennedy (DJPR)" userId="21326440-ac07-4837-a38f-5acc3ccf5e65" providerId="ADAL" clId="{566A31EE-1665-48E8-ACE3-4C6387C1CBB9}" dt="2021-01-26T21:38:24.308" v="7" actId="20577"/>
        <pc:sldMkLst>
          <pc:docMk/>
          <pc:sldMk cId="1714178413" sldId="297"/>
        </pc:sldMkLst>
        <pc:spChg chg="mod">
          <ac:chgData name="Emily L Thoday-Kennedy (DJPR)" userId="21326440-ac07-4837-a38f-5acc3ccf5e65" providerId="ADAL" clId="{566A31EE-1665-48E8-ACE3-4C6387C1CBB9}" dt="2021-01-26T21:38:09.210" v="1" actId="20577"/>
          <ac:spMkLst>
            <pc:docMk/>
            <pc:sldMk cId="1714178413" sldId="297"/>
            <ac:spMk id="14" creationId="{4B67F386-1CA9-47DA-AD80-C3E122686181}"/>
          </ac:spMkLst>
        </pc:spChg>
        <pc:spChg chg="mod">
          <ac:chgData name="Emily L Thoday-Kennedy (DJPR)" userId="21326440-ac07-4837-a38f-5acc3ccf5e65" providerId="ADAL" clId="{566A31EE-1665-48E8-ACE3-4C6387C1CBB9}" dt="2021-01-26T21:38:12.902" v="3" actId="20577"/>
          <ac:spMkLst>
            <pc:docMk/>
            <pc:sldMk cId="1714178413" sldId="297"/>
            <ac:spMk id="15" creationId="{A0D368D0-3438-416D-B60F-FEECC96880E1}"/>
          </ac:spMkLst>
        </pc:spChg>
        <pc:spChg chg="mod">
          <ac:chgData name="Emily L Thoday-Kennedy (DJPR)" userId="21326440-ac07-4837-a38f-5acc3ccf5e65" providerId="ADAL" clId="{566A31EE-1665-48E8-ACE3-4C6387C1CBB9}" dt="2021-01-26T21:38:24.308" v="7" actId="20577"/>
          <ac:spMkLst>
            <pc:docMk/>
            <pc:sldMk cId="1714178413" sldId="297"/>
            <ac:spMk id="16" creationId="{9EEE3FFE-1C4D-4254-BB5F-4E50E8AB330F}"/>
          </ac:spMkLst>
        </pc:spChg>
      </pc:sldChg>
    </pc:docChg>
  </pc:docChgLst>
  <pc:docChgLst>
    <pc:chgData name="Emily L Thoday-Kennedy (DJPR)" userId="21326440-ac07-4837-a38f-5acc3ccf5e65" providerId="ADAL" clId="{D822684E-EB25-4B31-AD74-21409AD28B82}"/>
    <pc:docChg chg="modSld">
      <pc:chgData name="Emily L Thoday-Kennedy (DJPR)" userId="21326440-ac07-4837-a38f-5acc3ccf5e65" providerId="ADAL" clId="{D822684E-EB25-4B31-AD74-21409AD28B82}" dt="2020-07-28T00:06:45.550" v="1" actId="20577"/>
      <pc:docMkLst>
        <pc:docMk/>
      </pc:docMkLst>
      <pc:sldChg chg="modSp">
        <pc:chgData name="Emily L Thoday-Kennedy (DJPR)" userId="21326440-ac07-4837-a38f-5acc3ccf5e65" providerId="ADAL" clId="{D822684E-EB25-4B31-AD74-21409AD28B82}" dt="2020-07-28T00:06:45.550" v="1" actId="20577"/>
        <pc:sldMkLst>
          <pc:docMk/>
          <pc:sldMk cId="2555432452" sldId="287"/>
        </pc:sldMkLst>
        <pc:spChg chg="mod">
          <ac:chgData name="Emily L Thoday-Kennedy (DJPR)" userId="21326440-ac07-4837-a38f-5acc3ccf5e65" providerId="ADAL" clId="{D822684E-EB25-4B31-AD74-21409AD28B82}" dt="2020-07-28T00:06:45.550" v="1" actId="20577"/>
          <ac:spMkLst>
            <pc:docMk/>
            <pc:sldMk cId="2555432452" sldId="287"/>
            <ac:spMk id="5" creationId="{F93C4AD5-F523-47A9-AAE2-73BBD2F085C4}"/>
          </ac:spMkLst>
        </pc:spChg>
      </pc:sldChg>
    </pc:docChg>
  </pc:docChgLst>
  <pc:docChgLst>
    <pc:chgData name="Emily" userId="21326440-ac07-4837-a38f-5acc3ccf5e65" providerId="ADAL" clId="{FB82E813-4D81-4EBB-81E1-2C203AA74B26}"/>
    <pc:docChg chg="modSld">
      <pc:chgData name="Emily" userId="21326440-ac07-4837-a38f-5acc3ccf5e65" providerId="ADAL" clId="{FB82E813-4D81-4EBB-81E1-2C203AA74B26}" dt="2020-08-21T01:21:12.655" v="6" actId="20577"/>
      <pc:docMkLst>
        <pc:docMk/>
      </pc:docMkLst>
      <pc:sldChg chg="modSp">
        <pc:chgData name="Emily" userId="21326440-ac07-4837-a38f-5acc3ccf5e65" providerId="ADAL" clId="{FB82E813-4D81-4EBB-81E1-2C203AA74B26}" dt="2020-08-21T01:18:26.109" v="0" actId="113"/>
        <pc:sldMkLst>
          <pc:docMk/>
          <pc:sldMk cId="2555432452" sldId="287"/>
        </pc:sldMkLst>
        <pc:spChg chg="mod">
          <ac:chgData name="Emily" userId="21326440-ac07-4837-a38f-5acc3ccf5e65" providerId="ADAL" clId="{FB82E813-4D81-4EBB-81E1-2C203AA74B26}" dt="2020-08-21T01:18:26.109" v="0" actId="113"/>
          <ac:spMkLst>
            <pc:docMk/>
            <pc:sldMk cId="2555432452" sldId="287"/>
            <ac:spMk id="5" creationId="{F93C4AD5-F523-47A9-AAE2-73BBD2F085C4}"/>
          </ac:spMkLst>
        </pc:spChg>
      </pc:sldChg>
      <pc:sldChg chg="modSp">
        <pc:chgData name="Emily" userId="21326440-ac07-4837-a38f-5acc3ccf5e65" providerId="ADAL" clId="{FB82E813-4D81-4EBB-81E1-2C203AA74B26}" dt="2020-08-21T01:21:12.655" v="6" actId="20577"/>
        <pc:sldMkLst>
          <pc:docMk/>
          <pc:sldMk cId="1714178413" sldId="297"/>
        </pc:sldMkLst>
        <pc:spChg chg="mod">
          <ac:chgData name="Emily" userId="21326440-ac07-4837-a38f-5acc3ccf5e65" providerId="ADAL" clId="{FB82E813-4D81-4EBB-81E1-2C203AA74B26}" dt="2020-08-21T01:21:12.655" v="6" actId="20577"/>
          <ac:spMkLst>
            <pc:docMk/>
            <pc:sldMk cId="1714178413" sldId="297"/>
            <ac:spMk id="16" creationId="{9EEE3FFE-1C4D-4254-BB5F-4E50E8AB330F}"/>
          </ac:spMkLst>
        </pc:spChg>
      </pc:sldChg>
    </pc:docChg>
  </pc:docChgLst>
  <pc:docChgLst>
    <pc:chgData name="Emily L Thoday-Kennedy (DJPR)" userId="21326440-ac07-4837-a38f-5acc3ccf5e65" providerId="ADAL" clId="{ED79222C-487F-4585-ABC6-8BCECCC3B277}"/>
    <pc:docChg chg="addSld delSld modSld">
      <pc:chgData name="Emily L Thoday-Kennedy (DJPR)" userId="21326440-ac07-4837-a38f-5acc3ccf5e65" providerId="ADAL" clId="{ED79222C-487F-4585-ABC6-8BCECCC3B277}" dt="2020-05-01T02:35:02.954" v="78"/>
      <pc:docMkLst>
        <pc:docMk/>
      </pc:docMkLst>
      <pc:sldChg chg="add del">
        <pc:chgData name="Emily L Thoday-Kennedy (DJPR)" userId="21326440-ac07-4837-a38f-5acc3ccf5e65" providerId="ADAL" clId="{ED79222C-487F-4585-ABC6-8BCECCC3B277}" dt="2020-04-22T07:07:06.834" v="3" actId="2696"/>
        <pc:sldMkLst>
          <pc:docMk/>
          <pc:sldMk cId="149864502" sldId="256"/>
        </pc:sldMkLst>
      </pc:sldChg>
      <pc:sldChg chg="add del">
        <pc:chgData name="Emily L Thoday-Kennedy (DJPR)" userId="21326440-ac07-4837-a38f-5acc3ccf5e65" providerId="ADAL" clId="{ED79222C-487F-4585-ABC6-8BCECCC3B277}" dt="2020-04-22T07:07:08.488" v="4" actId="2696"/>
        <pc:sldMkLst>
          <pc:docMk/>
          <pc:sldMk cId="2818527945" sldId="257"/>
        </pc:sldMkLst>
      </pc:sldChg>
      <pc:sldChg chg="modSp add">
        <pc:chgData name="Emily L Thoday-Kennedy (DJPR)" userId="21326440-ac07-4837-a38f-5acc3ccf5e65" providerId="ADAL" clId="{ED79222C-487F-4585-ABC6-8BCECCC3B277}" dt="2020-04-29T23:04:05.677" v="47" actId="20577"/>
        <pc:sldMkLst>
          <pc:docMk/>
          <pc:sldMk cId="2555432452" sldId="287"/>
        </pc:sldMkLst>
        <pc:spChg chg="mod">
          <ac:chgData name="Emily L Thoday-Kennedy (DJPR)" userId="21326440-ac07-4837-a38f-5acc3ccf5e65" providerId="ADAL" clId="{ED79222C-487F-4585-ABC6-8BCECCC3B277}" dt="2020-04-29T23:04:05.677" v="47" actId="20577"/>
          <ac:spMkLst>
            <pc:docMk/>
            <pc:sldMk cId="2555432452" sldId="287"/>
            <ac:spMk id="5" creationId="{F93C4AD5-F523-47A9-AAE2-73BBD2F085C4}"/>
          </ac:spMkLst>
        </pc:spChg>
        <pc:spChg chg="mod">
          <ac:chgData name="Emily L Thoday-Kennedy (DJPR)" userId="21326440-ac07-4837-a38f-5acc3ccf5e65" providerId="ADAL" clId="{ED79222C-487F-4585-ABC6-8BCECCC3B277}" dt="2020-04-29T23:03:47.562" v="34" actId="255"/>
          <ac:spMkLst>
            <pc:docMk/>
            <pc:sldMk cId="2555432452" sldId="287"/>
            <ac:spMk id="7" creationId="{396520BD-90B6-4A3E-AA4E-61FF814544D7}"/>
          </ac:spMkLst>
        </pc:spChg>
        <pc:graphicFrameChg chg="mod">
          <ac:chgData name="Emily L Thoday-Kennedy (DJPR)" userId="21326440-ac07-4837-a38f-5acc3ccf5e65" providerId="ADAL" clId="{ED79222C-487F-4585-ABC6-8BCECCC3B277}" dt="2020-04-29T23:02:38.757" v="8" actId="113"/>
          <ac:graphicFrameMkLst>
            <pc:docMk/>
            <pc:sldMk cId="2555432452" sldId="287"/>
            <ac:graphicFrameMk id="10" creationId="{B6E06077-0B3C-4C2C-AFD6-91417C8F5123}"/>
          </ac:graphicFrameMkLst>
        </pc:graphicFrameChg>
      </pc:sldChg>
      <pc:sldChg chg="modSp add">
        <pc:chgData name="Emily L Thoday-Kennedy (DJPR)" userId="21326440-ac07-4837-a38f-5acc3ccf5e65" providerId="ADAL" clId="{ED79222C-487F-4585-ABC6-8BCECCC3B277}" dt="2020-05-01T02:35:02.954" v="78"/>
        <pc:sldMkLst>
          <pc:docMk/>
          <pc:sldMk cId="1714178413" sldId="297"/>
        </pc:sldMkLst>
        <pc:spChg chg="mod">
          <ac:chgData name="Emily L Thoday-Kennedy (DJPR)" userId="21326440-ac07-4837-a38f-5acc3ccf5e65" providerId="ADAL" clId="{ED79222C-487F-4585-ABC6-8BCECCC3B277}" dt="2020-04-30T02:17:23.780" v="64" actId="20577"/>
          <ac:spMkLst>
            <pc:docMk/>
            <pc:sldMk cId="1714178413" sldId="297"/>
            <ac:spMk id="16" creationId="{9EEE3FFE-1C4D-4254-BB5F-4E50E8AB330F}"/>
          </ac:spMkLst>
        </pc:spChg>
        <pc:graphicFrameChg chg="mod">
          <ac:chgData name="Emily L Thoday-Kennedy (DJPR)" userId="21326440-ac07-4837-a38f-5acc3ccf5e65" providerId="ADAL" clId="{ED79222C-487F-4585-ABC6-8BCECCC3B277}" dt="2020-05-01T02:35:02.954" v="78"/>
          <ac:graphicFrameMkLst>
            <pc:docMk/>
            <pc:sldMk cId="1714178413" sldId="297"/>
            <ac:graphicFrameMk id="2" creationId="{2824535D-8A34-433D-94A9-606CF04400FF}"/>
          </ac:graphicFrameMkLst>
        </pc:graphicFrameChg>
        <pc:graphicFrameChg chg="mod">
          <ac:chgData name="Emily L Thoday-Kennedy (DJPR)" userId="21326440-ac07-4837-a38f-5acc3ccf5e65" providerId="ADAL" clId="{ED79222C-487F-4585-ABC6-8BCECCC3B277}" dt="2020-05-01T02:34:55.366" v="77"/>
          <ac:graphicFrameMkLst>
            <pc:docMk/>
            <pc:sldMk cId="1714178413" sldId="297"/>
            <ac:graphicFrameMk id="3" creationId="{BA1D84E8-D40D-404A-82BF-8F8C4EC746F3}"/>
          </ac:graphicFrameMkLst>
        </pc:graphicFrameChg>
      </pc:sldChg>
    </pc:docChg>
  </pc:docChgLst>
  <pc:docChgLst>
    <pc:chgData name="Emily L Thoday-Kennedy (DJPR)" userId="21326440-ac07-4837-a38f-5acc3ccf5e65" providerId="ADAL" clId="{C2B7BA3E-38CC-4BE9-BF73-61915C25F211}"/>
    <pc:docChg chg="undo custSel modSld">
      <pc:chgData name="Emily L Thoday-Kennedy (DJPR)" userId="21326440-ac07-4837-a38f-5acc3ccf5e65" providerId="ADAL" clId="{C2B7BA3E-38CC-4BE9-BF73-61915C25F211}" dt="2021-05-14T00:21:32.086" v="29" actId="20577"/>
      <pc:docMkLst>
        <pc:docMk/>
      </pc:docMkLst>
      <pc:sldChg chg="modSp mod">
        <pc:chgData name="Emily L Thoday-Kennedy (DJPR)" userId="21326440-ac07-4837-a38f-5acc3ccf5e65" providerId="ADAL" clId="{C2B7BA3E-38CC-4BE9-BF73-61915C25F211}" dt="2021-05-14T00:21:32.086" v="29" actId="20577"/>
        <pc:sldMkLst>
          <pc:docMk/>
          <pc:sldMk cId="82166636" sldId="302"/>
        </pc:sldMkLst>
        <pc:spChg chg="mod">
          <ac:chgData name="Emily L Thoday-Kennedy (DJPR)" userId="21326440-ac07-4837-a38f-5acc3ccf5e65" providerId="ADAL" clId="{C2B7BA3E-38CC-4BE9-BF73-61915C25F211}" dt="2021-05-14T00:21:32.086" v="29" actId="20577"/>
          <ac:spMkLst>
            <pc:docMk/>
            <pc:sldMk cId="82166636" sldId="302"/>
            <ac:spMk id="7" creationId="{E2A806DD-9BBD-4471-878F-36B6CC62C551}"/>
          </ac:spMkLst>
        </pc:spChg>
      </pc:sldChg>
    </pc:docChg>
  </pc:docChgLst>
  <pc:docChgLst>
    <pc:chgData name="Emily Thoday-Kennedy" userId="21326440-ac07-4837-a38f-5acc3ccf5e65" providerId="ADAL" clId="{334A6EBA-707A-4593-A136-6347609491F9}"/>
    <pc:docChg chg="modSld sldOrd">
      <pc:chgData name="Emily Thoday-Kennedy" userId="21326440-ac07-4837-a38f-5acc3ccf5e65" providerId="ADAL" clId="{334A6EBA-707A-4593-A136-6347609491F9}" dt="2020-06-18T22:40:22.583" v="4" actId="20577"/>
      <pc:docMkLst>
        <pc:docMk/>
      </pc:docMkLst>
      <pc:sldChg chg="modSp">
        <pc:chgData name="Emily Thoday-Kennedy" userId="21326440-ac07-4837-a38f-5acc3ccf5e65" providerId="ADAL" clId="{334A6EBA-707A-4593-A136-6347609491F9}" dt="2020-06-18T22:40:22.583" v="4" actId="20577"/>
        <pc:sldMkLst>
          <pc:docMk/>
          <pc:sldMk cId="2555432452" sldId="287"/>
        </pc:sldMkLst>
        <pc:spChg chg="mod">
          <ac:chgData name="Emily Thoday-Kennedy" userId="21326440-ac07-4837-a38f-5acc3ccf5e65" providerId="ADAL" clId="{334A6EBA-707A-4593-A136-6347609491F9}" dt="2020-06-18T22:40:22.583" v="4" actId="20577"/>
          <ac:spMkLst>
            <pc:docMk/>
            <pc:sldMk cId="2555432452" sldId="287"/>
            <ac:spMk id="5" creationId="{F93C4AD5-F523-47A9-AAE2-73BBD2F085C4}"/>
          </ac:spMkLst>
        </pc:spChg>
      </pc:sldChg>
      <pc:sldChg chg="modSp ord">
        <pc:chgData name="Emily Thoday-Kennedy" userId="21326440-ac07-4837-a38f-5acc3ccf5e65" providerId="ADAL" clId="{334A6EBA-707A-4593-A136-6347609491F9}" dt="2020-06-18T22:40:19.582" v="2"/>
        <pc:sldMkLst>
          <pc:docMk/>
          <pc:sldMk cId="1714178413" sldId="297"/>
        </pc:sldMkLst>
        <pc:spChg chg="mod">
          <ac:chgData name="Emily Thoday-Kennedy" userId="21326440-ac07-4837-a38f-5acc3ccf5e65" providerId="ADAL" clId="{334A6EBA-707A-4593-A136-6347609491F9}" dt="2020-06-18T22:40:17.793" v="1" actId="20577"/>
          <ac:spMkLst>
            <pc:docMk/>
            <pc:sldMk cId="1714178413" sldId="297"/>
            <ac:spMk id="16" creationId="{9EEE3FFE-1C4D-4254-BB5F-4E50E8AB330F}"/>
          </ac:spMkLst>
        </pc:spChg>
      </pc:sldChg>
    </pc:docChg>
  </pc:docChgLst>
  <pc:docChgLst>
    <pc:chgData name="Emily L Thoday-Kennedy (DEDJTR)" userId="21326440-ac07-4837-a38f-5acc3ccf5e65" providerId="ADAL" clId="{ED79222C-487F-4585-ABC6-8BCECCC3B277}"/>
    <pc:docChg chg="custSel delSld">
      <pc:chgData name="Emily L Thoday-Kennedy (DEDJTR)" userId="21326440-ac07-4837-a38f-5acc3ccf5e65" providerId="ADAL" clId="{ED79222C-487F-4585-ABC6-8BCECCC3B277}" dt="2020-04-07T02:15:29.376" v="0" actId="2696"/>
      <pc:docMkLst>
        <pc:docMk/>
      </pc:docMkLst>
      <pc:sldChg chg="del">
        <pc:chgData name="Emily L Thoday-Kennedy (DEDJTR)" userId="21326440-ac07-4837-a38f-5acc3ccf5e65" providerId="ADAL" clId="{ED79222C-487F-4585-ABC6-8BCECCC3B277}" dt="2020-04-07T02:15:29.376" v="0" actId="2696"/>
        <pc:sldMkLst>
          <pc:docMk/>
          <pc:sldMk cId="2555432452" sldId="287"/>
        </pc:sldMkLst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vicgov-my.sharepoint.com/personal/emily_thoday-kennedy_agriculture_vic_gov_au/Documents/AgVic/Safflower/Safflower%20PPV%20Stress%20Screens/Salinity/2.%20Safflower_Salinity_Expt-Main_May_July_2018/Data/Imaging%20Data/Total%20Are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vicgov-my.sharepoint.com/personal/emily_thoday-kennedy_agriculture_vic_gov_au/Documents/AgVic/Safflower/Safflower%20PPV%20Stress%20Screens/Salinity/2.%20Safflower_Salinity_Expt-Main_May_July_2018/Data/Imaging%20Data/Total%20Area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5487682488568072"/>
          <c:y val="5.0925925925925923E-2"/>
          <c:w val="0.81135349924496225"/>
          <c:h val="0.73929790026246722"/>
        </c:manualLayout>
      </c:layout>
      <c:scatterChart>
        <c:scatterStyle val="lineMarker"/>
        <c:varyColors val="0"/>
        <c:ser>
          <c:idx val="0"/>
          <c:order val="0"/>
          <c:tx>
            <c:v>all</c:v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trendline>
            <c:spPr>
              <a:ln w="1270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1"/>
            <c:dispEq val="0"/>
            <c:trendlineLbl>
              <c:layout>
                <c:manualLayout>
                  <c:x val="3.978206465562955E-2"/>
                  <c:y val="0.54733267716535428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1" i="0" u="none" strike="noStrike" kern="120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/>
                </a:p>
              </c:txPr>
            </c:trendlineLbl>
          </c:trendline>
          <c:xVal>
            <c:numRef>
              <c:f>(Sheet3!$D$2:$D$221,Sheet3!$G$2:$G$221)</c:f>
              <c:numCache>
                <c:formatCode>General</c:formatCode>
                <c:ptCount val="440"/>
                <c:pt idx="0">
                  <c:v>28.88</c:v>
                </c:pt>
                <c:pt idx="1">
                  <c:v>28.64</c:v>
                </c:pt>
                <c:pt idx="2">
                  <c:v>8.1</c:v>
                </c:pt>
                <c:pt idx="3">
                  <c:v>7.83</c:v>
                </c:pt>
                <c:pt idx="4">
                  <c:v>8.23</c:v>
                </c:pt>
                <c:pt idx="5">
                  <c:v>12.47</c:v>
                </c:pt>
                <c:pt idx="6">
                  <c:v>7.35</c:v>
                </c:pt>
                <c:pt idx="7">
                  <c:v>6.31</c:v>
                </c:pt>
                <c:pt idx="8">
                  <c:v>11.71</c:v>
                </c:pt>
                <c:pt idx="9">
                  <c:v>17.149999999999999</c:v>
                </c:pt>
                <c:pt idx="10">
                  <c:v>19.670000000000002</c:v>
                </c:pt>
                <c:pt idx="11">
                  <c:v>11.72</c:v>
                </c:pt>
                <c:pt idx="12">
                  <c:v>6.33</c:v>
                </c:pt>
                <c:pt idx="13">
                  <c:v>16.440000000000001</c:v>
                </c:pt>
                <c:pt idx="14">
                  <c:v>8.27</c:v>
                </c:pt>
                <c:pt idx="15">
                  <c:v>9.17</c:v>
                </c:pt>
                <c:pt idx="16">
                  <c:v>9.2899999999999991</c:v>
                </c:pt>
                <c:pt idx="17">
                  <c:v>5.0599999999999996</c:v>
                </c:pt>
                <c:pt idx="18">
                  <c:v>8.25</c:v>
                </c:pt>
                <c:pt idx="19">
                  <c:v>11.97</c:v>
                </c:pt>
                <c:pt idx="20">
                  <c:v>12.09</c:v>
                </c:pt>
                <c:pt idx="21">
                  <c:v>8.73</c:v>
                </c:pt>
                <c:pt idx="22">
                  <c:v>7.61</c:v>
                </c:pt>
                <c:pt idx="23">
                  <c:v>11.4</c:v>
                </c:pt>
                <c:pt idx="24">
                  <c:v>6.38</c:v>
                </c:pt>
                <c:pt idx="25">
                  <c:v>24.33</c:v>
                </c:pt>
                <c:pt idx="26">
                  <c:v>6.67</c:v>
                </c:pt>
                <c:pt idx="27">
                  <c:v>6.39</c:v>
                </c:pt>
                <c:pt idx="28">
                  <c:v>10.210000000000001</c:v>
                </c:pt>
                <c:pt idx="29">
                  <c:v>22.66</c:v>
                </c:pt>
                <c:pt idx="30">
                  <c:v>14.25</c:v>
                </c:pt>
                <c:pt idx="31">
                  <c:v>12.6</c:v>
                </c:pt>
                <c:pt idx="32">
                  <c:v>4.92</c:v>
                </c:pt>
                <c:pt idx="33">
                  <c:v>6.63</c:v>
                </c:pt>
                <c:pt idx="34">
                  <c:v>2.82</c:v>
                </c:pt>
                <c:pt idx="35">
                  <c:v>11.86</c:v>
                </c:pt>
                <c:pt idx="36">
                  <c:v>4.58</c:v>
                </c:pt>
                <c:pt idx="37">
                  <c:v>8.6999999999999993</c:v>
                </c:pt>
                <c:pt idx="38">
                  <c:v>5.7</c:v>
                </c:pt>
                <c:pt idx="39">
                  <c:v>11.66</c:v>
                </c:pt>
                <c:pt idx="40">
                  <c:v>6.45</c:v>
                </c:pt>
                <c:pt idx="41">
                  <c:v>13.41</c:v>
                </c:pt>
                <c:pt idx="42">
                  <c:v>5.9</c:v>
                </c:pt>
                <c:pt idx="43">
                  <c:v>11.99</c:v>
                </c:pt>
                <c:pt idx="44">
                  <c:v>9.91</c:v>
                </c:pt>
                <c:pt idx="45">
                  <c:v>8.5500000000000007</c:v>
                </c:pt>
                <c:pt idx="46">
                  <c:v>4.5</c:v>
                </c:pt>
                <c:pt idx="47">
                  <c:v>4.09</c:v>
                </c:pt>
                <c:pt idx="48">
                  <c:v>6.36</c:v>
                </c:pt>
                <c:pt idx="49">
                  <c:v>3.83</c:v>
                </c:pt>
                <c:pt idx="50">
                  <c:v>10.17</c:v>
                </c:pt>
                <c:pt idx="51">
                  <c:v>8.5</c:v>
                </c:pt>
                <c:pt idx="52">
                  <c:v>6.89</c:v>
                </c:pt>
                <c:pt idx="53">
                  <c:v>11.8</c:v>
                </c:pt>
                <c:pt idx="54">
                  <c:v>9.07</c:v>
                </c:pt>
                <c:pt idx="55">
                  <c:v>7.55</c:v>
                </c:pt>
                <c:pt idx="56">
                  <c:v>3.77</c:v>
                </c:pt>
                <c:pt idx="57">
                  <c:v>7.51</c:v>
                </c:pt>
                <c:pt idx="58">
                  <c:v>4.79</c:v>
                </c:pt>
                <c:pt idx="59">
                  <c:v>12.32</c:v>
                </c:pt>
                <c:pt idx="60">
                  <c:v>11.19</c:v>
                </c:pt>
                <c:pt idx="61">
                  <c:v>16.18</c:v>
                </c:pt>
                <c:pt idx="62">
                  <c:v>5.31</c:v>
                </c:pt>
                <c:pt idx="63">
                  <c:v>5.75</c:v>
                </c:pt>
                <c:pt idx="64">
                  <c:v>5.58</c:v>
                </c:pt>
                <c:pt idx="65">
                  <c:v>8.33</c:v>
                </c:pt>
                <c:pt idx="66">
                  <c:v>9.36</c:v>
                </c:pt>
                <c:pt idx="67">
                  <c:v>13.11</c:v>
                </c:pt>
                <c:pt idx="68">
                  <c:v>3.67</c:v>
                </c:pt>
                <c:pt idx="69">
                  <c:v>9.36</c:v>
                </c:pt>
                <c:pt idx="70">
                  <c:v>13.09</c:v>
                </c:pt>
                <c:pt idx="71">
                  <c:v>3.34</c:v>
                </c:pt>
                <c:pt idx="72">
                  <c:v>22.01</c:v>
                </c:pt>
                <c:pt idx="73">
                  <c:v>15.58</c:v>
                </c:pt>
                <c:pt idx="74">
                  <c:v>10.54</c:v>
                </c:pt>
                <c:pt idx="75">
                  <c:v>11.85</c:v>
                </c:pt>
                <c:pt idx="76">
                  <c:v>13.05</c:v>
                </c:pt>
                <c:pt idx="77">
                  <c:v>10.54</c:v>
                </c:pt>
                <c:pt idx="78">
                  <c:v>12.12</c:v>
                </c:pt>
                <c:pt idx="79">
                  <c:v>8.33</c:v>
                </c:pt>
                <c:pt idx="80">
                  <c:v>3.39</c:v>
                </c:pt>
                <c:pt idx="81">
                  <c:v>5.2</c:v>
                </c:pt>
                <c:pt idx="82">
                  <c:v>6.32</c:v>
                </c:pt>
                <c:pt idx="83">
                  <c:v>25.22</c:v>
                </c:pt>
                <c:pt idx="84">
                  <c:v>14</c:v>
                </c:pt>
                <c:pt idx="85">
                  <c:v>5.08</c:v>
                </c:pt>
                <c:pt idx="86">
                  <c:v>19.149999999999999</c:v>
                </c:pt>
                <c:pt idx="87">
                  <c:v>11.06</c:v>
                </c:pt>
                <c:pt idx="88">
                  <c:v>8.5299999999999994</c:v>
                </c:pt>
                <c:pt idx="89">
                  <c:v>9.2899999999999991</c:v>
                </c:pt>
                <c:pt idx="90">
                  <c:v>6.47</c:v>
                </c:pt>
                <c:pt idx="91">
                  <c:v>11.44</c:v>
                </c:pt>
                <c:pt idx="92">
                  <c:v>9.34</c:v>
                </c:pt>
                <c:pt idx="93">
                  <c:v>6.72</c:v>
                </c:pt>
                <c:pt idx="94">
                  <c:v>12.96</c:v>
                </c:pt>
                <c:pt idx="95">
                  <c:v>10.06</c:v>
                </c:pt>
                <c:pt idx="96">
                  <c:v>9.1999999999999993</c:v>
                </c:pt>
                <c:pt idx="97">
                  <c:v>12.67</c:v>
                </c:pt>
                <c:pt idx="98">
                  <c:v>7.49</c:v>
                </c:pt>
                <c:pt idx="99">
                  <c:v>1.86</c:v>
                </c:pt>
                <c:pt idx="100">
                  <c:v>2.89</c:v>
                </c:pt>
                <c:pt idx="101">
                  <c:v>9.33</c:v>
                </c:pt>
                <c:pt idx="102">
                  <c:v>7.76</c:v>
                </c:pt>
                <c:pt idx="103">
                  <c:v>8.3699999999999992</c:v>
                </c:pt>
                <c:pt idx="104">
                  <c:v>9.7100000000000009</c:v>
                </c:pt>
                <c:pt idx="105">
                  <c:v>2.97</c:v>
                </c:pt>
                <c:pt idx="106">
                  <c:v>5.81</c:v>
                </c:pt>
                <c:pt idx="107">
                  <c:v>4.3</c:v>
                </c:pt>
                <c:pt idx="108">
                  <c:v>9.69</c:v>
                </c:pt>
                <c:pt idx="109">
                  <c:v>9.18</c:v>
                </c:pt>
                <c:pt idx="110">
                  <c:v>14.2</c:v>
                </c:pt>
                <c:pt idx="111">
                  <c:v>11.38</c:v>
                </c:pt>
                <c:pt idx="112">
                  <c:v>7.95</c:v>
                </c:pt>
                <c:pt idx="113">
                  <c:v>7.23</c:v>
                </c:pt>
                <c:pt idx="114">
                  <c:v>10.34</c:v>
                </c:pt>
                <c:pt idx="115">
                  <c:v>11.11</c:v>
                </c:pt>
                <c:pt idx="116">
                  <c:v>11.05</c:v>
                </c:pt>
                <c:pt idx="117">
                  <c:v>9.17</c:v>
                </c:pt>
                <c:pt idx="118">
                  <c:v>12.17</c:v>
                </c:pt>
                <c:pt idx="119">
                  <c:v>11.15</c:v>
                </c:pt>
                <c:pt idx="120">
                  <c:v>12.29</c:v>
                </c:pt>
                <c:pt idx="121">
                  <c:v>4.41</c:v>
                </c:pt>
                <c:pt idx="122">
                  <c:v>4.99</c:v>
                </c:pt>
                <c:pt idx="123">
                  <c:v>6.22</c:v>
                </c:pt>
                <c:pt idx="124">
                  <c:v>6.58</c:v>
                </c:pt>
                <c:pt idx="125">
                  <c:v>13.97</c:v>
                </c:pt>
                <c:pt idx="126">
                  <c:v>8.58</c:v>
                </c:pt>
                <c:pt idx="127">
                  <c:v>7.73</c:v>
                </c:pt>
                <c:pt idx="128">
                  <c:v>6.5</c:v>
                </c:pt>
                <c:pt idx="129">
                  <c:v>5.47</c:v>
                </c:pt>
                <c:pt idx="130">
                  <c:v>10.82</c:v>
                </c:pt>
                <c:pt idx="131">
                  <c:v>6.78</c:v>
                </c:pt>
                <c:pt idx="132">
                  <c:v>7.17</c:v>
                </c:pt>
                <c:pt idx="133">
                  <c:v>12.25</c:v>
                </c:pt>
                <c:pt idx="134">
                  <c:v>12.63</c:v>
                </c:pt>
                <c:pt idx="135">
                  <c:v>4.9000000000000004</c:v>
                </c:pt>
                <c:pt idx="136">
                  <c:v>8.36</c:v>
                </c:pt>
                <c:pt idx="137">
                  <c:v>8.1199999999999992</c:v>
                </c:pt>
                <c:pt idx="138">
                  <c:v>4.46</c:v>
                </c:pt>
                <c:pt idx="139">
                  <c:v>13.8</c:v>
                </c:pt>
                <c:pt idx="140">
                  <c:v>3.27</c:v>
                </c:pt>
                <c:pt idx="141">
                  <c:v>8.52</c:v>
                </c:pt>
                <c:pt idx="142">
                  <c:v>7.24</c:v>
                </c:pt>
                <c:pt idx="143">
                  <c:v>3.3</c:v>
                </c:pt>
                <c:pt idx="144">
                  <c:v>5.2</c:v>
                </c:pt>
                <c:pt idx="145">
                  <c:v>8.01</c:v>
                </c:pt>
                <c:pt idx="146">
                  <c:v>10.78</c:v>
                </c:pt>
                <c:pt idx="147">
                  <c:v>6.64</c:v>
                </c:pt>
                <c:pt idx="148">
                  <c:v>7.5</c:v>
                </c:pt>
                <c:pt idx="149">
                  <c:v>4.7699999999999996</c:v>
                </c:pt>
                <c:pt idx="150">
                  <c:v>7.58</c:v>
                </c:pt>
                <c:pt idx="151">
                  <c:v>8.2200000000000006</c:v>
                </c:pt>
                <c:pt idx="152">
                  <c:v>7.66</c:v>
                </c:pt>
                <c:pt idx="153">
                  <c:v>3.67</c:v>
                </c:pt>
                <c:pt idx="154">
                  <c:v>6.05</c:v>
                </c:pt>
                <c:pt idx="155">
                  <c:v>7.01</c:v>
                </c:pt>
                <c:pt idx="156">
                  <c:v>10.24</c:v>
                </c:pt>
                <c:pt idx="157">
                  <c:v>4.5</c:v>
                </c:pt>
                <c:pt idx="158">
                  <c:v>8.74</c:v>
                </c:pt>
                <c:pt idx="159">
                  <c:v>8.2100000000000009</c:v>
                </c:pt>
                <c:pt idx="160">
                  <c:v>6.26</c:v>
                </c:pt>
                <c:pt idx="161">
                  <c:v>11.24</c:v>
                </c:pt>
                <c:pt idx="162">
                  <c:v>7.83</c:v>
                </c:pt>
                <c:pt idx="163">
                  <c:v>4.9400000000000004</c:v>
                </c:pt>
                <c:pt idx="164">
                  <c:v>2.71</c:v>
                </c:pt>
                <c:pt idx="165">
                  <c:v>8.36</c:v>
                </c:pt>
                <c:pt idx="166">
                  <c:v>4.37</c:v>
                </c:pt>
                <c:pt idx="167">
                  <c:v>2.88</c:v>
                </c:pt>
                <c:pt idx="168">
                  <c:v>15.23</c:v>
                </c:pt>
                <c:pt idx="169">
                  <c:v>5.84</c:v>
                </c:pt>
                <c:pt idx="170">
                  <c:v>3.34</c:v>
                </c:pt>
                <c:pt idx="171">
                  <c:v>3.89</c:v>
                </c:pt>
                <c:pt idx="172">
                  <c:v>13.23</c:v>
                </c:pt>
                <c:pt idx="173">
                  <c:v>6.35</c:v>
                </c:pt>
                <c:pt idx="174">
                  <c:v>5.45</c:v>
                </c:pt>
                <c:pt idx="175">
                  <c:v>4.25</c:v>
                </c:pt>
                <c:pt idx="176">
                  <c:v>9.08</c:v>
                </c:pt>
                <c:pt idx="177">
                  <c:v>6.64</c:v>
                </c:pt>
                <c:pt idx="178">
                  <c:v>7.48</c:v>
                </c:pt>
                <c:pt idx="179">
                  <c:v>5.28</c:v>
                </c:pt>
                <c:pt idx="180">
                  <c:v>4.49</c:v>
                </c:pt>
                <c:pt idx="181">
                  <c:v>9.02</c:v>
                </c:pt>
                <c:pt idx="182">
                  <c:v>2.71</c:v>
                </c:pt>
                <c:pt idx="183">
                  <c:v>1.74</c:v>
                </c:pt>
                <c:pt idx="184">
                  <c:v>7.53</c:v>
                </c:pt>
                <c:pt idx="185">
                  <c:v>2.63</c:v>
                </c:pt>
                <c:pt idx="186">
                  <c:v>7.84</c:v>
                </c:pt>
                <c:pt idx="187">
                  <c:v>5.32</c:v>
                </c:pt>
                <c:pt idx="188">
                  <c:v>4.79</c:v>
                </c:pt>
                <c:pt idx="189">
                  <c:v>6.33</c:v>
                </c:pt>
                <c:pt idx="190">
                  <c:v>7.91</c:v>
                </c:pt>
                <c:pt idx="191">
                  <c:v>5.48</c:v>
                </c:pt>
                <c:pt idx="192">
                  <c:v>6.26</c:v>
                </c:pt>
                <c:pt idx="193">
                  <c:v>5.43</c:v>
                </c:pt>
                <c:pt idx="194">
                  <c:v>5.77</c:v>
                </c:pt>
                <c:pt idx="195">
                  <c:v>2.4700000000000002</c:v>
                </c:pt>
                <c:pt idx="196">
                  <c:v>8.69</c:v>
                </c:pt>
                <c:pt idx="197">
                  <c:v>1.81</c:v>
                </c:pt>
                <c:pt idx="198">
                  <c:v>4.2</c:v>
                </c:pt>
                <c:pt idx="199">
                  <c:v>6.54</c:v>
                </c:pt>
                <c:pt idx="200">
                  <c:v>6.5</c:v>
                </c:pt>
                <c:pt idx="201">
                  <c:v>4.3099999999999996</c:v>
                </c:pt>
                <c:pt idx="202">
                  <c:v>6.33</c:v>
                </c:pt>
                <c:pt idx="203">
                  <c:v>4.49</c:v>
                </c:pt>
                <c:pt idx="204">
                  <c:v>3.32</c:v>
                </c:pt>
                <c:pt idx="205">
                  <c:v>5.09</c:v>
                </c:pt>
                <c:pt idx="206">
                  <c:v>9.36</c:v>
                </c:pt>
                <c:pt idx="207">
                  <c:v>5.6</c:v>
                </c:pt>
                <c:pt idx="208">
                  <c:v>3.83</c:v>
                </c:pt>
                <c:pt idx="209">
                  <c:v>6.17</c:v>
                </c:pt>
                <c:pt idx="210">
                  <c:v>1.83</c:v>
                </c:pt>
                <c:pt idx="211">
                  <c:v>8.07</c:v>
                </c:pt>
                <c:pt idx="212">
                  <c:v>4.38</c:v>
                </c:pt>
                <c:pt idx="213">
                  <c:v>1.75</c:v>
                </c:pt>
                <c:pt idx="214">
                  <c:v>1.6</c:v>
                </c:pt>
                <c:pt idx="215">
                  <c:v>3.02</c:v>
                </c:pt>
                <c:pt idx="216">
                  <c:v>1.98</c:v>
                </c:pt>
                <c:pt idx="217">
                  <c:v>2.88</c:v>
                </c:pt>
                <c:pt idx="218">
                  <c:v>2.69</c:v>
                </c:pt>
                <c:pt idx="219">
                  <c:v>1.31</c:v>
                </c:pt>
                <c:pt idx="220">
                  <c:v>1.42</c:v>
                </c:pt>
                <c:pt idx="221">
                  <c:v>1.58</c:v>
                </c:pt>
                <c:pt idx="222">
                  <c:v>0.3</c:v>
                </c:pt>
                <c:pt idx="223">
                  <c:v>0.56000000000000005</c:v>
                </c:pt>
                <c:pt idx="224">
                  <c:v>0.4</c:v>
                </c:pt>
                <c:pt idx="225">
                  <c:v>0.93</c:v>
                </c:pt>
                <c:pt idx="226">
                  <c:v>0.3</c:v>
                </c:pt>
                <c:pt idx="227">
                  <c:v>0.5</c:v>
                </c:pt>
                <c:pt idx="228">
                  <c:v>0.39</c:v>
                </c:pt>
                <c:pt idx="229">
                  <c:v>1.39</c:v>
                </c:pt>
                <c:pt idx="230">
                  <c:v>2.2599999999999998</c:v>
                </c:pt>
                <c:pt idx="231">
                  <c:v>0.91</c:v>
                </c:pt>
                <c:pt idx="232">
                  <c:v>0.97</c:v>
                </c:pt>
                <c:pt idx="233">
                  <c:v>1.63</c:v>
                </c:pt>
                <c:pt idx="234">
                  <c:v>1</c:v>
                </c:pt>
                <c:pt idx="235">
                  <c:v>0.87</c:v>
                </c:pt>
                <c:pt idx="236">
                  <c:v>0.62</c:v>
                </c:pt>
                <c:pt idx="237">
                  <c:v>0.28999999999999998</c:v>
                </c:pt>
                <c:pt idx="238">
                  <c:v>1.31</c:v>
                </c:pt>
                <c:pt idx="239">
                  <c:v>1.21</c:v>
                </c:pt>
                <c:pt idx="240">
                  <c:v>2.23</c:v>
                </c:pt>
                <c:pt idx="241">
                  <c:v>1.1000000000000001</c:v>
                </c:pt>
                <c:pt idx="242">
                  <c:v>0.8</c:v>
                </c:pt>
                <c:pt idx="243">
                  <c:v>1.76</c:v>
                </c:pt>
                <c:pt idx="244">
                  <c:v>0.72</c:v>
                </c:pt>
                <c:pt idx="245">
                  <c:v>4.17</c:v>
                </c:pt>
                <c:pt idx="246">
                  <c:v>1.39</c:v>
                </c:pt>
                <c:pt idx="247">
                  <c:v>1.06</c:v>
                </c:pt>
                <c:pt idx="248">
                  <c:v>1.45</c:v>
                </c:pt>
                <c:pt idx="249">
                  <c:v>5.44</c:v>
                </c:pt>
                <c:pt idx="250">
                  <c:v>2.42</c:v>
                </c:pt>
                <c:pt idx="251">
                  <c:v>2.46</c:v>
                </c:pt>
                <c:pt idx="252">
                  <c:v>1.03</c:v>
                </c:pt>
                <c:pt idx="253">
                  <c:v>0.93</c:v>
                </c:pt>
                <c:pt idx="254">
                  <c:v>0.54</c:v>
                </c:pt>
                <c:pt idx="255">
                  <c:v>2.74</c:v>
                </c:pt>
                <c:pt idx="256">
                  <c:v>0.22</c:v>
                </c:pt>
                <c:pt idx="257">
                  <c:v>2.33</c:v>
                </c:pt>
                <c:pt idx="258">
                  <c:v>1.57</c:v>
                </c:pt>
                <c:pt idx="259">
                  <c:v>2</c:v>
                </c:pt>
                <c:pt idx="260">
                  <c:v>1.53</c:v>
                </c:pt>
                <c:pt idx="261">
                  <c:v>2.14</c:v>
                </c:pt>
                <c:pt idx="262">
                  <c:v>0.9</c:v>
                </c:pt>
                <c:pt idx="263">
                  <c:v>2.99</c:v>
                </c:pt>
                <c:pt idx="264">
                  <c:v>2.82</c:v>
                </c:pt>
                <c:pt idx="265">
                  <c:v>2.29</c:v>
                </c:pt>
                <c:pt idx="266">
                  <c:v>0.85</c:v>
                </c:pt>
                <c:pt idx="267">
                  <c:v>1.1200000000000001</c:v>
                </c:pt>
                <c:pt idx="268">
                  <c:v>1.55</c:v>
                </c:pt>
                <c:pt idx="269">
                  <c:v>1.1200000000000001</c:v>
                </c:pt>
                <c:pt idx="270">
                  <c:v>2.5099999999999998</c:v>
                </c:pt>
                <c:pt idx="271">
                  <c:v>1.23</c:v>
                </c:pt>
                <c:pt idx="272">
                  <c:v>1.53</c:v>
                </c:pt>
                <c:pt idx="273">
                  <c:v>3.99</c:v>
                </c:pt>
                <c:pt idx="274">
                  <c:v>2.41</c:v>
                </c:pt>
                <c:pt idx="275">
                  <c:v>2.54</c:v>
                </c:pt>
                <c:pt idx="276">
                  <c:v>0.89</c:v>
                </c:pt>
                <c:pt idx="277">
                  <c:v>1.87</c:v>
                </c:pt>
                <c:pt idx="278">
                  <c:v>1.56</c:v>
                </c:pt>
                <c:pt idx="279">
                  <c:v>4.5</c:v>
                </c:pt>
                <c:pt idx="280">
                  <c:v>2.52</c:v>
                </c:pt>
                <c:pt idx="281">
                  <c:v>4.4000000000000004</c:v>
                </c:pt>
                <c:pt idx="282">
                  <c:v>1.03</c:v>
                </c:pt>
                <c:pt idx="283">
                  <c:v>1.26</c:v>
                </c:pt>
                <c:pt idx="284">
                  <c:v>1.8</c:v>
                </c:pt>
                <c:pt idx="285">
                  <c:v>2.39</c:v>
                </c:pt>
                <c:pt idx="286">
                  <c:v>2.81</c:v>
                </c:pt>
                <c:pt idx="287">
                  <c:v>4.2699999999999996</c:v>
                </c:pt>
                <c:pt idx="288">
                  <c:v>1.46</c:v>
                </c:pt>
                <c:pt idx="289">
                  <c:v>3.48</c:v>
                </c:pt>
                <c:pt idx="290">
                  <c:v>3.71</c:v>
                </c:pt>
                <c:pt idx="291">
                  <c:v>1.1599999999999999</c:v>
                </c:pt>
                <c:pt idx="292">
                  <c:v>8.9499999999999993</c:v>
                </c:pt>
                <c:pt idx="293">
                  <c:v>5.6</c:v>
                </c:pt>
                <c:pt idx="294">
                  <c:v>4.38</c:v>
                </c:pt>
                <c:pt idx="295">
                  <c:v>3.61</c:v>
                </c:pt>
                <c:pt idx="296">
                  <c:v>4.84</c:v>
                </c:pt>
                <c:pt idx="297">
                  <c:v>3.79</c:v>
                </c:pt>
                <c:pt idx="298">
                  <c:v>4.1900000000000004</c:v>
                </c:pt>
                <c:pt idx="299">
                  <c:v>3.08</c:v>
                </c:pt>
                <c:pt idx="300">
                  <c:v>0.82</c:v>
                </c:pt>
                <c:pt idx="301">
                  <c:v>2.4</c:v>
                </c:pt>
                <c:pt idx="302">
                  <c:v>1.97</c:v>
                </c:pt>
                <c:pt idx="303">
                  <c:v>10.65</c:v>
                </c:pt>
                <c:pt idx="304">
                  <c:v>5.65</c:v>
                </c:pt>
                <c:pt idx="305">
                  <c:v>1.52</c:v>
                </c:pt>
                <c:pt idx="306">
                  <c:v>6.85</c:v>
                </c:pt>
                <c:pt idx="307">
                  <c:v>3.4</c:v>
                </c:pt>
                <c:pt idx="308">
                  <c:v>3.03</c:v>
                </c:pt>
                <c:pt idx="309">
                  <c:v>3.3</c:v>
                </c:pt>
                <c:pt idx="310">
                  <c:v>3.02</c:v>
                </c:pt>
                <c:pt idx="311">
                  <c:v>4.25</c:v>
                </c:pt>
                <c:pt idx="312">
                  <c:v>3.75</c:v>
                </c:pt>
                <c:pt idx="313">
                  <c:v>2.57</c:v>
                </c:pt>
                <c:pt idx="314">
                  <c:v>4.43</c:v>
                </c:pt>
                <c:pt idx="315">
                  <c:v>3.16</c:v>
                </c:pt>
                <c:pt idx="316">
                  <c:v>3.48</c:v>
                </c:pt>
                <c:pt idx="317">
                  <c:v>5.63</c:v>
                </c:pt>
                <c:pt idx="318">
                  <c:v>1.93</c:v>
                </c:pt>
                <c:pt idx="319">
                  <c:v>0.52</c:v>
                </c:pt>
                <c:pt idx="320">
                  <c:v>1.2</c:v>
                </c:pt>
                <c:pt idx="321">
                  <c:v>3.23</c:v>
                </c:pt>
                <c:pt idx="322">
                  <c:v>3.06</c:v>
                </c:pt>
                <c:pt idx="323">
                  <c:v>3.19</c:v>
                </c:pt>
                <c:pt idx="324">
                  <c:v>3.91</c:v>
                </c:pt>
                <c:pt idx="325">
                  <c:v>1.81</c:v>
                </c:pt>
                <c:pt idx="326">
                  <c:v>2.74</c:v>
                </c:pt>
                <c:pt idx="327">
                  <c:v>1.24</c:v>
                </c:pt>
                <c:pt idx="328">
                  <c:v>3.84</c:v>
                </c:pt>
                <c:pt idx="329">
                  <c:v>4.54</c:v>
                </c:pt>
                <c:pt idx="330">
                  <c:v>5.12</c:v>
                </c:pt>
                <c:pt idx="331">
                  <c:v>3.47</c:v>
                </c:pt>
                <c:pt idx="332">
                  <c:v>4.38</c:v>
                </c:pt>
                <c:pt idx="333">
                  <c:v>3.82</c:v>
                </c:pt>
                <c:pt idx="334">
                  <c:v>5.7</c:v>
                </c:pt>
                <c:pt idx="335">
                  <c:v>5.8</c:v>
                </c:pt>
                <c:pt idx="336">
                  <c:v>5.45</c:v>
                </c:pt>
                <c:pt idx="337">
                  <c:v>3.78</c:v>
                </c:pt>
                <c:pt idx="338">
                  <c:v>6.27</c:v>
                </c:pt>
                <c:pt idx="339">
                  <c:v>5.17</c:v>
                </c:pt>
                <c:pt idx="340">
                  <c:v>4.59</c:v>
                </c:pt>
                <c:pt idx="341">
                  <c:v>3.26</c:v>
                </c:pt>
                <c:pt idx="342">
                  <c:v>3.58</c:v>
                </c:pt>
                <c:pt idx="343">
                  <c:v>3.65</c:v>
                </c:pt>
                <c:pt idx="344">
                  <c:v>4.78</c:v>
                </c:pt>
                <c:pt idx="345">
                  <c:v>6.55</c:v>
                </c:pt>
                <c:pt idx="346">
                  <c:v>5.15</c:v>
                </c:pt>
                <c:pt idx="347">
                  <c:v>3.21</c:v>
                </c:pt>
                <c:pt idx="348">
                  <c:v>4.43</c:v>
                </c:pt>
                <c:pt idx="349">
                  <c:v>3.24</c:v>
                </c:pt>
                <c:pt idx="350">
                  <c:v>6.04</c:v>
                </c:pt>
                <c:pt idx="351">
                  <c:v>3.47</c:v>
                </c:pt>
                <c:pt idx="352">
                  <c:v>4</c:v>
                </c:pt>
                <c:pt idx="353">
                  <c:v>4.91</c:v>
                </c:pt>
                <c:pt idx="354">
                  <c:v>4.78</c:v>
                </c:pt>
                <c:pt idx="355">
                  <c:v>2.8</c:v>
                </c:pt>
                <c:pt idx="356">
                  <c:v>6.03</c:v>
                </c:pt>
                <c:pt idx="357">
                  <c:v>5.37</c:v>
                </c:pt>
                <c:pt idx="358">
                  <c:v>3.56</c:v>
                </c:pt>
                <c:pt idx="359">
                  <c:v>8.6999999999999993</c:v>
                </c:pt>
                <c:pt idx="360">
                  <c:v>2.21</c:v>
                </c:pt>
                <c:pt idx="361">
                  <c:v>6.14</c:v>
                </c:pt>
                <c:pt idx="362">
                  <c:v>4.3499999999999996</c:v>
                </c:pt>
                <c:pt idx="363">
                  <c:v>2.85</c:v>
                </c:pt>
                <c:pt idx="364">
                  <c:v>3.55</c:v>
                </c:pt>
                <c:pt idx="365">
                  <c:v>4.87</c:v>
                </c:pt>
                <c:pt idx="366">
                  <c:v>6.78</c:v>
                </c:pt>
                <c:pt idx="367">
                  <c:v>3.98</c:v>
                </c:pt>
                <c:pt idx="368">
                  <c:v>4.4800000000000004</c:v>
                </c:pt>
                <c:pt idx="369">
                  <c:v>2.6</c:v>
                </c:pt>
                <c:pt idx="370">
                  <c:v>4.6500000000000004</c:v>
                </c:pt>
                <c:pt idx="371">
                  <c:v>5.33</c:v>
                </c:pt>
                <c:pt idx="372">
                  <c:v>4.5599999999999996</c:v>
                </c:pt>
                <c:pt idx="373">
                  <c:v>3</c:v>
                </c:pt>
                <c:pt idx="374">
                  <c:v>3.95</c:v>
                </c:pt>
                <c:pt idx="375">
                  <c:v>4.75</c:v>
                </c:pt>
                <c:pt idx="376">
                  <c:v>8.5399999999999991</c:v>
                </c:pt>
                <c:pt idx="377">
                  <c:v>2.8</c:v>
                </c:pt>
                <c:pt idx="378">
                  <c:v>6.69</c:v>
                </c:pt>
                <c:pt idx="379">
                  <c:v>3.9</c:v>
                </c:pt>
                <c:pt idx="380">
                  <c:v>3.79</c:v>
                </c:pt>
                <c:pt idx="381">
                  <c:v>11.71</c:v>
                </c:pt>
                <c:pt idx="382">
                  <c:v>5.43</c:v>
                </c:pt>
                <c:pt idx="383">
                  <c:v>2.89</c:v>
                </c:pt>
                <c:pt idx="384">
                  <c:v>2.1</c:v>
                </c:pt>
                <c:pt idx="385">
                  <c:v>6.02</c:v>
                </c:pt>
                <c:pt idx="386">
                  <c:v>4.6900000000000004</c:v>
                </c:pt>
                <c:pt idx="387">
                  <c:v>1.84</c:v>
                </c:pt>
                <c:pt idx="388">
                  <c:v>10.37</c:v>
                </c:pt>
                <c:pt idx="389">
                  <c:v>4.41</c:v>
                </c:pt>
                <c:pt idx="390">
                  <c:v>2.99</c:v>
                </c:pt>
                <c:pt idx="391">
                  <c:v>4.49</c:v>
                </c:pt>
                <c:pt idx="392">
                  <c:v>10.119999999999999</c:v>
                </c:pt>
                <c:pt idx="393">
                  <c:v>4.8899999999999997</c:v>
                </c:pt>
                <c:pt idx="394">
                  <c:v>4.76</c:v>
                </c:pt>
                <c:pt idx="395">
                  <c:v>3.36</c:v>
                </c:pt>
                <c:pt idx="396">
                  <c:v>7.93</c:v>
                </c:pt>
                <c:pt idx="397">
                  <c:v>5.6</c:v>
                </c:pt>
                <c:pt idx="398">
                  <c:v>6.73</c:v>
                </c:pt>
                <c:pt idx="399">
                  <c:v>4.76</c:v>
                </c:pt>
                <c:pt idx="400">
                  <c:v>4.22</c:v>
                </c:pt>
                <c:pt idx="401">
                  <c:v>6.66</c:v>
                </c:pt>
                <c:pt idx="402">
                  <c:v>3.26</c:v>
                </c:pt>
                <c:pt idx="403">
                  <c:v>1.26</c:v>
                </c:pt>
                <c:pt idx="404">
                  <c:v>6.05</c:v>
                </c:pt>
                <c:pt idx="405">
                  <c:v>2.84</c:v>
                </c:pt>
                <c:pt idx="406">
                  <c:v>8.6199999999999992</c:v>
                </c:pt>
                <c:pt idx="407">
                  <c:v>4.5199999999999996</c:v>
                </c:pt>
                <c:pt idx="408">
                  <c:v>4.95</c:v>
                </c:pt>
                <c:pt idx="409">
                  <c:v>6.13</c:v>
                </c:pt>
                <c:pt idx="410">
                  <c:v>7.76</c:v>
                </c:pt>
                <c:pt idx="411">
                  <c:v>5.97</c:v>
                </c:pt>
                <c:pt idx="412">
                  <c:v>6.65</c:v>
                </c:pt>
                <c:pt idx="413">
                  <c:v>4.32</c:v>
                </c:pt>
                <c:pt idx="414">
                  <c:v>8.23</c:v>
                </c:pt>
                <c:pt idx="415">
                  <c:v>2.87</c:v>
                </c:pt>
                <c:pt idx="416">
                  <c:v>6.93</c:v>
                </c:pt>
                <c:pt idx="417">
                  <c:v>0.85</c:v>
                </c:pt>
                <c:pt idx="418">
                  <c:v>4.18</c:v>
                </c:pt>
                <c:pt idx="419">
                  <c:v>8</c:v>
                </c:pt>
                <c:pt idx="420">
                  <c:v>7.74</c:v>
                </c:pt>
                <c:pt idx="421">
                  <c:v>5.34</c:v>
                </c:pt>
                <c:pt idx="422">
                  <c:v>7.71</c:v>
                </c:pt>
                <c:pt idx="423">
                  <c:v>6.87</c:v>
                </c:pt>
                <c:pt idx="424">
                  <c:v>4.0999999999999996</c:v>
                </c:pt>
                <c:pt idx="425">
                  <c:v>7.4</c:v>
                </c:pt>
                <c:pt idx="426">
                  <c:v>4.82</c:v>
                </c:pt>
                <c:pt idx="427">
                  <c:v>6.47</c:v>
                </c:pt>
                <c:pt idx="428">
                  <c:v>5.43</c:v>
                </c:pt>
                <c:pt idx="429">
                  <c:v>6.63</c:v>
                </c:pt>
                <c:pt idx="430">
                  <c:v>3.86</c:v>
                </c:pt>
                <c:pt idx="431">
                  <c:v>7.31</c:v>
                </c:pt>
                <c:pt idx="432">
                  <c:v>6.55</c:v>
                </c:pt>
                <c:pt idx="433">
                  <c:v>2.57</c:v>
                </c:pt>
                <c:pt idx="434">
                  <c:v>3.71</c:v>
                </c:pt>
                <c:pt idx="435">
                  <c:v>3.34</c:v>
                </c:pt>
                <c:pt idx="436">
                  <c:v>4.68</c:v>
                </c:pt>
                <c:pt idx="437">
                  <c:v>8.7200000000000006</c:v>
                </c:pt>
                <c:pt idx="438">
                  <c:v>6.83</c:v>
                </c:pt>
                <c:pt idx="439">
                  <c:v>3.89</c:v>
                </c:pt>
              </c:numCache>
            </c:numRef>
          </c:xVal>
          <c:yVal>
            <c:numRef>
              <c:f>(Sheet3!$C$2:$C$221,Sheet3!$F$2:$F$221)</c:f>
              <c:numCache>
                <c:formatCode>General</c:formatCode>
                <c:ptCount val="440"/>
                <c:pt idx="0">
                  <c:v>437958</c:v>
                </c:pt>
                <c:pt idx="1">
                  <c:v>486219</c:v>
                </c:pt>
                <c:pt idx="2">
                  <c:v>143902</c:v>
                </c:pt>
                <c:pt idx="3">
                  <c:v>159845</c:v>
                </c:pt>
                <c:pt idx="4">
                  <c:v>156093</c:v>
                </c:pt>
                <c:pt idx="5">
                  <c:v>202800</c:v>
                </c:pt>
                <c:pt idx="6">
                  <c:v>135048</c:v>
                </c:pt>
                <c:pt idx="7">
                  <c:v>138374</c:v>
                </c:pt>
                <c:pt idx="8">
                  <c:v>197892</c:v>
                </c:pt>
                <c:pt idx="9">
                  <c:v>300138</c:v>
                </c:pt>
                <c:pt idx="10">
                  <c:v>412058</c:v>
                </c:pt>
                <c:pt idx="11">
                  <c:v>213507</c:v>
                </c:pt>
                <c:pt idx="12">
                  <c:v>135720</c:v>
                </c:pt>
                <c:pt idx="13">
                  <c:v>232373</c:v>
                </c:pt>
                <c:pt idx="14">
                  <c:v>146323</c:v>
                </c:pt>
                <c:pt idx="15">
                  <c:v>162543</c:v>
                </c:pt>
                <c:pt idx="16">
                  <c:v>145969</c:v>
                </c:pt>
                <c:pt idx="17">
                  <c:v>114217</c:v>
                </c:pt>
                <c:pt idx="18">
                  <c:v>121907</c:v>
                </c:pt>
                <c:pt idx="19">
                  <c:v>184567</c:v>
                </c:pt>
                <c:pt idx="20">
                  <c:v>200076</c:v>
                </c:pt>
                <c:pt idx="21">
                  <c:v>165138</c:v>
                </c:pt>
                <c:pt idx="22">
                  <c:v>154026</c:v>
                </c:pt>
                <c:pt idx="23">
                  <c:v>161806</c:v>
                </c:pt>
                <c:pt idx="24">
                  <c:v>139405</c:v>
                </c:pt>
                <c:pt idx="25">
                  <c:v>369954</c:v>
                </c:pt>
                <c:pt idx="26">
                  <c:v>120149</c:v>
                </c:pt>
                <c:pt idx="27">
                  <c:v>129799</c:v>
                </c:pt>
                <c:pt idx="28">
                  <c:v>182964</c:v>
                </c:pt>
                <c:pt idx="29">
                  <c:v>330492</c:v>
                </c:pt>
                <c:pt idx="30">
                  <c:v>236437</c:v>
                </c:pt>
                <c:pt idx="31">
                  <c:v>200948</c:v>
                </c:pt>
                <c:pt idx="32">
                  <c:v>131513</c:v>
                </c:pt>
                <c:pt idx="33">
                  <c:v>153009</c:v>
                </c:pt>
                <c:pt idx="34">
                  <c:v>66168</c:v>
                </c:pt>
                <c:pt idx="35">
                  <c:v>203780</c:v>
                </c:pt>
                <c:pt idx="36">
                  <c:v>131850</c:v>
                </c:pt>
                <c:pt idx="37">
                  <c:v>149590</c:v>
                </c:pt>
                <c:pt idx="38">
                  <c:v>137596</c:v>
                </c:pt>
                <c:pt idx="39">
                  <c:v>194156</c:v>
                </c:pt>
                <c:pt idx="40">
                  <c:v>102564</c:v>
                </c:pt>
                <c:pt idx="41">
                  <c:v>141133</c:v>
                </c:pt>
                <c:pt idx="42">
                  <c:v>197834</c:v>
                </c:pt>
                <c:pt idx="43">
                  <c:v>206091</c:v>
                </c:pt>
                <c:pt idx="44">
                  <c:v>229813</c:v>
                </c:pt>
                <c:pt idx="45">
                  <c:v>158019</c:v>
                </c:pt>
                <c:pt idx="46">
                  <c:v>111078</c:v>
                </c:pt>
                <c:pt idx="47">
                  <c:v>113305</c:v>
                </c:pt>
                <c:pt idx="48">
                  <c:v>91841</c:v>
                </c:pt>
                <c:pt idx="49">
                  <c:v>90247</c:v>
                </c:pt>
                <c:pt idx="50">
                  <c:v>194201</c:v>
                </c:pt>
                <c:pt idx="51">
                  <c:v>123579</c:v>
                </c:pt>
                <c:pt idx="52">
                  <c:v>134334</c:v>
                </c:pt>
                <c:pt idx="53">
                  <c:v>199578</c:v>
                </c:pt>
                <c:pt idx="54">
                  <c:v>202151</c:v>
                </c:pt>
                <c:pt idx="55">
                  <c:v>208359</c:v>
                </c:pt>
                <c:pt idx="56">
                  <c:v>106987</c:v>
                </c:pt>
                <c:pt idx="57">
                  <c:v>154649</c:v>
                </c:pt>
                <c:pt idx="58">
                  <c:v>119094</c:v>
                </c:pt>
                <c:pt idx="59">
                  <c:v>207636</c:v>
                </c:pt>
                <c:pt idx="60">
                  <c:v>205341</c:v>
                </c:pt>
                <c:pt idx="61">
                  <c:v>273838</c:v>
                </c:pt>
                <c:pt idx="62">
                  <c:v>120286</c:v>
                </c:pt>
                <c:pt idx="63">
                  <c:v>102896</c:v>
                </c:pt>
                <c:pt idx="64">
                  <c:v>114259</c:v>
                </c:pt>
                <c:pt idx="65">
                  <c:v>60446</c:v>
                </c:pt>
                <c:pt idx="66">
                  <c:v>187765</c:v>
                </c:pt>
                <c:pt idx="67">
                  <c:v>221226</c:v>
                </c:pt>
                <c:pt idx="68">
                  <c:v>86897</c:v>
                </c:pt>
                <c:pt idx="69">
                  <c:v>188160</c:v>
                </c:pt>
                <c:pt idx="70">
                  <c:v>234755</c:v>
                </c:pt>
                <c:pt idx="71">
                  <c:v>65399</c:v>
                </c:pt>
                <c:pt idx="72">
                  <c:v>344137</c:v>
                </c:pt>
                <c:pt idx="73">
                  <c:v>192889</c:v>
                </c:pt>
                <c:pt idx="74">
                  <c:v>203110</c:v>
                </c:pt>
                <c:pt idx="75">
                  <c:v>112114</c:v>
                </c:pt>
                <c:pt idx="76">
                  <c:v>227146</c:v>
                </c:pt>
                <c:pt idx="77">
                  <c:v>185892</c:v>
                </c:pt>
                <c:pt idx="78">
                  <c:v>216658</c:v>
                </c:pt>
                <c:pt idx="79">
                  <c:v>141121</c:v>
                </c:pt>
                <c:pt idx="80">
                  <c:v>61708</c:v>
                </c:pt>
                <c:pt idx="81">
                  <c:v>98427</c:v>
                </c:pt>
                <c:pt idx="82">
                  <c:v>138281</c:v>
                </c:pt>
                <c:pt idx="83">
                  <c:v>376024</c:v>
                </c:pt>
                <c:pt idx="84">
                  <c:v>200856</c:v>
                </c:pt>
                <c:pt idx="85">
                  <c:v>115304</c:v>
                </c:pt>
                <c:pt idx="86">
                  <c:v>293648</c:v>
                </c:pt>
                <c:pt idx="87">
                  <c:v>128797</c:v>
                </c:pt>
                <c:pt idx="88">
                  <c:v>149882</c:v>
                </c:pt>
                <c:pt idx="89">
                  <c:v>212491</c:v>
                </c:pt>
                <c:pt idx="90">
                  <c:v>153837</c:v>
                </c:pt>
                <c:pt idx="91">
                  <c:v>194955</c:v>
                </c:pt>
                <c:pt idx="92">
                  <c:v>181017</c:v>
                </c:pt>
                <c:pt idx="93">
                  <c:v>167590</c:v>
                </c:pt>
                <c:pt idx="94">
                  <c:v>194743</c:v>
                </c:pt>
                <c:pt idx="95">
                  <c:v>170301</c:v>
                </c:pt>
                <c:pt idx="96">
                  <c:v>148028</c:v>
                </c:pt>
                <c:pt idx="97">
                  <c:v>217447</c:v>
                </c:pt>
                <c:pt idx="98">
                  <c:v>156260</c:v>
                </c:pt>
                <c:pt idx="99">
                  <c:v>46874</c:v>
                </c:pt>
                <c:pt idx="100">
                  <c:v>81596</c:v>
                </c:pt>
                <c:pt idx="101">
                  <c:v>124015</c:v>
                </c:pt>
                <c:pt idx="102">
                  <c:v>129488</c:v>
                </c:pt>
                <c:pt idx="103">
                  <c:v>152977</c:v>
                </c:pt>
                <c:pt idx="104">
                  <c:v>177447</c:v>
                </c:pt>
                <c:pt idx="105">
                  <c:v>83509</c:v>
                </c:pt>
                <c:pt idx="106">
                  <c:v>162725</c:v>
                </c:pt>
                <c:pt idx="107">
                  <c:v>218835</c:v>
                </c:pt>
                <c:pt idx="108">
                  <c:v>175871</c:v>
                </c:pt>
                <c:pt idx="109">
                  <c:v>179752</c:v>
                </c:pt>
                <c:pt idx="110">
                  <c:v>200536</c:v>
                </c:pt>
                <c:pt idx="111">
                  <c:v>117816</c:v>
                </c:pt>
                <c:pt idx="112">
                  <c:v>221429</c:v>
                </c:pt>
                <c:pt idx="113">
                  <c:v>146981</c:v>
                </c:pt>
                <c:pt idx="114">
                  <c:v>204780</c:v>
                </c:pt>
                <c:pt idx="115">
                  <c:v>186687</c:v>
                </c:pt>
                <c:pt idx="116">
                  <c:v>188985</c:v>
                </c:pt>
                <c:pt idx="117">
                  <c:v>274386</c:v>
                </c:pt>
                <c:pt idx="118">
                  <c:v>202807</c:v>
                </c:pt>
                <c:pt idx="119">
                  <c:v>169732</c:v>
                </c:pt>
                <c:pt idx="120">
                  <c:v>215066</c:v>
                </c:pt>
                <c:pt idx="121">
                  <c:v>113035</c:v>
                </c:pt>
                <c:pt idx="122">
                  <c:v>98624</c:v>
                </c:pt>
                <c:pt idx="123">
                  <c:v>205668</c:v>
                </c:pt>
                <c:pt idx="124">
                  <c:v>101462</c:v>
                </c:pt>
                <c:pt idx="125">
                  <c:v>235902</c:v>
                </c:pt>
                <c:pt idx="126">
                  <c:v>169473</c:v>
                </c:pt>
                <c:pt idx="127">
                  <c:v>154200</c:v>
                </c:pt>
                <c:pt idx="128">
                  <c:v>153941</c:v>
                </c:pt>
                <c:pt idx="129">
                  <c:v>100051</c:v>
                </c:pt>
                <c:pt idx="130">
                  <c:v>234194</c:v>
                </c:pt>
                <c:pt idx="131">
                  <c:v>122055</c:v>
                </c:pt>
                <c:pt idx="132">
                  <c:v>133275</c:v>
                </c:pt>
                <c:pt idx="133">
                  <c:v>210098</c:v>
                </c:pt>
                <c:pt idx="134">
                  <c:v>91823</c:v>
                </c:pt>
                <c:pt idx="135">
                  <c:v>110262</c:v>
                </c:pt>
                <c:pt idx="136">
                  <c:v>120843</c:v>
                </c:pt>
                <c:pt idx="137">
                  <c:v>132632</c:v>
                </c:pt>
                <c:pt idx="138">
                  <c:v>111358</c:v>
                </c:pt>
                <c:pt idx="139">
                  <c:v>220664</c:v>
                </c:pt>
                <c:pt idx="140">
                  <c:v>70894</c:v>
                </c:pt>
                <c:pt idx="141">
                  <c:v>175548</c:v>
                </c:pt>
                <c:pt idx="142">
                  <c:v>140691</c:v>
                </c:pt>
                <c:pt idx="143">
                  <c:v>78949</c:v>
                </c:pt>
                <c:pt idx="144">
                  <c:v>110802</c:v>
                </c:pt>
                <c:pt idx="145">
                  <c:v>126990</c:v>
                </c:pt>
                <c:pt idx="146">
                  <c:v>178429</c:v>
                </c:pt>
                <c:pt idx="147">
                  <c:v>131986</c:v>
                </c:pt>
                <c:pt idx="148">
                  <c:v>152738</c:v>
                </c:pt>
                <c:pt idx="149">
                  <c:v>111415</c:v>
                </c:pt>
                <c:pt idx="150">
                  <c:v>142086</c:v>
                </c:pt>
                <c:pt idx="151">
                  <c:v>129472</c:v>
                </c:pt>
                <c:pt idx="152">
                  <c:v>141208</c:v>
                </c:pt>
                <c:pt idx="153">
                  <c:v>109415</c:v>
                </c:pt>
                <c:pt idx="154">
                  <c:v>145180</c:v>
                </c:pt>
                <c:pt idx="155">
                  <c:v>113857</c:v>
                </c:pt>
                <c:pt idx="156">
                  <c:v>182068</c:v>
                </c:pt>
                <c:pt idx="157">
                  <c:v>90573</c:v>
                </c:pt>
                <c:pt idx="158">
                  <c:v>153538</c:v>
                </c:pt>
                <c:pt idx="159">
                  <c:v>161596</c:v>
                </c:pt>
                <c:pt idx="160">
                  <c:v>102720</c:v>
                </c:pt>
                <c:pt idx="161">
                  <c:v>185841</c:v>
                </c:pt>
                <c:pt idx="162">
                  <c:v>142484</c:v>
                </c:pt>
                <c:pt idx="163">
                  <c:v>91192</c:v>
                </c:pt>
                <c:pt idx="164">
                  <c:v>52839</c:v>
                </c:pt>
                <c:pt idx="165">
                  <c:v>151157</c:v>
                </c:pt>
                <c:pt idx="166">
                  <c:v>99680</c:v>
                </c:pt>
                <c:pt idx="167">
                  <c:v>96307</c:v>
                </c:pt>
                <c:pt idx="168">
                  <c:v>173563</c:v>
                </c:pt>
                <c:pt idx="169">
                  <c:v>164333</c:v>
                </c:pt>
                <c:pt idx="170">
                  <c:v>75690</c:v>
                </c:pt>
                <c:pt idx="171">
                  <c:v>87128</c:v>
                </c:pt>
                <c:pt idx="172">
                  <c:v>225868</c:v>
                </c:pt>
                <c:pt idx="173">
                  <c:v>106245</c:v>
                </c:pt>
                <c:pt idx="174">
                  <c:v>111148</c:v>
                </c:pt>
                <c:pt idx="175">
                  <c:v>78452</c:v>
                </c:pt>
                <c:pt idx="176">
                  <c:v>180262</c:v>
                </c:pt>
                <c:pt idx="177">
                  <c:v>131617</c:v>
                </c:pt>
                <c:pt idx="178">
                  <c:v>117265</c:v>
                </c:pt>
                <c:pt idx="179">
                  <c:v>112679</c:v>
                </c:pt>
                <c:pt idx="180">
                  <c:v>114277</c:v>
                </c:pt>
                <c:pt idx="181">
                  <c:v>166473</c:v>
                </c:pt>
                <c:pt idx="182">
                  <c:v>92081</c:v>
                </c:pt>
                <c:pt idx="183">
                  <c:v>51851</c:v>
                </c:pt>
                <c:pt idx="184">
                  <c:v>162812</c:v>
                </c:pt>
                <c:pt idx="185">
                  <c:v>94486</c:v>
                </c:pt>
                <c:pt idx="186">
                  <c:v>166411</c:v>
                </c:pt>
                <c:pt idx="187">
                  <c:v>106003</c:v>
                </c:pt>
                <c:pt idx="188">
                  <c:v>81103</c:v>
                </c:pt>
                <c:pt idx="189">
                  <c:v>133627</c:v>
                </c:pt>
                <c:pt idx="190">
                  <c:v>132350</c:v>
                </c:pt>
                <c:pt idx="191">
                  <c:v>86200</c:v>
                </c:pt>
                <c:pt idx="192">
                  <c:v>108983</c:v>
                </c:pt>
                <c:pt idx="193">
                  <c:v>113877</c:v>
                </c:pt>
                <c:pt idx="194">
                  <c:v>108172</c:v>
                </c:pt>
                <c:pt idx="195">
                  <c:v>63187</c:v>
                </c:pt>
                <c:pt idx="196">
                  <c:v>142418</c:v>
                </c:pt>
                <c:pt idx="197">
                  <c:v>49184</c:v>
                </c:pt>
                <c:pt idx="198">
                  <c:v>96734</c:v>
                </c:pt>
                <c:pt idx="199">
                  <c:v>128863</c:v>
                </c:pt>
                <c:pt idx="200">
                  <c:v>33576</c:v>
                </c:pt>
                <c:pt idx="201">
                  <c:v>96994</c:v>
                </c:pt>
                <c:pt idx="202">
                  <c:v>127724</c:v>
                </c:pt>
                <c:pt idx="203">
                  <c:v>90478</c:v>
                </c:pt>
                <c:pt idx="204">
                  <c:v>71313</c:v>
                </c:pt>
                <c:pt idx="205">
                  <c:v>107864</c:v>
                </c:pt>
                <c:pt idx="206">
                  <c:v>158669</c:v>
                </c:pt>
                <c:pt idx="207">
                  <c:v>117697</c:v>
                </c:pt>
                <c:pt idx="208">
                  <c:v>102074</c:v>
                </c:pt>
                <c:pt idx="209">
                  <c:v>107116</c:v>
                </c:pt>
                <c:pt idx="210">
                  <c:v>36602</c:v>
                </c:pt>
                <c:pt idx="211">
                  <c:v>56136</c:v>
                </c:pt>
                <c:pt idx="212">
                  <c:v>95157</c:v>
                </c:pt>
                <c:pt idx="213">
                  <c:v>169510</c:v>
                </c:pt>
                <c:pt idx="214">
                  <c:v>161008</c:v>
                </c:pt>
                <c:pt idx="215">
                  <c:v>58809</c:v>
                </c:pt>
                <c:pt idx="216">
                  <c:v>31534</c:v>
                </c:pt>
                <c:pt idx="217">
                  <c:v>67912</c:v>
                </c:pt>
                <c:pt idx="218">
                  <c:v>58956</c:v>
                </c:pt>
                <c:pt idx="219">
                  <c:v>27474</c:v>
                </c:pt>
                <c:pt idx="220">
                  <c:v>26627</c:v>
                </c:pt>
                <c:pt idx="221">
                  <c:v>38976</c:v>
                </c:pt>
                <c:pt idx="222">
                  <c:v>10028</c:v>
                </c:pt>
                <c:pt idx="223">
                  <c:v>21672</c:v>
                </c:pt>
                <c:pt idx="224">
                  <c:v>11620</c:v>
                </c:pt>
                <c:pt idx="225">
                  <c:v>27707</c:v>
                </c:pt>
                <c:pt idx="226">
                  <c:v>7464</c:v>
                </c:pt>
                <c:pt idx="227">
                  <c:v>19309</c:v>
                </c:pt>
                <c:pt idx="228">
                  <c:v>24239</c:v>
                </c:pt>
                <c:pt idx="229">
                  <c:v>41843</c:v>
                </c:pt>
                <c:pt idx="230">
                  <c:v>75680</c:v>
                </c:pt>
                <c:pt idx="231">
                  <c:v>70055</c:v>
                </c:pt>
                <c:pt idx="232">
                  <c:v>0</c:v>
                </c:pt>
                <c:pt idx="233">
                  <c:v>47776</c:v>
                </c:pt>
                <c:pt idx="234">
                  <c:v>3549</c:v>
                </c:pt>
                <c:pt idx="235">
                  <c:v>24149</c:v>
                </c:pt>
                <c:pt idx="236">
                  <c:v>11647</c:v>
                </c:pt>
                <c:pt idx="237">
                  <c:v>14158</c:v>
                </c:pt>
                <c:pt idx="238">
                  <c:v>25030</c:v>
                </c:pt>
                <c:pt idx="239">
                  <c:v>35087</c:v>
                </c:pt>
                <c:pt idx="240">
                  <c:v>48190</c:v>
                </c:pt>
                <c:pt idx="241">
                  <c:v>34617</c:v>
                </c:pt>
                <c:pt idx="242">
                  <c:v>22069</c:v>
                </c:pt>
                <c:pt idx="243">
                  <c:v>105369</c:v>
                </c:pt>
                <c:pt idx="244">
                  <c:v>23484</c:v>
                </c:pt>
                <c:pt idx="245">
                  <c:v>84257</c:v>
                </c:pt>
                <c:pt idx="246">
                  <c:v>45541</c:v>
                </c:pt>
                <c:pt idx="247">
                  <c:v>45690</c:v>
                </c:pt>
                <c:pt idx="248">
                  <c:v>39735</c:v>
                </c:pt>
                <c:pt idx="249">
                  <c:v>93572</c:v>
                </c:pt>
                <c:pt idx="250">
                  <c:v>71518</c:v>
                </c:pt>
                <c:pt idx="251">
                  <c:v>63311</c:v>
                </c:pt>
                <c:pt idx="252">
                  <c:v>67931</c:v>
                </c:pt>
                <c:pt idx="253">
                  <c:v>21626</c:v>
                </c:pt>
                <c:pt idx="254">
                  <c:v>15935</c:v>
                </c:pt>
                <c:pt idx="255">
                  <c:v>68106</c:v>
                </c:pt>
                <c:pt idx="256">
                  <c:v>8050</c:v>
                </c:pt>
                <c:pt idx="257">
                  <c:v>61914</c:v>
                </c:pt>
                <c:pt idx="258">
                  <c:v>45613</c:v>
                </c:pt>
                <c:pt idx="259">
                  <c:v>60331</c:v>
                </c:pt>
                <c:pt idx="260">
                  <c:v>37009</c:v>
                </c:pt>
                <c:pt idx="261">
                  <c:v>64931</c:v>
                </c:pt>
                <c:pt idx="262">
                  <c:v>65672</c:v>
                </c:pt>
                <c:pt idx="263">
                  <c:v>59715</c:v>
                </c:pt>
                <c:pt idx="264">
                  <c:v>31951</c:v>
                </c:pt>
                <c:pt idx="265">
                  <c:v>56307</c:v>
                </c:pt>
                <c:pt idx="266">
                  <c:v>11162</c:v>
                </c:pt>
                <c:pt idx="267">
                  <c:v>42390</c:v>
                </c:pt>
                <c:pt idx="268">
                  <c:v>54351</c:v>
                </c:pt>
                <c:pt idx="269">
                  <c:v>40358</c:v>
                </c:pt>
                <c:pt idx="270">
                  <c:v>62949</c:v>
                </c:pt>
                <c:pt idx="271">
                  <c:v>31622</c:v>
                </c:pt>
                <c:pt idx="272">
                  <c:v>36574</c:v>
                </c:pt>
                <c:pt idx="273">
                  <c:v>85035</c:v>
                </c:pt>
                <c:pt idx="274">
                  <c:v>52456</c:v>
                </c:pt>
                <c:pt idx="275">
                  <c:v>82280</c:v>
                </c:pt>
                <c:pt idx="276">
                  <c:v>29292</c:v>
                </c:pt>
                <c:pt idx="277">
                  <c:v>40760</c:v>
                </c:pt>
                <c:pt idx="278">
                  <c:v>64622</c:v>
                </c:pt>
                <c:pt idx="279">
                  <c:v>88612</c:v>
                </c:pt>
                <c:pt idx="280">
                  <c:v>72996</c:v>
                </c:pt>
                <c:pt idx="281">
                  <c:v>71110</c:v>
                </c:pt>
                <c:pt idx="282">
                  <c:v>28295</c:v>
                </c:pt>
                <c:pt idx="283">
                  <c:v>36010</c:v>
                </c:pt>
                <c:pt idx="284">
                  <c:v>39117</c:v>
                </c:pt>
                <c:pt idx="285">
                  <c:v>70837</c:v>
                </c:pt>
                <c:pt idx="286">
                  <c:v>69302</c:v>
                </c:pt>
                <c:pt idx="287">
                  <c:v>103100</c:v>
                </c:pt>
                <c:pt idx="288">
                  <c:v>45967</c:v>
                </c:pt>
                <c:pt idx="289">
                  <c:v>82341</c:v>
                </c:pt>
                <c:pt idx="290">
                  <c:v>85314</c:v>
                </c:pt>
                <c:pt idx="291">
                  <c:v>59402</c:v>
                </c:pt>
                <c:pt idx="292">
                  <c:v>159434</c:v>
                </c:pt>
                <c:pt idx="293">
                  <c:v>96128</c:v>
                </c:pt>
                <c:pt idx="294">
                  <c:v>101356</c:v>
                </c:pt>
                <c:pt idx="295">
                  <c:v>80577</c:v>
                </c:pt>
                <c:pt idx="296">
                  <c:v>81954</c:v>
                </c:pt>
                <c:pt idx="297">
                  <c:v>93445</c:v>
                </c:pt>
                <c:pt idx="298">
                  <c:v>73742</c:v>
                </c:pt>
                <c:pt idx="299">
                  <c:v>71765</c:v>
                </c:pt>
                <c:pt idx="300">
                  <c:v>58039</c:v>
                </c:pt>
                <c:pt idx="301">
                  <c:v>51992</c:v>
                </c:pt>
                <c:pt idx="302">
                  <c:v>51106</c:v>
                </c:pt>
                <c:pt idx="303">
                  <c:v>189314</c:v>
                </c:pt>
                <c:pt idx="304">
                  <c:v>95445</c:v>
                </c:pt>
                <c:pt idx="305">
                  <c:v>132116</c:v>
                </c:pt>
                <c:pt idx="306">
                  <c:v>116768</c:v>
                </c:pt>
                <c:pt idx="307">
                  <c:v>29797</c:v>
                </c:pt>
                <c:pt idx="308">
                  <c:v>69615</c:v>
                </c:pt>
                <c:pt idx="309">
                  <c:v>87301</c:v>
                </c:pt>
                <c:pt idx="310">
                  <c:v>67461</c:v>
                </c:pt>
                <c:pt idx="311">
                  <c:v>101134</c:v>
                </c:pt>
                <c:pt idx="312">
                  <c:v>81162</c:v>
                </c:pt>
                <c:pt idx="313">
                  <c:v>74267</c:v>
                </c:pt>
                <c:pt idx="314">
                  <c:v>92447</c:v>
                </c:pt>
                <c:pt idx="315">
                  <c:v>52440</c:v>
                </c:pt>
                <c:pt idx="316">
                  <c:v>59163</c:v>
                </c:pt>
                <c:pt idx="317">
                  <c:v>108380</c:v>
                </c:pt>
                <c:pt idx="318">
                  <c:v>46620</c:v>
                </c:pt>
                <c:pt idx="319">
                  <c:v>23375</c:v>
                </c:pt>
                <c:pt idx="320">
                  <c:v>43654</c:v>
                </c:pt>
                <c:pt idx="321">
                  <c:v>137310</c:v>
                </c:pt>
                <c:pt idx="322">
                  <c:v>72140</c:v>
                </c:pt>
                <c:pt idx="323">
                  <c:v>63445</c:v>
                </c:pt>
                <c:pt idx="324">
                  <c:v>79519</c:v>
                </c:pt>
                <c:pt idx="325">
                  <c:v>51547</c:v>
                </c:pt>
                <c:pt idx="326">
                  <c:v>93009</c:v>
                </c:pt>
                <c:pt idx="327">
                  <c:v>102804</c:v>
                </c:pt>
                <c:pt idx="328">
                  <c:v>79101</c:v>
                </c:pt>
                <c:pt idx="329">
                  <c:v>100597</c:v>
                </c:pt>
                <c:pt idx="330">
                  <c:v>83633</c:v>
                </c:pt>
                <c:pt idx="331">
                  <c:v>53319</c:v>
                </c:pt>
                <c:pt idx="332">
                  <c:v>55774</c:v>
                </c:pt>
                <c:pt idx="333">
                  <c:v>67111</c:v>
                </c:pt>
                <c:pt idx="334">
                  <c:v>112608</c:v>
                </c:pt>
                <c:pt idx="335">
                  <c:v>114901</c:v>
                </c:pt>
                <c:pt idx="336">
                  <c:v>124388</c:v>
                </c:pt>
                <c:pt idx="337">
                  <c:v>114838</c:v>
                </c:pt>
                <c:pt idx="338">
                  <c:v>116990</c:v>
                </c:pt>
                <c:pt idx="339">
                  <c:v>102983</c:v>
                </c:pt>
                <c:pt idx="340">
                  <c:v>179233</c:v>
                </c:pt>
                <c:pt idx="341">
                  <c:v>57731</c:v>
                </c:pt>
                <c:pt idx="342">
                  <c:v>65504</c:v>
                </c:pt>
                <c:pt idx="343">
                  <c:v>91032</c:v>
                </c:pt>
                <c:pt idx="344">
                  <c:v>92134</c:v>
                </c:pt>
                <c:pt idx="345">
                  <c:v>132162</c:v>
                </c:pt>
                <c:pt idx="346">
                  <c:v>108423</c:v>
                </c:pt>
                <c:pt idx="347">
                  <c:v>4589</c:v>
                </c:pt>
                <c:pt idx="348">
                  <c:v>107906</c:v>
                </c:pt>
                <c:pt idx="349">
                  <c:v>58533</c:v>
                </c:pt>
                <c:pt idx="350">
                  <c:v>96900</c:v>
                </c:pt>
                <c:pt idx="351">
                  <c:v>89626</c:v>
                </c:pt>
                <c:pt idx="352">
                  <c:v>71655</c:v>
                </c:pt>
                <c:pt idx="353">
                  <c:v>122300</c:v>
                </c:pt>
                <c:pt idx="354">
                  <c:v>36513</c:v>
                </c:pt>
                <c:pt idx="355">
                  <c:v>69676</c:v>
                </c:pt>
                <c:pt idx="356">
                  <c:v>98791</c:v>
                </c:pt>
                <c:pt idx="357">
                  <c:v>138492</c:v>
                </c:pt>
                <c:pt idx="358">
                  <c:v>100341</c:v>
                </c:pt>
                <c:pt idx="359">
                  <c:v>146906</c:v>
                </c:pt>
                <c:pt idx="360">
                  <c:v>60749</c:v>
                </c:pt>
                <c:pt idx="361">
                  <c:v>137281</c:v>
                </c:pt>
                <c:pt idx="362">
                  <c:v>103864</c:v>
                </c:pt>
                <c:pt idx="363">
                  <c:v>64666</c:v>
                </c:pt>
                <c:pt idx="364">
                  <c:v>87443</c:v>
                </c:pt>
                <c:pt idx="365">
                  <c:v>82742</c:v>
                </c:pt>
                <c:pt idx="366">
                  <c:v>132128</c:v>
                </c:pt>
                <c:pt idx="367">
                  <c:v>81507</c:v>
                </c:pt>
                <c:pt idx="368">
                  <c:v>94285</c:v>
                </c:pt>
                <c:pt idx="369">
                  <c:v>67923</c:v>
                </c:pt>
                <c:pt idx="370">
                  <c:v>103072</c:v>
                </c:pt>
                <c:pt idx="371">
                  <c:v>90719</c:v>
                </c:pt>
                <c:pt idx="372">
                  <c:v>96351</c:v>
                </c:pt>
                <c:pt idx="373">
                  <c:v>80107</c:v>
                </c:pt>
                <c:pt idx="374">
                  <c:v>107515</c:v>
                </c:pt>
                <c:pt idx="375">
                  <c:v>83477</c:v>
                </c:pt>
                <c:pt idx="376">
                  <c:v>115224</c:v>
                </c:pt>
                <c:pt idx="377">
                  <c:v>70198</c:v>
                </c:pt>
                <c:pt idx="378">
                  <c:v>131465</c:v>
                </c:pt>
                <c:pt idx="379">
                  <c:v>91453</c:v>
                </c:pt>
                <c:pt idx="380">
                  <c:v>91746</c:v>
                </c:pt>
                <c:pt idx="381">
                  <c:v>177933</c:v>
                </c:pt>
                <c:pt idx="382">
                  <c:v>99056</c:v>
                </c:pt>
                <c:pt idx="383">
                  <c:v>65326</c:v>
                </c:pt>
                <c:pt idx="384">
                  <c:v>44443</c:v>
                </c:pt>
                <c:pt idx="385">
                  <c:v>115975</c:v>
                </c:pt>
                <c:pt idx="386">
                  <c:v>112162</c:v>
                </c:pt>
                <c:pt idx="387">
                  <c:v>6157</c:v>
                </c:pt>
                <c:pt idx="388">
                  <c:v>101797</c:v>
                </c:pt>
                <c:pt idx="389">
                  <c:v>129024</c:v>
                </c:pt>
                <c:pt idx="390">
                  <c:v>76556</c:v>
                </c:pt>
                <c:pt idx="391">
                  <c:v>91239</c:v>
                </c:pt>
                <c:pt idx="392">
                  <c:v>177283</c:v>
                </c:pt>
                <c:pt idx="393">
                  <c:v>103601</c:v>
                </c:pt>
                <c:pt idx="394">
                  <c:v>109476</c:v>
                </c:pt>
                <c:pt idx="395">
                  <c:v>69572</c:v>
                </c:pt>
                <c:pt idx="396">
                  <c:v>135253</c:v>
                </c:pt>
                <c:pt idx="397">
                  <c:v>102831</c:v>
                </c:pt>
                <c:pt idx="398">
                  <c:v>125741</c:v>
                </c:pt>
                <c:pt idx="399">
                  <c:v>131619</c:v>
                </c:pt>
                <c:pt idx="400">
                  <c:v>91214</c:v>
                </c:pt>
                <c:pt idx="401">
                  <c:v>127123</c:v>
                </c:pt>
                <c:pt idx="402">
                  <c:v>14858</c:v>
                </c:pt>
                <c:pt idx="403">
                  <c:v>32666</c:v>
                </c:pt>
                <c:pt idx="404">
                  <c:v>132744</c:v>
                </c:pt>
                <c:pt idx="405">
                  <c:v>13798</c:v>
                </c:pt>
                <c:pt idx="406">
                  <c:v>135870</c:v>
                </c:pt>
                <c:pt idx="407">
                  <c:v>96369</c:v>
                </c:pt>
                <c:pt idx="408">
                  <c:v>103737</c:v>
                </c:pt>
                <c:pt idx="409">
                  <c:v>145041</c:v>
                </c:pt>
                <c:pt idx="410">
                  <c:v>133882</c:v>
                </c:pt>
                <c:pt idx="411">
                  <c:v>91446</c:v>
                </c:pt>
                <c:pt idx="412">
                  <c:v>139700</c:v>
                </c:pt>
                <c:pt idx="413">
                  <c:v>97136</c:v>
                </c:pt>
                <c:pt idx="414">
                  <c:v>146167</c:v>
                </c:pt>
                <c:pt idx="415">
                  <c:v>61970</c:v>
                </c:pt>
                <c:pt idx="416">
                  <c:v>86392</c:v>
                </c:pt>
                <c:pt idx="417">
                  <c:v>35284</c:v>
                </c:pt>
                <c:pt idx="418">
                  <c:v>75695</c:v>
                </c:pt>
                <c:pt idx="419">
                  <c:v>163627</c:v>
                </c:pt>
                <c:pt idx="420">
                  <c:v>115945</c:v>
                </c:pt>
                <c:pt idx="421">
                  <c:v>98346</c:v>
                </c:pt>
                <c:pt idx="422">
                  <c:v>153428</c:v>
                </c:pt>
                <c:pt idx="423">
                  <c:v>123283</c:v>
                </c:pt>
                <c:pt idx="424">
                  <c:v>105908</c:v>
                </c:pt>
                <c:pt idx="425">
                  <c:v>127952</c:v>
                </c:pt>
                <c:pt idx="426">
                  <c:v>94792</c:v>
                </c:pt>
                <c:pt idx="427">
                  <c:v>127056</c:v>
                </c:pt>
                <c:pt idx="428">
                  <c:v>119312</c:v>
                </c:pt>
                <c:pt idx="429">
                  <c:v>44803</c:v>
                </c:pt>
                <c:pt idx="430">
                  <c:v>64464</c:v>
                </c:pt>
                <c:pt idx="431">
                  <c:v>66048</c:v>
                </c:pt>
                <c:pt idx="432">
                  <c:v>133820</c:v>
                </c:pt>
                <c:pt idx="433">
                  <c:v>58251</c:v>
                </c:pt>
                <c:pt idx="434">
                  <c:v>144339</c:v>
                </c:pt>
                <c:pt idx="435">
                  <c:v>76676</c:v>
                </c:pt>
                <c:pt idx="436">
                  <c:v>89056</c:v>
                </c:pt>
                <c:pt idx="437">
                  <c:v>167592</c:v>
                </c:pt>
                <c:pt idx="438">
                  <c:v>131414</c:v>
                </c:pt>
                <c:pt idx="439">
                  <c:v>7029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657D-4092-BF8C-18C4FBEF3429}"/>
            </c:ext>
          </c:extLst>
        </c:ser>
        <c:ser>
          <c:idx val="1"/>
          <c:order val="1"/>
          <c:tx>
            <c:v>0mM</c:v>
          </c:tx>
          <c:spPr>
            <a:ln w="25400" cap="rnd">
              <a:noFill/>
              <a:round/>
            </a:ln>
            <a:effectLst/>
          </c:spPr>
          <c:marker>
            <c:symbol val="square"/>
            <c:size val="5"/>
            <c:spPr>
              <a:solidFill>
                <a:schemeClr val="accent6">
                  <a:lumMod val="75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3!$D$2:$D$221</c:f>
              <c:numCache>
                <c:formatCode>General</c:formatCode>
                <c:ptCount val="220"/>
                <c:pt idx="0">
                  <c:v>28.88</c:v>
                </c:pt>
                <c:pt idx="1">
                  <c:v>28.64</c:v>
                </c:pt>
                <c:pt idx="2">
                  <c:v>8.1</c:v>
                </c:pt>
                <c:pt idx="3">
                  <c:v>7.83</c:v>
                </c:pt>
                <c:pt idx="4">
                  <c:v>8.23</c:v>
                </c:pt>
                <c:pt idx="5">
                  <c:v>12.47</c:v>
                </c:pt>
                <c:pt idx="6">
                  <c:v>7.35</c:v>
                </c:pt>
                <c:pt idx="7">
                  <c:v>6.31</c:v>
                </c:pt>
                <c:pt idx="8">
                  <c:v>11.71</c:v>
                </c:pt>
                <c:pt idx="9">
                  <c:v>17.149999999999999</c:v>
                </c:pt>
                <c:pt idx="10">
                  <c:v>19.670000000000002</c:v>
                </c:pt>
                <c:pt idx="11">
                  <c:v>11.72</c:v>
                </c:pt>
                <c:pt idx="12">
                  <c:v>6.33</c:v>
                </c:pt>
                <c:pt idx="13">
                  <c:v>16.440000000000001</c:v>
                </c:pt>
                <c:pt idx="14">
                  <c:v>8.27</c:v>
                </c:pt>
                <c:pt idx="15">
                  <c:v>9.17</c:v>
                </c:pt>
                <c:pt idx="16">
                  <c:v>9.2899999999999991</c:v>
                </c:pt>
                <c:pt idx="17">
                  <c:v>5.0599999999999996</c:v>
                </c:pt>
                <c:pt idx="18">
                  <c:v>8.25</c:v>
                </c:pt>
                <c:pt idx="19">
                  <c:v>11.97</c:v>
                </c:pt>
                <c:pt idx="20">
                  <c:v>12.09</c:v>
                </c:pt>
                <c:pt idx="21">
                  <c:v>8.73</c:v>
                </c:pt>
                <c:pt idx="22">
                  <c:v>7.61</c:v>
                </c:pt>
                <c:pt idx="23">
                  <c:v>11.4</c:v>
                </c:pt>
                <c:pt idx="24">
                  <c:v>6.38</c:v>
                </c:pt>
                <c:pt idx="25">
                  <c:v>24.33</c:v>
                </c:pt>
                <c:pt idx="26">
                  <c:v>6.67</c:v>
                </c:pt>
                <c:pt idx="27">
                  <c:v>6.39</c:v>
                </c:pt>
                <c:pt idx="28">
                  <c:v>10.210000000000001</c:v>
                </c:pt>
                <c:pt idx="29">
                  <c:v>22.66</c:v>
                </c:pt>
                <c:pt idx="30">
                  <c:v>14.25</c:v>
                </c:pt>
                <c:pt idx="31">
                  <c:v>12.6</c:v>
                </c:pt>
                <c:pt idx="32">
                  <c:v>4.92</c:v>
                </c:pt>
                <c:pt idx="33">
                  <c:v>6.63</c:v>
                </c:pt>
                <c:pt idx="34">
                  <c:v>2.82</c:v>
                </c:pt>
                <c:pt idx="35">
                  <c:v>11.86</c:v>
                </c:pt>
                <c:pt idx="36">
                  <c:v>4.58</c:v>
                </c:pt>
                <c:pt idx="37">
                  <c:v>8.6999999999999993</c:v>
                </c:pt>
                <c:pt idx="38">
                  <c:v>5.7</c:v>
                </c:pt>
                <c:pt idx="39">
                  <c:v>11.66</c:v>
                </c:pt>
                <c:pt idx="40">
                  <c:v>6.45</c:v>
                </c:pt>
                <c:pt idx="41">
                  <c:v>13.41</c:v>
                </c:pt>
                <c:pt idx="42">
                  <c:v>5.9</c:v>
                </c:pt>
                <c:pt idx="43">
                  <c:v>11.99</c:v>
                </c:pt>
                <c:pt idx="44">
                  <c:v>9.91</c:v>
                </c:pt>
                <c:pt idx="45">
                  <c:v>8.5500000000000007</c:v>
                </c:pt>
                <c:pt idx="46">
                  <c:v>4.5</c:v>
                </c:pt>
                <c:pt idx="47">
                  <c:v>4.09</c:v>
                </c:pt>
                <c:pt idx="48">
                  <c:v>6.36</c:v>
                </c:pt>
                <c:pt idx="49">
                  <c:v>3.83</c:v>
                </c:pt>
                <c:pt idx="50">
                  <c:v>10.17</c:v>
                </c:pt>
                <c:pt idx="51">
                  <c:v>8.5</c:v>
                </c:pt>
                <c:pt idx="52">
                  <c:v>6.89</c:v>
                </c:pt>
                <c:pt idx="53">
                  <c:v>11.8</c:v>
                </c:pt>
                <c:pt idx="54">
                  <c:v>9.07</c:v>
                </c:pt>
                <c:pt idx="55">
                  <c:v>7.55</c:v>
                </c:pt>
                <c:pt idx="56">
                  <c:v>3.77</c:v>
                </c:pt>
                <c:pt idx="57">
                  <c:v>7.51</c:v>
                </c:pt>
                <c:pt idx="58">
                  <c:v>4.79</c:v>
                </c:pt>
                <c:pt idx="59">
                  <c:v>12.32</c:v>
                </c:pt>
                <c:pt idx="60">
                  <c:v>11.19</c:v>
                </c:pt>
                <c:pt idx="61">
                  <c:v>16.18</c:v>
                </c:pt>
                <c:pt idx="62">
                  <c:v>5.31</c:v>
                </c:pt>
                <c:pt idx="63">
                  <c:v>5.75</c:v>
                </c:pt>
                <c:pt idx="64">
                  <c:v>5.58</c:v>
                </c:pt>
                <c:pt idx="65">
                  <c:v>8.33</c:v>
                </c:pt>
                <c:pt idx="66">
                  <c:v>9.36</c:v>
                </c:pt>
                <c:pt idx="67">
                  <c:v>13.11</c:v>
                </c:pt>
                <c:pt idx="68">
                  <c:v>3.67</c:v>
                </c:pt>
                <c:pt idx="69">
                  <c:v>9.36</c:v>
                </c:pt>
                <c:pt idx="70">
                  <c:v>13.09</c:v>
                </c:pt>
                <c:pt idx="71">
                  <c:v>3.34</c:v>
                </c:pt>
                <c:pt idx="72">
                  <c:v>22.01</c:v>
                </c:pt>
                <c:pt idx="73">
                  <c:v>15.58</c:v>
                </c:pt>
                <c:pt idx="74">
                  <c:v>10.54</c:v>
                </c:pt>
                <c:pt idx="75">
                  <c:v>11.85</c:v>
                </c:pt>
                <c:pt idx="76">
                  <c:v>13.05</c:v>
                </c:pt>
                <c:pt idx="77">
                  <c:v>10.54</c:v>
                </c:pt>
                <c:pt idx="78">
                  <c:v>12.12</c:v>
                </c:pt>
                <c:pt idx="79">
                  <c:v>8.33</c:v>
                </c:pt>
                <c:pt idx="80">
                  <c:v>3.39</c:v>
                </c:pt>
                <c:pt idx="81">
                  <c:v>5.2</c:v>
                </c:pt>
                <c:pt idx="82">
                  <c:v>6.32</c:v>
                </c:pt>
                <c:pt idx="83">
                  <c:v>25.22</c:v>
                </c:pt>
                <c:pt idx="84">
                  <c:v>14</c:v>
                </c:pt>
                <c:pt idx="85">
                  <c:v>5.08</c:v>
                </c:pt>
                <c:pt idx="86">
                  <c:v>19.149999999999999</c:v>
                </c:pt>
                <c:pt idx="87">
                  <c:v>11.06</c:v>
                </c:pt>
                <c:pt idx="88">
                  <c:v>8.5299999999999994</c:v>
                </c:pt>
                <c:pt idx="89">
                  <c:v>9.2899999999999991</c:v>
                </c:pt>
                <c:pt idx="90">
                  <c:v>6.47</c:v>
                </c:pt>
                <c:pt idx="91">
                  <c:v>11.44</c:v>
                </c:pt>
                <c:pt idx="92">
                  <c:v>9.34</c:v>
                </c:pt>
                <c:pt idx="93">
                  <c:v>6.72</c:v>
                </c:pt>
                <c:pt idx="94">
                  <c:v>12.96</c:v>
                </c:pt>
                <c:pt idx="95">
                  <c:v>10.06</c:v>
                </c:pt>
                <c:pt idx="96">
                  <c:v>9.1999999999999993</c:v>
                </c:pt>
                <c:pt idx="97">
                  <c:v>12.67</c:v>
                </c:pt>
                <c:pt idx="98">
                  <c:v>7.49</c:v>
                </c:pt>
                <c:pt idx="99">
                  <c:v>1.86</c:v>
                </c:pt>
                <c:pt idx="100">
                  <c:v>2.89</c:v>
                </c:pt>
                <c:pt idx="101">
                  <c:v>9.33</c:v>
                </c:pt>
                <c:pt idx="102">
                  <c:v>7.76</c:v>
                </c:pt>
                <c:pt idx="103">
                  <c:v>8.3699999999999992</c:v>
                </c:pt>
                <c:pt idx="104">
                  <c:v>9.7100000000000009</c:v>
                </c:pt>
                <c:pt idx="105">
                  <c:v>2.97</c:v>
                </c:pt>
                <c:pt idx="106">
                  <c:v>5.81</c:v>
                </c:pt>
                <c:pt idx="107">
                  <c:v>4.3</c:v>
                </c:pt>
                <c:pt idx="108">
                  <c:v>9.69</c:v>
                </c:pt>
                <c:pt idx="109">
                  <c:v>9.18</c:v>
                </c:pt>
                <c:pt idx="110">
                  <c:v>14.2</c:v>
                </c:pt>
                <c:pt idx="111">
                  <c:v>11.38</c:v>
                </c:pt>
                <c:pt idx="112">
                  <c:v>7.95</c:v>
                </c:pt>
                <c:pt idx="113">
                  <c:v>7.23</c:v>
                </c:pt>
                <c:pt idx="114">
                  <c:v>10.34</c:v>
                </c:pt>
                <c:pt idx="115">
                  <c:v>11.11</c:v>
                </c:pt>
                <c:pt idx="116">
                  <c:v>11.05</c:v>
                </c:pt>
                <c:pt idx="117">
                  <c:v>9.17</c:v>
                </c:pt>
                <c:pt idx="118">
                  <c:v>12.17</c:v>
                </c:pt>
                <c:pt idx="119">
                  <c:v>11.15</c:v>
                </c:pt>
                <c:pt idx="120">
                  <c:v>12.29</c:v>
                </c:pt>
                <c:pt idx="121">
                  <c:v>4.41</c:v>
                </c:pt>
                <c:pt idx="122">
                  <c:v>4.99</c:v>
                </c:pt>
                <c:pt idx="123">
                  <c:v>6.22</c:v>
                </c:pt>
                <c:pt idx="124">
                  <c:v>6.58</c:v>
                </c:pt>
                <c:pt idx="125">
                  <c:v>13.97</c:v>
                </c:pt>
                <c:pt idx="126">
                  <c:v>8.58</c:v>
                </c:pt>
                <c:pt idx="127">
                  <c:v>7.73</c:v>
                </c:pt>
                <c:pt idx="128">
                  <c:v>6.5</c:v>
                </c:pt>
                <c:pt idx="129">
                  <c:v>5.47</c:v>
                </c:pt>
                <c:pt idx="130">
                  <c:v>10.82</c:v>
                </c:pt>
                <c:pt idx="131">
                  <c:v>6.78</c:v>
                </c:pt>
                <c:pt idx="132">
                  <c:v>7.17</c:v>
                </c:pt>
                <c:pt idx="133">
                  <c:v>12.25</c:v>
                </c:pt>
                <c:pt idx="134">
                  <c:v>12.63</c:v>
                </c:pt>
                <c:pt idx="135">
                  <c:v>4.9000000000000004</c:v>
                </c:pt>
                <c:pt idx="136">
                  <c:v>8.36</c:v>
                </c:pt>
                <c:pt idx="137">
                  <c:v>8.1199999999999992</c:v>
                </c:pt>
                <c:pt idx="138">
                  <c:v>4.46</c:v>
                </c:pt>
                <c:pt idx="139">
                  <c:v>13.8</c:v>
                </c:pt>
                <c:pt idx="140">
                  <c:v>3.27</c:v>
                </c:pt>
                <c:pt idx="141">
                  <c:v>8.52</c:v>
                </c:pt>
                <c:pt idx="142">
                  <c:v>7.24</c:v>
                </c:pt>
                <c:pt idx="143">
                  <c:v>3.3</c:v>
                </c:pt>
                <c:pt idx="144">
                  <c:v>5.2</c:v>
                </c:pt>
                <c:pt idx="145">
                  <c:v>8.01</c:v>
                </c:pt>
                <c:pt idx="146">
                  <c:v>10.78</c:v>
                </c:pt>
                <c:pt idx="147">
                  <c:v>6.64</c:v>
                </c:pt>
                <c:pt idx="148">
                  <c:v>7.5</c:v>
                </c:pt>
                <c:pt idx="149">
                  <c:v>4.7699999999999996</c:v>
                </c:pt>
                <c:pt idx="150">
                  <c:v>7.58</c:v>
                </c:pt>
                <c:pt idx="151">
                  <c:v>8.2200000000000006</c:v>
                </c:pt>
                <c:pt idx="152">
                  <c:v>7.66</c:v>
                </c:pt>
                <c:pt idx="153">
                  <c:v>3.67</c:v>
                </c:pt>
                <c:pt idx="154">
                  <c:v>6.05</c:v>
                </c:pt>
                <c:pt idx="155">
                  <c:v>7.01</c:v>
                </c:pt>
                <c:pt idx="156">
                  <c:v>10.24</c:v>
                </c:pt>
                <c:pt idx="157">
                  <c:v>4.5</c:v>
                </c:pt>
                <c:pt idx="158">
                  <c:v>8.74</c:v>
                </c:pt>
                <c:pt idx="159">
                  <c:v>8.2100000000000009</c:v>
                </c:pt>
                <c:pt idx="160">
                  <c:v>6.26</c:v>
                </c:pt>
                <c:pt idx="161">
                  <c:v>11.24</c:v>
                </c:pt>
                <c:pt idx="162">
                  <c:v>7.83</c:v>
                </c:pt>
                <c:pt idx="163">
                  <c:v>4.9400000000000004</c:v>
                </c:pt>
                <c:pt idx="164">
                  <c:v>2.71</c:v>
                </c:pt>
                <c:pt idx="165">
                  <c:v>8.36</c:v>
                </c:pt>
                <c:pt idx="166">
                  <c:v>4.37</c:v>
                </c:pt>
                <c:pt idx="167">
                  <c:v>2.88</c:v>
                </c:pt>
                <c:pt idx="168">
                  <c:v>15.23</c:v>
                </c:pt>
                <c:pt idx="169">
                  <c:v>5.84</c:v>
                </c:pt>
                <c:pt idx="170">
                  <c:v>3.34</c:v>
                </c:pt>
                <c:pt idx="171">
                  <c:v>3.89</c:v>
                </c:pt>
                <c:pt idx="172">
                  <c:v>13.23</c:v>
                </c:pt>
                <c:pt idx="173">
                  <c:v>6.35</c:v>
                </c:pt>
                <c:pt idx="174">
                  <c:v>5.45</c:v>
                </c:pt>
                <c:pt idx="175">
                  <c:v>4.25</c:v>
                </c:pt>
                <c:pt idx="176">
                  <c:v>9.08</c:v>
                </c:pt>
                <c:pt idx="177">
                  <c:v>6.64</c:v>
                </c:pt>
                <c:pt idx="178">
                  <c:v>7.48</c:v>
                </c:pt>
                <c:pt idx="179">
                  <c:v>5.28</c:v>
                </c:pt>
                <c:pt idx="180">
                  <c:v>4.49</c:v>
                </c:pt>
                <c:pt idx="181">
                  <c:v>9.02</c:v>
                </c:pt>
                <c:pt idx="182">
                  <c:v>2.71</c:v>
                </c:pt>
                <c:pt idx="183">
                  <c:v>1.74</c:v>
                </c:pt>
                <c:pt idx="184">
                  <c:v>7.53</c:v>
                </c:pt>
                <c:pt idx="185">
                  <c:v>2.63</c:v>
                </c:pt>
                <c:pt idx="186">
                  <c:v>7.84</c:v>
                </c:pt>
                <c:pt idx="187">
                  <c:v>5.32</c:v>
                </c:pt>
                <c:pt idx="188">
                  <c:v>4.79</c:v>
                </c:pt>
                <c:pt idx="189">
                  <c:v>6.33</c:v>
                </c:pt>
                <c:pt idx="190">
                  <c:v>7.91</c:v>
                </c:pt>
                <c:pt idx="191">
                  <c:v>5.48</c:v>
                </c:pt>
                <c:pt idx="192">
                  <c:v>6.26</c:v>
                </c:pt>
                <c:pt idx="193">
                  <c:v>5.43</c:v>
                </c:pt>
                <c:pt idx="194">
                  <c:v>5.77</c:v>
                </c:pt>
                <c:pt idx="195">
                  <c:v>2.4700000000000002</c:v>
                </c:pt>
                <c:pt idx="196">
                  <c:v>8.69</c:v>
                </c:pt>
                <c:pt idx="197">
                  <c:v>1.81</c:v>
                </c:pt>
                <c:pt idx="198">
                  <c:v>4.2</c:v>
                </c:pt>
                <c:pt idx="199">
                  <c:v>6.54</c:v>
                </c:pt>
                <c:pt idx="200">
                  <c:v>6.5</c:v>
                </c:pt>
                <c:pt idx="201">
                  <c:v>4.3099999999999996</c:v>
                </c:pt>
                <c:pt idx="202">
                  <c:v>6.33</c:v>
                </c:pt>
                <c:pt idx="203">
                  <c:v>4.49</c:v>
                </c:pt>
                <c:pt idx="204">
                  <c:v>3.32</c:v>
                </c:pt>
                <c:pt idx="205">
                  <c:v>5.09</c:v>
                </c:pt>
                <c:pt idx="206">
                  <c:v>9.36</c:v>
                </c:pt>
                <c:pt idx="207">
                  <c:v>5.6</c:v>
                </c:pt>
                <c:pt idx="208">
                  <c:v>3.83</c:v>
                </c:pt>
                <c:pt idx="209">
                  <c:v>6.17</c:v>
                </c:pt>
                <c:pt idx="210">
                  <c:v>1.83</c:v>
                </c:pt>
                <c:pt idx="211">
                  <c:v>8.07</c:v>
                </c:pt>
                <c:pt idx="212">
                  <c:v>4.38</c:v>
                </c:pt>
                <c:pt idx="213">
                  <c:v>1.75</c:v>
                </c:pt>
                <c:pt idx="214">
                  <c:v>1.6</c:v>
                </c:pt>
                <c:pt idx="215">
                  <c:v>3.02</c:v>
                </c:pt>
                <c:pt idx="216">
                  <c:v>1.98</c:v>
                </c:pt>
                <c:pt idx="217">
                  <c:v>2.88</c:v>
                </c:pt>
                <c:pt idx="218">
                  <c:v>2.69</c:v>
                </c:pt>
                <c:pt idx="219">
                  <c:v>1.31</c:v>
                </c:pt>
              </c:numCache>
            </c:numRef>
          </c:xVal>
          <c:yVal>
            <c:numRef>
              <c:f>Sheet3!$C$2:$C$221</c:f>
              <c:numCache>
                <c:formatCode>General</c:formatCode>
                <c:ptCount val="220"/>
                <c:pt idx="0">
                  <c:v>437958</c:v>
                </c:pt>
                <c:pt idx="1">
                  <c:v>486219</c:v>
                </c:pt>
                <c:pt idx="2">
                  <c:v>143902</c:v>
                </c:pt>
                <c:pt idx="3">
                  <c:v>159845</c:v>
                </c:pt>
                <c:pt idx="4">
                  <c:v>156093</c:v>
                </c:pt>
                <c:pt idx="5">
                  <c:v>202800</c:v>
                </c:pt>
                <c:pt idx="6">
                  <c:v>135048</c:v>
                </c:pt>
                <c:pt idx="7">
                  <c:v>138374</c:v>
                </c:pt>
                <c:pt idx="8">
                  <c:v>197892</c:v>
                </c:pt>
                <c:pt idx="9">
                  <c:v>300138</c:v>
                </c:pt>
                <c:pt idx="10">
                  <c:v>412058</c:v>
                </c:pt>
                <c:pt idx="11">
                  <c:v>213507</c:v>
                </c:pt>
                <c:pt idx="12">
                  <c:v>135720</c:v>
                </c:pt>
                <c:pt idx="13">
                  <c:v>232373</c:v>
                </c:pt>
                <c:pt idx="14">
                  <c:v>146323</c:v>
                </c:pt>
                <c:pt idx="15">
                  <c:v>162543</c:v>
                </c:pt>
                <c:pt idx="16">
                  <c:v>145969</c:v>
                </c:pt>
                <c:pt idx="17">
                  <c:v>114217</c:v>
                </c:pt>
                <c:pt idx="18">
                  <c:v>121907</c:v>
                </c:pt>
                <c:pt idx="19">
                  <c:v>184567</c:v>
                </c:pt>
                <c:pt idx="20">
                  <c:v>200076</c:v>
                </c:pt>
                <c:pt idx="21">
                  <c:v>165138</c:v>
                </c:pt>
                <c:pt idx="22">
                  <c:v>154026</c:v>
                </c:pt>
                <c:pt idx="23">
                  <c:v>161806</c:v>
                </c:pt>
                <c:pt idx="24">
                  <c:v>139405</c:v>
                </c:pt>
                <c:pt idx="25">
                  <c:v>369954</c:v>
                </c:pt>
                <c:pt idx="26">
                  <c:v>120149</c:v>
                </c:pt>
                <c:pt idx="27">
                  <c:v>129799</c:v>
                </c:pt>
                <c:pt idx="28">
                  <c:v>182964</c:v>
                </c:pt>
                <c:pt idx="29">
                  <c:v>330492</c:v>
                </c:pt>
                <c:pt idx="30">
                  <c:v>236437</c:v>
                </c:pt>
                <c:pt idx="31">
                  <c:v>200948</c:v>
                </c:pt>
                <c:pt idx="32">
                  <c:v>131513</c:v>
                </c:pt>
                <c:pt idx="33">
                  <c:v>153009</c:v>
                </c:pt>
                <c:pt idx="34">
                  <c:v>66168</c:v>
                </c:pt>
                <c:pt idx="35">
                  <c:v>203780</c:v>
                </c:pt>
                <c:pt idx="36">
                  <c:v>131850</c:v>
                </c:pt>
                <c:pt idx="37">
                  <c:v>149590</c:v>
                </c:pt>
                <c:pt idx="38">
                  <c:v>137596</c:v>
                </c:pt>
                <c:pt idx="39">
                  <c:v>194156</c:v>
                </c:pt>
                <c:pt idx="40">
                  <c:v>102564</c:v>
                </c:pt>
                <c:pt idx="41">
                  <c:v>141133</c:v>
                </c:pt>
                <c:pt idx="42">
                  <c:v>197834</c:v>
                </c:pt>
                <c:pt idx="43">
                  <c:v>206091</c:v>
                </c:pt>
                <c:pt idx="44">
                  <c:v>229813</c:v>
                </c:pt>
                <c:pt idx="45">
                  <c:v>158019</c:v>
                </c:pt>
                <c:pt idx="46">
                  <c:v>111078</c:v>
                </c:pt>
                <c:pt idx="47">
                  <c:v>113305</c:v>
                </c:pt>
                <c:pt idx="48">
                  <c:v>91841</c:v>
                </c:pt>
                <c:pt idx="49">
                  <c:v>90247</c:v>
                </c:pt>
                <c:pt idx="50">
                  <c:v>194201</c:v>
                </c:pt>
                <c:pt idx="51">
                  <c:v>123579</c:v>
                </c:pt>
                <c:pt idx="52">
                  <c:v>134334</c:v>
                </c:pt>
                <c:pt idx="53">
                  <c:v>199578</c:v>
                </c:pt>
                <c:pt idx="54">
                  <c:v>202151</c:v>
                </c:pt>
                <c:pt idx="55">
                  <c:v>208359</c:v>
                </c:pt>
                <c:pt idx="56">
                  <c:v>106987</c:v>
                </c:pt>
                <c:pt idx="57">
                  <c:v>154649</c:v>
                </c:pt>
                <c:pt idx="58">
                  <c:v>119094</c:v>
                </c:pt>
                <c:pt idx="59">
                  <c:v>207636</c:v>
                </c:pt>
                <c:pt idx="60">
                  <c:v>205341</c:v>
                </c:pt>
                <c:pt idx="61">
                  <c:v>273838</c:v>
                </c:pt>
                <c:pt idx="62">
                  <c:v>120286</c:v>
                </c:pt>
                <c:pt idx="63">
                  <c:v>102896</c:v>
                </c:pt>
                <c:pt idx="64">
                  <c:v>114259</c:v>
                </c:pt>
                <c:pt idx="65">
                  <c:v>60446</c:v>
                </c:pt>
                <c:pt idx="66">
                  <c:v>187765</c:v>
                </c:pt>
                <c:pt idx="67">
                  <c:v>221226</c:v>
                </c:pt>
                <c:pt idx="68">
                  <c:v>86897</c:v>
                </c:pt>
                <c:pt idx="69">
                  <c:v>188160</c:v>
                </c:pt>
                <c:pt idx="70">
                  <c:v>234755</c:v>
                </c:pt>
                <c:pt idx="71">
                  <c:v>65399</c:v>
                </c:pt>
                <c:pt idx="72">
                  <c:v>344137</c:v>
                </c:pt>
                <c:pt idx="73">
                  <c:v>192889</c:v>
                </c:pt>
                <c:pt idx="74">
                  <c:v>203110</c:v>
                </c:pt>
                <c:pt idx="75">
                  <c:v>112114</c:v>
                </c:pt>
                <c:pt idx="76">
                  <c:v>227146</c:v>
                </c:pt>
                <c:pt idx="77">
                  <c:v>185892</c:v>
                </c:pt>
                <c:pt idx="78">
                  <c:v>216658</c:v>
                </c:pt>
                <c:pt idx="79">
                  <c:v>141121</c:v>
                </c:pt>
                <c:pt idx="80">
                  <c:v>61708</c:v>
                </c:pt>
                <c:pt idx="81">
                  <c:v>98427</c:v>
                </c:pt>
                <c:pt idx="82">
                  <c:v>138281</c:v>
                </c:pt>
                <c:pt idx="83">
                  <c:v>376024</c:v>
                </c:pt>
                <c:pt idx="84">
                  <c:v>200856</c:v>
                </c:pt>
                <c:pt idx="85">
                  <c:v>115304</c:v>
                </c:pt>
                <c:pt idx="86">
                  <c:v>293648</c:v>
                </c:pt>
                <c:pt idx="87">
                  <c:v>128797</c:v>
                </c:pt>
                <c:pt idx="88">
                  <c:v>149882</c:v>
                </c:pt>
                <c:pt idx="89">
                  <c:v>212491</c:v>
                </c:pt>
                <c:pt idx="90">
                  <c:v>153837</c:v>
                </c:pt>
                <c:pt idx="91">
                  <c:v>194955</c:v>
                </c:pt>
                <c:pt idx="92">
                  <c:v>181017</c:v>
                </c:pt>
                <c:pt idx="93">
                  <c:v>167590</c:v>
                </c:pt>
                <c:pt idx="94">
                  <c:v>194743</c:v>
                </c:pt>
                <c:pt idx="95">
                  <c:v>170301</c:v>
                </c:pt>
                <c:pt idx="96">
                  <c:v>148028</c:v>
                </c:pt>
                <c:pt idx="97">
                  <c:v>217447</c:v>
                </c:pt>
                <c:pt idx="98">
                  <c:v>156260</c:v>
                </c:pt>
                <c:pt idx="99">
                  <c:v>46874</c:v>
                </c:pt>
                <c:pt idx="100">
                  <c:v>81596</c:v>
                </c:pt>
                <c:pt idx="101">
                  <c:v>124015</c:v>
                </c:pt>
                <c:pt idx="102">
                  <c:v>129488</c:v>
                </c:pt>
                <c:pt idx="103">
                  <c:v>152977</c:v>
                </c:pt>
                <c:pt idx="104">
                  <c:v>177447</c:v>
                </c:pt>
                <c:pt idx="105">
                  <c:v>83509</c:v>
                </c:pt>
                <c:pt idx="106">
                  <c:v>162725</c:v>
                </c:pt>
                <c:pt idx="107">
                  <c:v>218835</c:v>
                </c:pt>
                <c:pt idx="108">
                  <c:v>175871</c:v>
                </c:pt>
                <c:pt idx="109">
                  <c:v>179752</c:v>
                </c:pt>
                <c:pt idx="110">
                  <c:v>200536</c:v>
                </c:pt>
                <c:pt idx="111">
                  <c:v>117816</c:v>
                </c:pt>
                <c:pt idx="112">
                  <c:v>221429</c:v>
                </c:pt>
                <c:pt idx="113">
                  <c:v>146981</c:v>
                </c:pt>
                <c:pt idx="114">
                  <c:v>204780</c:v>
                </c:pt>
                <c:pt idx="115">
                  <c:v>186687</c:v>
                </c:pt>
                <c:pt idx="116">
                  <c:v>188985</c:v>
                </c:pt>
                <c:pt idx="117">
                  <c:v>274386</c:v>
                </c:pt>
                <c:pt idx="118">
                  <c:v>202807</c:v>
                </c:pt>
                <c:pt idx="119">
                  <c:v>169732</c:v>
                </c:pt>
                <c:pt idx="120">
                  <c:v>215066</c:v>
                </c:pt>
                <c:pt idx="121">
                  <c:v>113035</c:v>
                </c:pt>
                <c:pt idx="122">
                  <c:v>98624</c:v>
                </c:pt>
                <c:pt idx="123">
                  <c:v>205668</c:v>
                </c:pt>
                <c:pt idx="124">
                  <c:v>101462</c:v>
                </c:pt>
                <c:pt idx="125">
                  <c:v>235902</c:v>
                </c:pt>
                <c:pt idx="126">
                  <c:v>169473</c:v>
                </c:pt>
                <c:pt idx="127">
                  <c:v>154200</c:v>
                </c:pt>
                <c:pt idx="128">
                  <c:v>153941</c:v>
                </c:pt>
                <c:pt idx="129">
                  <c:v>100051</c:v>
                </c:pt>
                <c:pt idx="130">
                  <c:v>234194</c:v>
                </c:pt>
                <c:pt idx="131">
                  <c:v>122055</c:v>
                </c:pt>
                <c:pt idx="132">
                  <c:v>133275</c:v>
                </c:pt>
                <c:pt idx="133">
                  <c:v>210098</c:v>
                </c:pt>
                <c:pt idx="134">
                  <c:v>91823</c:v>
                </c:pt>
                <c:pt idx="135">
                  <c:v>110262</c:v>
                </c:pt>
                <c:pt idx="136">
                  <c:v>120843</c:v>
                </c:pt>
                <c:pt idx="137">
                  <c:v>132632</c:v>
                </c:pt>
                <c:pt idx="138">
                  <c:v>111358</c:v>
                </c:pt>
                <c:pt idx="139">
                  <c:v>220664</c:v>
                </c:pt>
                <c:pt idx="140">
                  <c:v>70894</c:v>
                </c:pt>
                <c:pt idx="141">
                  <c:v>175548</c:v>
                </c:pt>
                <c:pt idx="142">
                  <c:v>140691</c:v>
                </c:pt>
                <c:pt idx="143">
                  <c:v>78949</c:v>
                </c:pt>
                <c:pt idx="144">
                  <c:v>110802</c:v>
                </c:pt>
                <c:pt idx="145">
                  <c:v>126990</c:v>
                </c:pt>
                <c:pt idx="146">
                  <c:v>178429</c:v>
                </c:pt>
                <c:pt idx="147">
                  <c:v>131986</c:v>
                </c:pt>
                <c:pt idx="148">
                  <c:v>152738</c:v>
                </c:pt>
                <c:pt idx="149">
                  <c:v>111415</c:v>
                </c:pt>
                <c:pt idx="150">
                  <c:v>142086</c:v>
                </c:pt>
                <c:pt idx="151">
                  <c:v>129472</c:v>
                </c:pt>
                <c:pt idx="152">
                  <c:v>141208</c:v>
                </c:pt>
                <c:pt idx="153">
                  <c:v>109415</c:v>
                </c:pt>
                <c:pt idx="154">
                  <c:v>145180</c:v>
                </c:pt>
                <c:pt idx="155">
                  <c:v>113857</c:v>
                </c:pt>
                <c:pt idx="156">
                  <c:v>182068</c:v>
                </c:pt>
                <c:pt idx="157">
                  <c:v>90573</c:v>
                </c:pt>
                <c:pt idx="158">
                  <c:v>153538</c:v>
                </c:pt>
                <c:pt idx="159">
                  <c:v>161596</c:v>
                </c:pt>
                <c:pt idx="160">
                  <c:v>102720</c:v>
                </c:pt>
                <c:pt idx="161">
                  <c:v>185841</c:v>
                </c:pt>
                <c:pt idx="162">
                  <c:v>142484</c:v>
                </c:pt>
                <c:pt idx="163">
                  <c:v>91192</c:v>
                </c:pt>
                <c:pt idx="164">
                  <c:v>52839</c:v>
                </c:pt>
                <c:pt idx="165">
                  <c:v>151157</c:v>
                </c:pt>
                <c:pt idx="166">
                  <c:v>99680</c:v>
                </c:pt>
                <c:pt idx="167">
                  <c:v>96307</c:v>
                </c:pt>
                <c:pt idx="168">
                  <c:v>173563</c:v>
                </c:pt>
                <c:pt idx="169">
                  <c:v>164333</c:v>
                </c:pt>
                <c:pt idx="170">
                  <c:v>75690</c:v>
                </c:pt>
                <c:pt idx="171">
                  <c:v>87128</c:v>
                </c:pt>
                <c:pt idx="172">
                  <c:v>225868</c:v>
                </c:pt>
                <c:pt idx="173">
                  <c:v>106245</c:v>
                </c:pt>
                <c:pt idx="174">
                  <c:v>111148</c:v>
                </c:pt>
                <c:pt idx="175">
                  <c:v>78452</c:v>
                </c:pt>
                <c:pt idx="176">
                  <c:v>180262</c:v>
                </c:pt>
                <c:pt idx="177">
                  <c:v>131617</c:v>
                </c:pt>
                <c:pt idx="178">
                  <c:v>117265</c:v>
                </c:pt>
                <c:pt idx="179">
                  <c:v>112679</c:v>
                </c:pt>
                <c:pt idx="180">
                  <c:v>114277</c:v>
                </c:pt>
                <c:pt idx="181">
                  <c:v>166473</c:v>
                </c:pt>
                <c:pt idx="182">
                  <c:v>92081</c:v>
                </c:pt>
                <c:pt idx="183">
                  <c:v>51851</c:v>
                </c:pt>
                <c:pt idx="184">
                  <c:v>162812</c:v>
                </c:pt>
                <c:pt idx="185">
                  <c:v>94486</c:v>
                </c:pt>
                <c:pt idx="186">
                  <c:v>166411</c:v>
                </c:pt>
                <c:pt idx="187">
                  <c:v>106003</c:v>
                </c:pt>
                <c:pt idx="188">
                  <c:v>81103</c:v>
                </c:pt>
                <c:pt idx="189">
                  <c:v>133627</c:v>
                </c:pt>
                <c:pt idx="190">
                  <c:v>132350</c:v>
                </c:pt>
                <c:pt idx="191">
                  <c:v>86200</c:v>
                </c:pt>
                <c:pt idx="192">
                  <c:v>108983</c:v>
                </c:pt>
                <c:pt idx="193">
                  <c:v>113877</c:v>
                </c:pt>
                <c:pt idx="194">
                  <c:v>108172</c:v>
                </c:pt>
                <c:pt idx="195">
                  <c:v>63187</c:v>
                </c:pt>
                <c:pt idx="196">
                  <c:v>142418</c:v>
                </c:pt>
                <c:pt idx="197">
                  <c:v>49184</c:v>
                </c:pt>
                <c:pt idx="198">
                  <c:v>96734</c:v>
                </c:pt>
                <c:pt idx="199">
                  <c:v>128863</c:v>
                </c:pt>
                <c:pt idx="200">
                  <c:v>33576</c:v>
                </c:pt>
                <c:pt idx="201">
                  <c:v>96994</c:v>
                </c:pt>
                <c:pt idx="202">
                  <c:v>127724</c:v>
                </c:pt>
                <c:pt idx="203">
                  <c:v>90478</c:v>
                </c:pt>
                <c:pt idx="204">
                  <c:v>71313</c:v>
                </c:pt>
                <c:pt idx="205">
                  <c:v>107864</c:v>
                </c:pt>
                <c:pt idx="206">
                  <c:v>158669</c:v>
                </c:pt>
                <c:pt idx="207">
                  <c:v>117697</c:v>
                </c:pt>
                <c:pt idx="208">
                  <c:v>102074</c:v>
                </c:pt>
                <c:pt idx="209">
                  <c:v>107116</c:v>
                </c:pt>
                <c:pt idx="210">
                  <c:v>36602</c:v>
                </c:pt>
                <c:pt idx="211">
                  <c:v>56136</c:v>
                </c:pt>
                <c:pt idx="212">
                  <c:v>95157</c:v>
                </c:pt>
                <c:pt idx="213">
                  <c:v>169510</c:v>
                </c:pt>
                <c:pt idx="214">
                  <c:v>161008</c:v>
                </c:pt>
                <c:pt idx="215">
                  <c:v>58809</c:v>
                </c:pt>
                <c:pt idx="216">
                  <c:v>31534</c:v>
                </c:pt>
                <c:pt idx="217">
                  <c:v>67912</c:v>
                </c:pt>
                <c:pt idx="218">
                  <c:v>58956</c:v>
                </c:pt>
                <c:pt idx="219">
                  <c:v>2747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657D-4092-BF8C-18C4FBEF3429}"/>
            </c:ext>
          </c:extLst>
        </c:ser>
        <c:ser>
          <c:idx val="2"/>
          <c:order val="2"/>
          <c:tx>
            <c:v>250mM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6"/>
            <c:spPr>
              <a:solidFill>
                <a:schemeClr val="accent2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3!$G$2:$G$221</c:f>
              <c:numCache>
                <c:formatCode>General</c:formatCode>
                <c:ptCount val="220"/>
                <c:pt idx="0">
                  <c:v>1.42</c:v>
                </c:pt>
                <c:pt idx="1">
                  <c:v>1.58</c:v>
                </c:pt>
                <c:pt idx="2">
                  <c:v>0.3</c:v>
                </c:pt>
                <c:pt idx="3">
                  <c:v>0.56000000000000005</c:v>
                </c:pt>
                <c:pt idx="4">
                  <c:v>0.4</c:v>
                </c:pt>
                <c:pt idx="5">
                  <c:v>0.93</c:v>
                </c:pt>
                <c:pt idx="6">
                  <c:v>0.3</c:v>
                </c:pt>
                <c:pt idx="7">
                  <c:v>0.5</c:v>
                </c:pt>
                <c:pt idx="8">
                  <c:v>0.39</c:v>
                </c:pt>
                <c:pt idx="9">
                  <c:v>1.39</c:v>
                </c:pt>
                <c:pt idx="10">
                  <c:v>2.2599999999999998</c:v>
                </c:pt>
                <c:pt idx="11">
                  <c:v>0.91</c:v>
                </c:pt>
                <c:pt idx="12">
                  <c:v>0.97</c:v>
                </c:pt>
                <c:pt idx="13">
                  <c:v>1.63</c:v>
                </c:pt>
                <c:pt idx="14">
                  <c:v>1</c:v>
                </c:pt>
                <c:pt idx="15">
                  <c:v>0.87</c:v>
                </c:pt>
                <c:pt idx="16">
                  <c:v>0.62</c:v>
                </c:pt>
                <c:pt idx="17">
                  <c:v>0.28999999999999998</c:v>
                </c:pt>
                <c:pt idx="18">
                  <c:v>1.31</c:v>
                </c:pt>
                <c:pt idx="19">
                  <c:v>1.21</c:v>
                </c:pt>
                <c:pt idx="20">
                  <c:v>2.23</c:v>
                </c:pt>
                <c:pt idx="21">
                  <c:v>1.1000000000000001</c:v>
                </c:pt>
                <c:pt idx="22">
                  <c:v>0.8</c:v>
                </c:pt>
                <c:pt idx="23">
                  <c:v>1.76</c:v>
                </c:pt>
                <c:pt idx="24">
                  <c:v>0.72</c:v>
                </c:pt>
                <c:pt idx="25">
                  <c:v>4.17</c:v>
                </c:pt>
                <c:pt idx="26">
                  <c:v>1.39</c:v>
                </c:pt>
                <c:pt idx="27">
                  <c:v>1.06</c:v>
                </c:pt>
                <c:pt idx="28">
                  <c:v>1.45</c:v>
                </c:pt>
                <c:pt idx="29">
                  <c:v>5.44</c:v>
                </c:pt>
                <c:pt idx="30">
                  <c:v>2.42</c:v>
                </c:pt>
                <c:pt idx="31">
                  <c:v>2.46</c:v>
                </c:pt>
                <c:pt idx="32">
                  <c:v>1.03</c:v>
                </c:pt>
                <c:pt idx="33">
                  <c:v>0.93</c:v>
                </c:pt>
                <c:pt idx="34">
                  <c:v>0.54</c:v>
                </c:pt>
                <c:pt idx="35">
                  <c:v>2.74</c:v>
                </c:pt>
                <c:pt idx="36">
                  <c:v>0.22</c:v>
                </c:pt>
                <c:pt idx="37">
                  <c:v>2.33</c:v>
                </c:pt>
                <c:pt idx="38">
                  <c:v>1.57</c:v>
                </c:pt>
                <c:pt idx="39">
                  <c:v>2</c:v>
                </c:pt>
                <c:pt idx="40">
                  <c:v>1.53</c:v>
                </c:pt>
                <c:pt idx="41">
                  <c:v>2.14</c:v>
                </c:pt>
                <c:pt idx="42">
                  <c:v>0.9</c:v>
                </c:pt>
                <c:pt idx="43">
                  <c:v>2.99</c:v>
                </c:pt>
                <c:pt idx="44">
                  <c:v>2.82</c:v>
                </c:pt>
                <c:pt idx="45">
                  <c:v>2.29</c:v>
                </c:pt>
                <c:pt idx="46">
                  <c:v>0.85</c:v>
                </c:pt>
                <c:pt idx="47">
                  <c:v>1.1200000000000001</c:v>
                </c:pt>
                <c:pt idx="48">
                  <c:v>1.55</c:v>
                </c:pt>
                <c:pt idx="49">
                  <c:v>1.1200000000000001</c:v>
                </c:pt>
                <c:pt idx="50">
                  <c:v>2.5099999999999998</c:v>
                </c:pt>
                <c:pt idx="51">
                  <c:v>1.23</c:v>
                </c:pt>
                <c:pt idx="52">
                  <c:v>1.53</c:v>
                </c:pt>
                <c:pt idx="53">
                  <c:v>3.99</c:v>
                </c:pt>
                <c:pt idx="54">
                  <c:v>2.41</c:v>
                </c:pt>
                <c:pt idx="55">
                  <c:v>2.54</c:v>
                </c:pt>
                <c:pt idx="56">
                  <c:v>0.89</c:v>
                </c:pt>
                <c:pt idx="57">
                  <c:v>1.87</c:v>
                </c:pt>
                <c:pt idx="58">
                  <c:v>1.56</c:v>
                </c:pt>
                <c:pt idx="59">
                  <c:v>4.5</c:v>
                </c:pt>
                <c:pt idx="60">
                  <c:v>2.52</c:v>
                </c:pt>
                <c:pt idx="61">
                  <c:v>4.4000000000000004</c:v>
                </c:pt>
                <c:pt idx="62">
                  <c:v>1.03</c:v>
                </c:pt>
                <c:pt idx="63">
                  <c:v>1.26</c:v>
                </c:pt>
                <c:pt idx="64">
                  <c:v>1.8</c:v>
                </c:pt>
                <c:pt idx="65">
                  <c:v>2.39</c:v>
                </c:pt>
                <c:pt idx="66">
                  <c:v>2.81</c:v>
                </c:pt>
                <c:pt idx="67">
                  <c:v>4.2699999999999996</c:v>
                </c:pt>
                <c:pt idx="68">
                  <c:v>1.46</c:v>
                </c:pt>
                <c:pt idx="69">
                  <c:v>3.48</c:v>
                </c:pt>
                <c:pt idx="70">
                  <c:v>3.71</c:v>
                </c:pt>
                <c:pt idx="71">
                  <c:v>1.1599999999999999</c:v>
                </c:pt>
                <c:pt idx="72">
                  <c:v>8.9499999999999993</c:v>
                </c:pt>
                <c:pt idx="73">
                  <c:v>5.6</c:v>
                </c:pt>
                <c:pt idx="74">
                  <c:v>4.38</c:v>
                </c:pt>
                <c:pt idx="75">
                  <c:v>3.61</c:v>
                </c:pt>
                <c:pt idx="76">
                  <c:v>4.84</c:v>
                </c:pt>
                <c:pt idx="77">
                  <c:v>3.79</c:v>
                </c:pt>
                <c:pt idx="78">
                  <c:v>4.1900000000000004</c:v>
                </c:pt>
                <c:pt idx="79">
                  <c:v>3.08</c:v>
                </c:pt>
                <c:pt idx="80">
                  <c:v>0.82</c:v>
                </c:pt>
                <c:pt idx="81">
                  <c:v>2.4</c:v>
                </c:pt>
                <c:pt idx="82">
                  <c:v>1.97</c:v>
                </c:pt>
                <c:pt idx="83">
                  <c:v>10.65</c:v>
                </c:pt>
                <c:pt idx="84">
                  <c:v>5.65</c:v>
                </c:pt>
                <c:pt idx="85">
                  <c:v>1.52</c:v>
                </c:pt>
                <c:pt idx="86">
                  <c:v>6.85</c:v>
                </c:pt>
                <c:pt idx="87">
                  <c:v>3.4</c:v>
                </c:pt>
                <c:pt idx="88">
                  <c:v>3.03</c:v>
                </c:pt>
                <c:pt idx="89">
                  <c:v>3.3</c:v>
                </c:pt>
                <c:pt idx="90">
                  <c:v>3.02</c:v>
                </c:pt>
                <c:pt idx="91">
                  <c:v>4.25</c:v>
                </c:pt>
                <c:pt idx="92">
                  <c:v>3.75</c:v>
                </c:pt>
                <c:pt idx="93">
                  <c:v>2.57</c:v>
                </c:pt>
                <c:pt idx="94">
                  <c:v>4.43</c:v>
                </c:pt>
                <c:pt idx="95">
                  <c:v>3.16</c:v>
                </c:pt>
                <c:pt idx="96">
                  <c:v>3.48</c:v>
                </c:pt>
                <c:pt idx="97">
                  <c:v>5.63</c:v>
                </c:pt>
                <c:pt idx="98">
                  <c:v>1.93</c:v>
                </c:pt>
                <c:pt idx="99">
                  <c:v>0.52</c:v>
                </c:pt>
                <c:pt idx="100">
                  <c:v>1.2</c:v>
                </c:pt>
                <c:pt idx="101">
                  <c:v>3.23</c:v>
                </c:pt>
                <c:pt idx="102">
                  <c:v>3.06</c:v>
                </c:pt>
                <c:pt idx="103">
                  <c:v>3.19</c:v>
                </c:pt>
                <c:pt idx="104">
                  <c:v>3.91</c:v>
                </c:pt>
                <c:pt idx="105">
                  <c:v>1.81</c:v>
                </c:pt>
                <c:pt idx="106">
                  <c:v>2.74</c:v>
                </c:pt>
                <c:pt idx="107">
                  <c:v>1.24</c:v>
                </c:pt>
                <c:pt idx="108">
                  <c:v>3.84</c:v>
                </c:pt>
                <c:pt idx="109">
                  <c:v>4.54</c:v>
                </c:pt>
                <c:pt idx="110">
                  <c:v>5.12</c:v>
                </c:pt>
                <c:pt idx="111">
                  <c:v>3.47</c:v>
                </c:pt>
                <c:pt idx="112">
                  <c:v>4.38</c:v>
                </c:pt>
                <c:pt idx="113">
                  <c:v>3.82</c:v>
                </c:pt>
                <c:pt idx="114">
                  <c:v>5.7</c:v>
                </c:pt>
                <c:pt idx="115">
                  <c:v>5.8</c:v>
                </c:pt>
                <c:pt idx="116">
                  <c:v>5.45</c:v>
                </c:pt>
                <c:pt idx="117">
                  <c:v>3.78</c:v>
                </c:pt>
                <c:pt idx="118">
                  <c:v>6.27</c:v>
                </c:pt>
                <c:pt idx="119">
                  <c:v>5.17</c:v>
                </c:pt>
                <c:pt idx="120">
                  <c:v>4.59</c:v>
                </c:pt>
                <c:pt idx="121">
                  <c:v>3.26</c:v>
                </c:pt>
                <c:pt idx="122">
                  <c:v>3.58</c:v>
                </c:pt>
                <c:pt idx="123">
                  <c:v>3.65</c:v>
                </c:pt>
                <c:pt idx="124">
                  <c:v>4.78</c:v>
                </c:pt>
                <c:pt idx="125">
                  <c:v>6.55</c:v>
                </c:pt>
                <c:pt idx="126">
                  <c:v>5.15</c:v>
                </c:pt>
                <c:pt idx="127">
                  <c:v>3.21</c:v>
                </c:pt>
                <c:pt idx="128">
                  <c:v>4.43</c:v>
                </c:pt>
                <c:pt idx="129">
                  <c:v>3.24</c:v>
                </c:pt>
                <c:pt idx="130">
                  <c:v>6.04</c:v>
                </c:pt>
                <c:pt idx="131">
                  <c:v>3.47</c:v>
                </c:pt>
                <c:pt idx="132">
                  <c:v>4</c:v>
                </c:pt>
                <c:pt idx="133">
                  <c:v>4.91</c:v>
                </c:pt>
                <c:pt idx="134">
                  <c:v>4.78</c:v>
                </c:pt>
                <c:pt idx="135">
                  <c:v>2.8</c:v>
                </c:pt>
                <c:pt idx="136">
                  <c:v>6.03</c:v>
                </c:pt>
                <c:pt idx="137">
                  <c:v>5.37</c:v>
                </c:pt>
                <c:pt idx="138">
                  <c:v>3.56</c:v>
                </c:pt>
                <c:pt idx="139">
                  <c:v>8.6999999999999993</c:v>
                </c:pt>
                <c:pt idx="140">
                  <c:v>2.21</c:v>
                </c:pt>
                <c:pt idx="141">
                  <c:v>6.14</c:v>
                </c:pt>
                <c:pt idx="142">
                  <c:v>4.3499999999999996</c:v>
                </c:pt>
                <c:pt idx="143">
                  <c:v>2.85</c:v>
                </c:pt>
                <c:pt idx="144">
                  <c:v>3.55</c:v>
                </c:pt>
                <c:pt idx="145">
                  <c:v>4.87</c:v>
                </c:pt>
                <c:pt idx="146">
                  <c:v>6.78</c:v>
                </c:pt>
                <c:pt idx="147">
                  <c:v>3.98</c:v>
                </c:pt>
                <c:pt idx="148">
                  <c:v>4.4800000000000004</c:v>
                </c:pt>
                <c:pt idx="149">
                  <c:v>2.6</c:v>
                </c:pt>
                <c:pt idx="150">
                  <c:v>4.6500000000000004</c:v>
                </c:pt>
                <c:pt idx="151">
                  <c:v>5.33</c:v>
                </c:pt>
                <c:pt idx="152">
                  <c:v>4.5599999999999996</c:v>
                </c:pt>
                <c:pt idx="153">
                  <c:v>3</c:v>
                </c:pt>
                <c:pt idx="154">
                  <c:v>3.95</c:v>
                </c:pt>
                <c:pt idx="155">
                  <c:v>4.75</c:v>
                </c:pt>
                <c:pt idx="156">
                  <c:v>8.5399999999999991</c:v>
                </c:pt>
                <c:pt idx="157">
                  <c:v>2.8</c:v>
                </c:pt>
                <c:pt idx="158">
                  <c:v>6.69</c:v>
                </c:pt>
                <c:pt idx="159">
                  <c:v>3.9</c:v>
                </c:pt>
                <c:pt idx="160">
                  <c:v>3.79</c:v>
                </c:pt>
                <c:pt idx="161">
                  <c:v>11.71</c:v>
                </c:pt>
                <c:pt idx="162">
                  <c:v>5.43</c:v>
                </c:pt>
                <c:pt idx="163">
                  <c:v>2.89</c:v>
                </c:pt>
                <c:pt idx="164">
                  <c:v>2.1</c:v>
                </c:pt>
                <c:pt idx="165">
                  <c:v>6.02</c:v>
                </c:pt>
                <c:pt idx="166">
                  <c:v>4.6900000000000004</c:v>
                </c:pt>
                <c:pt idx="167">
                  <c:v>1.84</c:v>
                </c:pt>
                <c:pt idx="168">
                  <c:v>10.37</c:v>
                </c:pt>
                <c:pt idx="169">
                  <c:v>4.41</c:v>
                </c:pt>
                <c:pt idx="170">
                  <c:v>2.99</c:v>
                </c:pt>
                <c:pt idx="171">
                  <c:v>4.49</c:v>
                </c:pt>
                <c:pt idx="172">
                  <c:v>10.119999999999999</c:v>
                </c:pt>
                <c:pt idx="173">
                  <c:v>4.8899999999999997</c:v>
                </c:pt>
                <c:pt idx="174">
                  <c:v>4.76</c:v>
                </c:pt>
                <c:pt idx="175">
                  <c:v>3.36</c:v>
                </c:pt>
                <c:pt idx="176">
                  <c:v>7.93</c:v>
                </c:pt>
                <c:pt idx="177">
                  <c:v>5.6</c:v>
                </c:pt>
                <c:pt idx="178">
                  <c:v>6.73</c:v>
                </c:pt>
                <c:pt idx="179">
                  <c:v>4.76</c:v>
                </c:pt>
                <c:pt idx="180">
                  <c:v>4.22</c:v>
                </c:pt>
                <c:pt idx="181">
                  <c:v>6.66</c:v>
                </c:pt>
                <c:pt idx="182">
                  <c:v>3.26</c:v>
                </c:pt>
                <c:pt idx="183">
                  <c:v>1.26</c:v>
                </c:pt>
                <c:pt idx="184">
                  <c:v>6.05</c:v>
                </c:pt>
                <c:pt idx="185">
                  <c:v>2.84</c:v>
                </c:pt>
                <c:pt idx="186">
                  <c:v>8.6199999999999992</c:v>
                </c:pt>
                <c:pt idx="187">
                  <c:v>4.5199999999999996</c:v>
                </c:pt>
                <c:pt idx="188">
                  <c:v>4.95</c:v>
                </c:pt>
                <c:pt idx="189">
                  <c:v>6.13</c:v>
                </c:pt>
                <c:pt idx="190">
                  <c:v>7.76</c:v>
                </c:pt>
                <c:pt idx="191">
                  <c:v>5.97</c:v>
                </c:pt>
                <c:pt idx="192">
                  <c:v>6.65</c:v>
                </c:pt>
                <c:pt idx="193">
                  <c:v>4.32</c:v>
                </c:pt>
                <c:pt idx="194">
                  <c:v>8.23</c:v>
                </c:pt>
                <c:pt idx="195">
                  <c:v>2.87</c:v>
                </c:pt>
                <c:pt idx="196">
                  <c:v>6.93</c:v>
                </c:pt>
                <c:pt idx="197">
                  <c:v>0.85</c:v>
                </c:pt>
                <c:pt idx="198">
                  <c:v>4.18</c:v>
                </c:pt>
                <c:pt idx="199">
                  <c:v>8</c:v>
                </c:pt>
                <c:pt idx="200">
                  <c:v>7.74</c:v>
                </c:pt>
                <c:pt idx="201">
                  <c:v>5.34</c:v>
                </c:pt>
                <c:pt idx="202">
                  <c:v>7.71</c:v>
                </c:pt>
                <c:pt idx="203">
                  <c:v>6.87</c:v>
                </c:pt>
                <c:pt idx="204">
                  <c:v>4.0999999999999996</c:v>
                </c:pt>
                <c:pt idx="205">
                  <c:v>7.4</c:v>
                </c:pt>
                <c:pt idx="206">
                  <c:v>4.82</c:v>
                </c:pt>
                <c:pt idx="207">
                  <c:v>6.47</c:v>
                </c:pt>
                <c:pt idx="208">
                  <c:v>5.43</c:v>
                </c:pt>
                <c:pt idx="209">
                  <c:v>6.63</c:v>
                </c:pt>
                <c:pt idx="210">
                  <c:v>3.86</c:v>
                </c:pt>
                <c:pt idx="211">
                  <c:v>7.31</c:v>
                </c:pt>
                <c:pt idx="212">
                  <c:v>6.55</c:v>
                </c:pt>
                <c:pt idx="213">
                  <c:v>2.57</c:v>
                </c:pt>
                <c:pt idx="214">
                  <c:v>3.71</c:v>
                </c:pt>
                <c:pt idx="215">
                  <c:v>3.34</c:v>
                </c:pt>
                <c:pt idx="216">
                  <c:v>4.68</c:v>
                </c:pt>
                <c:pt idx="217">
                  <c:v>8.7200000000000006</c:v>
                </c:pt>
                <c:pt idx="218">
                  <c:v>6.83</c:v>
                </c:pt>
                <c:pt idx="219">
                  <c:v>3.89</c:v>
                </c:pt>
              </c:numCache>
            </c:numRef>
          </c:xVal>
          <c:yVal>
            <c:numRef>
              <c:f>Sheet3!$F$2:$F$221</c:f>
              <c:numCache>
                <c:formatCode>General</c:formatCode>
                <c:ptCount val="220"/>
                <c:pt idx="0">
                  <c:v>26627</c:v>
                </c:pt>
                <c:pt idx="1">
                  <c:v>38976</c:v>
                </c:pt>
                <c:pt idx="2">
                  <c:v>10028</c:v>
                </c:pt>
                <c:pt idx="3">
                  <c:v>21672</c:v>
                </c:pt>
                <c:pt idx="4">
                  <c:v>11620</c:v>
                </c:pt>
                <c:pt idx="5">
                  <c:v>27707</c:v>
                </c:pt>
                <c:pt idx="6">
                  <c:v>7464</c:v>
                </c:pt>
                <c:pt idx="7">
                  <c:v>19309</c:v>
                </c:pt>
                <c:pt idx="8">
                  <c:v>24239</c:v>
                </c:pt>
                <c:pt idx="9">
                  <c:v>41843</c:v>
                </c:pt>
                <c:pt idx="10">
                  <c:v>75680</c:v>
                </c:pt>
                <c:pt idx="11">
                  <c:v>70055</c:v>
                </c:pt>
                <c:pt idx="12">
                  <c:v>0</c:v>
                </c:pt>
                <c:pt idx="13">
                  <c:v>47776</c:v>
                </c:pt>
                <c:pt idx="14">
                  <c:v>3549</c:v>
                </c:pt>
                <c:pt idx="15">
                  <c:v>24149</c:v>
                </c:pt>
                <c:pt idx="16">
                  <c:v>11647</c:v>
                </c:pt>
                <c:pt idx="17">
                  <c:v>14158</c:v>
                </c:pt>
                <c:pt idx="18">
                  <c:v>25030</c:v>
                </c:pt>
                <c:pt idx="19">
                  <c:v>35087</c:v>
                </c:pt>
                <c:pt idx="20">
                  <c:v>48190</c:v>
                </c:pt>
                <c:pt idx="21">
                  <c:v>34617</c:v>
                </c:pt>
                <c:pt idx="22">
                  <c:v>22069</c:v>
                </c:pt>
                <c:pt idx="23">
                  <c:v>105369</c:v>
                </c:pt>
                <c:pt idx="24">
                  <c:v>23484</c:v>
                </c:pt>
                <c:pt idx="25">
                  <c:v>84257</c:v>
                </c:pt>
                <c:pt idx="26">
                  <c:v>45541</c:v>
                </c:pt>
                <c:pt idx="27">
                  <c:v>45690</c:v>
                </c:pt>
                <c:pt idx="28">
                  <c:v>39735</c:v>
                </c:pt>
                <c:pt idx="29">
                  <c:v>93572</c:v>
                </c:pt>
                <c:pt idx="30">
                  <c:v>71518</c:v>
                </c:pt>
                <c:pt idx="31">
                  <c:v>63311</c:v>
                </c:pt>
                <c:pt idx="32">
                  <c:v>67931</c:v>
                </c:pt>
                <c:pt idx="33">
                  <c:v>21626</c:v>
                </c:pt>
                <c:pt idx="34">
                  <c:v>15935</c:v>
                </c:pt>
                <c:pt idx="35">
                  <c:v>68106</c:v>
                </c:pt>
                <c:pt idx="36">
                  <c:v>8050</c:v>
                </c:pt>
                <c:pt idx="37">
                  <c:v>61914</c:v>
                </c:pt>
                <c:pt idx="38">
                  <c:v>45613</c:v>
                </c:pt>
                <c:pt idx="39">
                  <c:v>60331</c:v>
                </c:pt>
                <c:pt idx="40">
                  <c:v>37009</c:v>
                </c:pt>
                <c:pt idx="41">
                  <c:v>64931</c:v>
                </c:pt>
                <c:pt idx="42">
                  <c:v>65672</c:v>
                </c:pt>
                <c:pt idx="43">
                  <c:v>59715</c:v>
                </c:pt>
                <c:pt idx="44">
                  <c:v>31951</c:v>
                </c:pt>
                <c:pt idx="45">
                  <c:v>56307</c:v>
                </c:pt>
                <c:pt idx="46">
                  <c:v>11162</c:v>
                </c:pt>
                <c:pt idx="47">
                  <c:v>42390</c:v>
                </c:pt>
                <c:pt idx="48">
                  <c:v>54351</c:v>
                </c:pt>
                <c:pt idx="49">
                  <c:v>40358</c:v>
                </c:pt>
                <c:pt idx="50">
                  <c:v>62949</c:v>
                </c:pt>
                <c:pt idx="51">
                  <c:v>31622</c:v>
                </c:pt>
                <c:pt idx="52">
                  <c:v>36574</c:v>
                </c:pt>
                <c:pt idx="53">
                  <c:v>85035</c:v>
                </c:pt>
                <c:pt idx="54">
                  <c:v>52456</c:v>
                </c:pt>
                <c:pt idx="55">
                  <c:v>82280</c:v>
                </c:pt>
                <c:pt idx="56">
                  <c:v>29292</c:v>
                </c:pt>
                <c:pt idx="57">
                  <c:v>40760</c:v>
                </c:pt>
                <c:pt idx="58">
                  <c:v>64622</c:v>
                </c:pt>
                <c:pt idx="59">
                  <c:v>88612</c:v>
                </c:pt>
                <c:pt idx="60">
                  <c:v>72996</c:v>
                </c:pt>
                <c:pt idx="61">
                  <c:v>71110</c:v>
                </c:pt>
                <c:pt idx="62">
                  <c:v>28295</c:v>
                </c:pt>
                <c:pt idx="63">
                  <c:v>36010</c:v>
                </c:pt>
                <c:pt idx="64">
                  <c:v>39117</c:v>
                </c:pt>
                <c:pt idx="65">
                  <c:v>70837</c:v>
                </c:pt>
                <c:pt idx="66">
                  <c:v>69302</c:v>
                </c:pt>
                <c:pt idx="67">
                  <c:v>103100</c:v>
                </c:pt>
                <c:pt idx="68">
                  <c:v>45967</c:v>
                </c:pt>
                <c:pt idx="69">
                  <c:v>82341</c:v>
                </c:pt>
                <c:pt idx="70">
                  <c:v>85314</c:v>
                </c:pt>
                <c:pt idx="71">
                  <c:v>59402</c:v>
                </c:pt>
                <c:pt idx="72">
                  <c:v>159434</c:v>
                </c:pt>
                <c:pt idx="73">
                  <c:v>96128</c:v>
                </c:pt>
                <c:pt idx="74">
                  <c:v>101356</c:v>
                </c:pt>
                <c:pt idx="75">
                  <c:v>80577</c:v>
                </c:pt>
                <c:pt idx="76">
                  <c:v>81954</c:v>
                </c:pt>
                <c:pt idx="77">
                  <c:v>93445</c:v>
                </c:pt>
                <c:pt idx="78">
                  <c:v>73742</c:v>
                </c:pt>
                <c:pt idx="79">
                  <c:v>71765</c:v>
                </c:pt>
                <c:pt idx="80">
                  <c:v>58039</c:v>
                </c:pt>
                <c:pt idx="81">
                  <c:v>51992</c:v>
                </c:pt>
                <c:pt idx="82">
                  <c:v>51106</c:v>
                </c:pt>
                <c:pt idx="83">
                  <c:v>189314</c:v>
                </c:pt>
                <c:pt idx="84">
                  <c:v>95445</c:v>
                </c:pt>
                <c:pt idx="85">
                  <c:v>132116</c:v>
                </c:pt>
                <c:pt idx="86">
                  <c:v>116768</c:v>
                </c:pt>
                <c:pt idx="87">
                  <c:v>29797</c:v>
                </c:pt>
                <c:pt idx="88">
                  <c:v>69615</c:v>
                </c:pt>
                <c:pt idx="89">
                  <c:v>87301</c:v>
                </c:pt>
                <c:pt idx="90">
                  <c:v>67461</c:v>
                </c:pt>
                <c:pt idx="91">
                  <c:v>101134</c:v>
                </c:pt>
                <c:pt idx="92">
                  <c:v>81162</c:v>
                </c:pt>
                <c:pt idx="93">
                  <c:v>74267</c:v>
                </c:pt>
                <c:pt idx="94">
                  <c:v>92447</c:v>
                </c:pt>
                <c:pt idx="95">
                  <c:v>52440</c:v>
                </c:pt>
                <c:pt idx="96">
                  <c:v>59163</c:v>
                </c:pt>
                <c:pt idx="97">
                  <c:v>108380</c:v>
                </c:pt>
                <c:pt idx="98">
                  <c:v>46620</c:v>
                </c:pt>
                <c:pt idx="99">
                  <c:v>23375</c:v>
                </c:pt>
                <c:pt idx="100">
                  <c:v>43654</c:v>
                </c:pt>
                <c:pt idx="101">
                  <c:v>137310</c:v>
                </c:pt>
                <c:pt idx="102">
                  <c:v>72140</c:v>
                </c:pt>
                <c:pt idx="103">
                  <c:v>63445</c:v>
                </c:pt>
                <c:pt idx="104">
                  <c:v>79519</c:v>
                </c:pt>
                <c:pt idx="105">
                  <c:v>51547</c:v>
                </c:pt>
                <c:pt idx="106">
                  <c:v>93009</c:v>
                </c:pt>
                <c:pt idx="107">
                  <c:v>102804</c:v>
                </c:pt>
                <c:pt idx="108">
                  <c:v>79101</c:v>
                </c:pt>
                <c:pt idx="109">
                  <c:v>100597</c:v>
                </c:pt>
                <c:pt idx="110">
                  <c:v>83633</c:v>
                </c:pt>
                <c:pt idx="111">
                  <c:v>53319</c:v>
                </c:pt>
                <c:pt idx="112">
                  <c:v>55774</c:v>
                </c:pt>
                <c:pt idx="113">
                  <c:v>67111</c:v>
                </c:pt>
                <c:pt idx="114">
                  <c:v>112608</c:v>
                </c:pt>
                <c:pt idx="115">
                  <c:v>114901</c:v>
                </c:pt>
                <c:pt idx="116">
                  <c:v>124388</c:v>
                </c:pt>
                <c:pt idx="117">
                  <c:v>114838</c:v>
                </c:pt>
                <c:pt idx="118">
                  <c:v>116990</c:v>
                </c:pt>
                <c:pt idx="119">
                  <c:v>102983</c:v>
                </c:pt>
                <c:pt idx="120">
                  <c:v>179233</c:v>
                </c:pt>
                <c:pt idx="121">
                  <c:v>57731</c:v>
                </c:pt>
                <c:pt idx="122">
                  <c:v>65504</c:v>
                </c:pt>
                <c:pt idx="123">
                  <c:v>91032</c:v>
                </c:pt>
                <c:pt idx="124">
                  <c:v>92134</c:v>
                </c:pt>
                <c:pt idx="125">
                  <c:v>132162</c:v>
                </c:pt>
                <c:pt idx="126">
                  <c:v>108423</c:v>
                </c:pt>
                <c:pt idx="127">
                  <c:v>4589</c:v>
                </c:pt>
                <c:pt idx="128">
                  <c:v>107906</c:v>
                </c:pt>
                <c:pt idx="129">
                  <c:v>58533</c:v>
                </c:pt>
                <c:pt idx="130">
                  <c:v>96900</c:v>
                </c:pt>
                <c:pt idx="131">
                  <c:v>89626</c:v>
                </c:pt>
                <c:pt idx="132">
                  <c:v>71655</c:v>
                </c:pt>
                <c:pt idx="133">
                  <c:v>122300</c:v>
                </c:pt>
                <c:pt idx="134">
                  <c:v>36513</c:v>
                </c:pt>
                <c:pt idx="135">
                  <c:v>69676</c:v>
                </c:pt>
                <c:pt idx="136">
                  <c:v>98791</c:v>
                </c:pt>
                <c:pt idx="137">
                  <c:v>138492</c:v>
                </c:pt>
                <c:pt idx="138">
                  <c:v>100341</c:v>
                </c:pt>
                <c:pt idx="139">
                  <c:v>146906</c:v>
                </c:pt>
                <c:pt idx="140">
                  <c:v>60749</c:v>
                </c:pt>
                <c:pt idx="141">
                  <c:v>137281</c:v>
                </c:pt>
                <c:pt idx="142">
                  <c:v>103864</c:v>
                </c:pt>
                <c:pt idx="143">
                  <c:v>64666</c:v>
                </c:pt>
                <c:pt idx="144">
                  <c:v>87443</c:v>
                </c:pt>
                <c:pt idx="145">
                  <c:v>82742</c:v>
                </c:pt>
                <c:pt idx="146">
                  <c:v>132128</c:v>
                </c:pt>
                <c:pt idx="147">
                  <c:v>81507</c:v>
                </c:pt>
                <c:pt idx="148">
                  <c:v>94285</c:v>
                </c:pt>
                <c:pt idx="149">
                  <c:v>67923</c:v>
                </c:pt>
                <c:pt idx="150">
                  <c:v>103072</c:v>
                </c:pt>
                <c:pt idx="151">
                  <c:v>90719</c:v>
                </c:pt>
                <c:pt idx="152">
                  <c:v>96351</c:v>
                </c:pt>
                <c:pt idx="153">
                  <c:v>80107</c:v>
                </c:pt>
                <c:pt idx="154">
                  <c:v>107515</c:v>
                </c:pt>
                <c:pt idx="155">
                  <c:v>83477</c:v>
                </c:pt>
                <c:pt idx="156">
                  <c:v>115224</c:v>
                </c:pt>
                <c:pt idx="157">
                  <c:v>70198</c:v>
                </c:pt>
                <c:pt idx="158">
                  <c:v>131465</c:v>
                </c:pt>
                <c:pt idx="159">
                  <c:v>91453</c:v>
                </c:pt>
                <c:pt idx="160">
                  <c:v>91746</c:v>
                </c:pt>
                <c:pt idx="161">
                  <c:v>177933</c:v>
                </c:pt>
                <c:pt idx="162">
                  <c:v>99056</c:v>
                </c:pt>
                <c:pt idx="163">
                  <c:v>65326</c:v>
                </c:pt>
                <c:pt idx="164">
                  <c:v>44443</c:v>
                </c:pt>
                <c:pt idx="165">
                  <c:v>115975</c:v>
                </c:pt>
                <c:pt idx="166">
                  <c:v>112162</c:v>
                </c:pt>
                <c:pt idx="167">
                  <c:v>6157</c:v>
                </c:pt>
                <c:pt idx="168">
                  <c:v>101797</c:v>
                </c:pt>
                <c:pt idx="169">
                  <c:v>129024</c:v>
                </c:pt>
                <c:pt idx="170">
                  <c:v>76556</c:v>
                </c:pt>
                <c:pt idx="171">
                  <c:v>91239</c:v>
                </c:pt>
                <c:pt idx="172">
                  <c:v>177283</c:v>
                </c:pt>
                <c:pt idx="173">
                  <c:v>103601</c:v>
                </c:pt>
                <c:pt idx="174">
                  <c:v>109476</c:v>
                </c:pt>
                <c:pt idx="175">
                  <c:v>69572</c:v>
                </c:pt>
                <c:pt idx="176">
                  <c:v>135253</c:v>
                </c:pt>
                <c:pt idx="177">
                  <c:v>102831</c:v>
                </c:pt>
                <c:pt idx="178">
                  <c:v>125741</c:v>
                </c:pt>
                <c:pt idx="179">
                  <c:v>131619</c:v>
                </c:pt>
                <c:pt idx="180">
                  <c:v>91214</c:v>
                </c:pt>
                <c:pt idx="181">
                  <c:v>127123</c:v>
                </c:pt>
                <c:pt idx="182">
                  <c:v>14858</c:v>
                </c:pt>
                <c:pt idx="183">
                  <c:v>32666</c:v>
                </c:pt>
                <c:pt idx="184">
                  <c:v>132744</c:v>
                </c:pt>
                <c:pt idx="185">
                  <c:v>13798</c:v>
                </c:pt>
                <c:pt idx="186">
                  <c:v>135870</c:v>
                </c:pt>
                <c:pt idx="187">
                  <c:v>96369</c:v>
                </c:pt>
                <c:pt idx="188">
                  <c:v>103737</c:v>
                </c:pt>
                <c:pt idx="189">
                  <c:v>145041</c:v>
                </c:pt>
                <c:pt idx="190">
                  <c:v>133882</c:v>
                </c:pt>
                <c:pt idx="191">
                  <c:v>91446</c:v>
                </c:pt>
                <c:pt idx="192">
                  <c:v>139700</c:v>
                </c:pt>
                <c:pt idx="193">
                  <c:v>97136</c:v>
                </c:pt>
                <c:pt idx="194">
                  <c:v>146167</c:v>
                </c:pt>
                <c:pt idx="195">
                  <c:v>61970</c:v>
                </c:pt>
                <c:pt idx="196">
                  <c:v>86392</c:v>
                </c:pt>
                <c:pt idx="197">
                  <c:v>35284</c:v>
                </c:pt>
                <c:pt idx="198">
                  <c:v>75695</c:v>
                </c:pt>
                <c:pt idx="199">
                  <c:v>163627</c:v>
                </c:pt>
                <c:pt idx="200">
                  <c:v>115945</c:v>
                </c:pt>
                <c:pt idx="201">
                  <c:v>98346</c:v>
                </c:pt>
                <c:pt idx="202">
                  <c:v>153428</c:v>
                </c:pt>
                <c:pt idx="203">
                  <c:v>123283</c:v>
                </c:pt>
                <c:pt idx="204">
                  <c:v>105908</c:v>
                </c:pt>
                <c:pt idx="205">
                  <c:v>127952</c:v>
                </c:pt>
                <c:pt idx="206">
                  <c:v>94792</c:v>
                </c:pt>
                <c:pt idx="207">
                  <c:v>127056</c:v>
                </c:pt>
                <c:pt idx="208">
                  <c:v>119312</c:v>
                </c:pt>
                <c:pt idx="209">
                  <c:v>44803</c:v>
                </c:pt>
                <c:pt idx="210">
                  <c:v>64464</c:v>
                </c:pt>
                <c:pt idx="211">
                  <c:v>66048</c:v>
                </c:pt>
                <c:pt idx="212">
                  <c:v>133820</c:v>
                </c:pt>
                <c:pt idx="213">
                  <c:v>58251</c:v>
                </c:pt>
                <c:pt idx="214">
                  <c:v>144339</c:v>
                </c:pt>
                <c:pt idx="215">
                  <c:v>76676</c:v>
                </c:pt>
                <c:pt idx="216">
                  <c:v>89056</c:v>
                </c:pt>
                <c:pt idx="217">
                  <c:v>167592</c:v>
                </c:pt>
                <c:pt idx="218">
                  <c:v>131414</c:v>
                </c:pt>
                <c:pt idx="219">
                  <c:v>7029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657D-4092-BF8C-18C4FBEF342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40378656"/>
        <c:axId val="740378984"/>
      </c:scatterChart>
      <c:valAx>
        <c:axId val="740378656"/>
        <c:scaling>
          <c:orientation val="minMax"/>
          <c:max val="3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AU"/>
                  <a:t>Fresh Biomass (g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740378984"/>
        <c:crosses val="autoZero"/>
        <c:crossBetween val="midCat"/>
      </c:valAx>
      <c:valAx>
        <c:axId val="740378984"/>
        <c:scaling>
          <c:orientation val="minMax"/>
          <c:max val="5000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AU"/>
                  <a:t>Estimated Shoot Biomass (000 Pixels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740378656"/>
        <c:crosses val="autoZero"/>
        <c:crossBetween val="midCat"/>
        <c:majorUnit val="100000"/>
        <c:dispUnits>
          <c:builtInUnit val="thousands"/>
        </c:dispUnits>
      </c:valAx>
      <c:spPr>
        <a:noFill/>
        <a:ln w="25400">
          <a:noFill/>
        </a:ln>
        <a:effectLst/>
      </c:spPr>
    </c:plotArea>
    <c:legend>
      <c:legendPos val="r"/>
      <c:legendEntry>
        <c:idx val="0"/>
        <c:delete val="1"/>
      </c:legendEntry>
      <c:legendEntry>
        <c:idx val="3"/>
        <c:delete val="1"/>
      </c:legendEntry>
      <c:layout>
        <c:manualLayout>
          <c:xMode val="edge"/>
          <c:yMode val="edge"/>
          <c:x val="0.21375027255053361"/>
          <c:y val="7.0067804024496971E-2"/>
          <c:w val="0.20693410495024114"/>
          <c:h val="0.1469014289880431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v>all</c:v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trendline>
            <c:spPr>
              <a:ln w="1270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1"/>
            <c:dispEq val="0"/>
            <c:trendlineLbl>
              <c:layout>
                <c:manualLayout>
                  <c:x val="0.12623471104730216"/>
                  <c:y val="0.59259259259259256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1" i="0" u="none" strike="noStrike" kern="120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/>
                </a:p>
              </c:txPr>
            </c:trendlineLbl>
          </c:trendline>
          <c:xVal>
            <c:numRef>
              <c:f>(Sheet3!$E$2:$E$221,Sheet3!$H$2:$H$221)</c:f>
              <c:numCache>
                <c:formatCode>General</c:formatCode>
                <c:ptCount val="440"/>
                <c:pt idx="0">
                  <c:v>0.46600000000000003</c:v>
                </c:pt>
                <c:pt idx="1">
                  <c:v>0.54200000000000004</c:v>
                </c:pt>
                <c:pt idx="2">
                  <c:v>0.36199999999999999</c:v>
                </c:pt>
                <c:pt idx="3">
                  <c:v>0.40600000000000003</c:v>
                </c:pt>
                <c:pt idx="4">
                  <c:v>2.5790000000000002</c:v>
                </c:pt>
                <c:pt idx="5">
                  <c:v>0.222</c:v>
                </c:pt>
                <c:pt idx="6">
                  <c:v>0.13400000000000001</c:v>
                </c:pt>
                <c:pt idx="7">
                  <c:v>0.52100000000000002</c:v>
                </c:pt>
                <c:pt idx="8">
                  <c:v>0.55700000000000005</c:v>
                </c:pt>
                <c:pt idx="9">
                  <c:v>0.44800000000000001</c:v>
                </c:pt>
                <c:pt idx="10">
                  <c:v>2.512</c:v>
                </c:pt>
                <c:pt idx="11">
                  <c:v>0.27100000000000002</c:v>
                </c:pt>
                <c:pt idx="12">
                  <c:v>0.53500000000000003</c:v>
                </c:pt>
                <c:pt idx="13">
                  <c:v>0.17899999999999999</c:v>
                </c:pt>
                <c:pt idx="14">
                  <c:v>0.47599999999999998</c:v>
                </c:pt>
                <c:pt idx="15">
                  <c:v>0.745</c:v>
                </c:pt>
                <c:pt idx="16">
                  <c:v>0.64600000000000002</c:v>
                </c:pt>
                <c:pt idx="17">
                  <c:v>0.97299999999999998</c:v>
                </c:pt>
                <c:pt idx="18">
                  <c:v>0.25</c:v>
                </c:pt>
                <c:pt idx="19">
                  <c:v>0.45500000000000002</c:v>
                </c:pt>
                <c:pt idx="20">
                  <c:v>0.48299999999999998</c:v>
                </c:pt>
                <c:pt idx="21">
                  <c:v>0.158</c:v>
                </c:pt>
                <c:pt idx="22">
                  <c:v>0.52</c:v>
                </c:pt>
                <c:pt idx="23">
                  <c:v>0.188</c:v>
                </c:pt>
                <c:pt idx="24">
                  <c:v>0.315</c:v>
                </c:pt>
                <c:pt idx="25">
                  <c:v>1.958</c:v>
                </c:pt>
                <c:pt idx="26">
                  <c:v>0.51800000000000002</c:v>
                </c:pt>
                <c:pt idx="27">
                  <c:v>0.38900000000000001</c:v>
                </c:pt>
                <c:pt idx="28">
                  <c:v>0.97599999999999998</c:v>
                </c:pt>
                <c:pt idx="29">
                  <c:v>0.5</c:v>
                </c:pt>
                <c:pt idx="30">
                  <c:v>0.52600000000000002</c:v>
                </c:pt>
                <c:pt idx="31">
                  <c:v>2.1030000000000002</c:v>
                </c:pt>
                <c:pt idx="32">
                  <c:v>0.57699999999999996</c:v>
                </c:pt>
                <c:pt idx="33">
                  <c:v>0.30299999999999999</c:v>
                </c:pt>
                <c:pt idx="34">
                  <c:v>0.23</c:v>
                </c:pt>
                <c:pt idx="35">
                  <c:v>0.748</c:v>
                </c:pt>
                <c:pt idx="36">
                  <c:v>0.53800000000000003</c:v>
                </c:pt>
                <c:pt idx="37">
                  <c:v>0.34899999999999998</c:v>
                </c:pt>
                <c:pt idx="38">
                  <c:v>0.49099999999999999</c:v>
                </c:pt>
                <c:pt idx="39">
                  <c:v>0.8</c:v>
                </c:pt>
                <c:pt idx="40">
                  <c:v>0.39300000000000002</c:v>
                </c:pt>
                <c:pt idx="41">
                  <c:v>0.3</c:v>
                </c:pt>
                <c:pt idx="42">
                  <c:v>0.28799999999999998</c:v>
                </c:pt>
                <c:pt idx="43">
                  <c:v>2.0369999999999999</c:v>
                </c:pt>
                <c:pt idx="44">
                  <c:v>0.747</c:v>
                </c:pt>
                <c:pt idx="45">
                  <c:v>0.32</c:v>
                </c:pt>
                <c:pt idx="46">
                  <c:v>0.91800000000000004</c:v>
                </c:pt>
                <c:pt idx="47">
                  <c:v>0.497</c:v>
                </c:pt>
                <c:pt idx="48">
                  <c:v>0.78700000000000003</c:v>
                </c:pt>
                <c:pt idx="49">
                  <c:v>0.64600000000000002</c:v>
                </c:pt>
                <c:pt idx="50">
                  <c:v>0.53300000000000003</c:v>
                </c:pt>
                <c:pt idx="51">
                  <c:v>0.69299999999999995</c:v>
                </c:pt>
                <c:pt idx="52">
                  <c:v>0.33800000000000002</c:v>
                </c:pt>
                <c:pt idx="53">
                  <c:v>0.35199999999999998</c:v>
                </c:pt>
                <c:pt idx="54">
                  <c:v>0.54500000000000004</c:v>
                </c:pt>
                <c:pt idx="55">
                  <c:v>0.64700000000000002</c:v>
                </c:pt>
                <c:pt idx="56">
                  <c:v>0.316</c:v>
                </c:pt>
                <c:pt idx="57">
                  <c:v>7.8E-2</c:v>
                </c:pt>
                <c:pt idx="58">
                  <c:v>0.29199999999999998</c:v>
                </c:pt>
                <c:pt idx="59">
                  <c:v>0.3</c:v>
                </c:pt>
                <c:pt idx="60">
                  <c:v>0.58499999999999996</c:v>
                </c:pt>
                <c:pt idx="61">
                  <c:v>0.50700000000000001</c:v>
                </c:pt>
                <c:pt idx="62">
                  <c:v>0.77900000000000003</c:v>
                </c:pt>
                <c:pt idx="63">
                  <c:v>0.3</c:v>
                </c:pt>
                <c:pt idx="64">
                  <c:v>0.68600000000000005</c:v>
                </c:pt>
                <c:pt idx="65">
                  <c:v>0.505</c:v>
                </c:pt>
                <c:pt idx="66">
                  <c:v>0.38500000000000001</c:v>
                </c:pt>
                <c:pt idx="67">
                  <c:v>0.30599999999999999</c:v>
                </c:pt>
                <c:pt idx="68">
                  <c:v>0.39400000000000002</c:v>
                </c:pt>
                <c:pt idx="69">
                  <c:v>0.377</c:v>
                </c:pt>
                <c:pt idx="70">
                  <c:v>0.47</c:v>
                </c:pt>
                <c:pt idx="71">
                  <c:v>1.6559999999999999</c:v>
                </c:pt>
                <c:pt idx="72">
                  <c:v>0.55000000000000004</c:v>
                </c:pt>
                <c:pt idx="73">
                  <c:v>0.55000000000000004</c:v>
                </c:pt>
                <c:pt idx="74">
                  <c:v>0.67200000000000004</c:v>
                </c:pt>
                <c:pt idx="75">
                  <c:v>0.504</c:v>
                </c:pt>
                <c:pt idx="76">
                  <c:v>0.45500000000000002</c:v>
                </c:pt>
                <c:pt idx="77">
                  <c:v>0.69299999999999995</c:v>
                </c:pt>
                <c:pt idx="78">
                  <c:v>0.246</c:v>
                </c:pt>
                <c:pt idx="79">
                  <c:v>0.46200000000000002</c:v>
                </c:pt>
                <c:pt idx="80">
                  <c:v>0.67</c:v>
                </c:pt>
                <c:pt idx="81">
                  <c:v>0.94799999999999995</c:v>
                </c:pt>
                <c:pt idx="82">
                  <c:v>0.58099999999999996</c:v>
                </c:pt>
                <c:pt idx="83">
                  <c:v>0.505</c:v>
                </c:pt>
                <c:pt idx="84">
                  <c:v>0.41499999999999998</c:v>
                </c:pt>
                <c:pt idx="85">
                  <c:v>0.39400000000000002</c:v>
                </c:pt>
                <c:pt idx="86">
                  <c:v>0.27200000000000002</c:v>
                </c:pt>
                <c:pt idx="87">
                  <c:v>0.56000000000000005</c:v>
                </c:pt>
                <c:pt idx="88">
                  <c:v>0.59799999999999998</c:v>
                </c:pt>
                <c:pt idx="89">
                  <c:v>0.505</c:v>
                </c:pt>
                <c:pt idx="90">
                  <c:v>0.42799999999999999</c:v>
                </c:pt>
                <c:pt idx="91">
                  <c:v>0.45300000000000001</c:v>
                </c:pt>
                <c:pt idx="92">
                  <c:v>0.66400000000000003</c:v>
                </c:pt>
                <c:pt idx="93">
                  <c:v>1.9550000000000001</c:v>
                </c:pt>
                <c:pt idx="94">
                  <c:v>0.41299999999999998</c:v>
                </c:pt>
                <c:pt idx="95">
                  <c:v>0.65900000000000003</c:v>
                </c:pt>
                <c:pt idx="96">
                  <c:v>0.183</c:v>
                </c:pt>
                <c:pt idx="97">
                  <c:v>0.61899999999999999</c:v>
                </c:pt>
                <c:pt idx="98">
                  <c:v>0.81599999999999995</c:v>
                </c:pt>
                <c:pt idx="99">
                  <c:v>0.94299999999999995</c:v>
                </c:pt>
                <c:pt idx="100">
                  <c:v>0.67800000000000005</c:v>
                </c:pt>
                <c:pt idx="101">
                  <c:v>0.13900000000000001</c:v>
                </c:pt>
                <c:pt idx="102">
                  <c:v>0.58199999999999996</c:v>
                </c:pt>
                <c:pt idx="103">
                  <c:v>0.61399999999999999</c:v>
                </c:pt>
                <c:pt idx="104">
                  <c:v>2.3279999999999998</c:v>
                </c:pt>
                <c:pt idx="105">
                  <c:v>0.39700000000000002</c:v>
                </c:pt>
                <c:pt idx="106">
                  <c:v>0.254</c:v>
                </c:pt>
                <c:pt idx="107">
                  <c:v>0.33500000000000002</c:v>
                </c:pt>
                <c:pt idx="108">
                  <c:v>0.65200000000000002</c:v>
                </c:pt>
                <c:pt idx="109">
                  <c:v>0.36799999999999999</c:v>
                </c:pt>
                <c:pt idx="110">
                  <c:v>0.26600000000000001</c:v>
                </c:pt>
                <c:pt idx="111">
                  <c:v>0.153</c:v>
                </c:pt>
                <c:pt idx="112">
                  <c:v>0.34</c:v>
                </c:pt>
                <c:pt idx="113">
                  <c:v>0.32400000000000001</c:v>
                </c:pt>
                <c:pt idx="114">
                  <c:v>0.57899999999999996</c:v>
                </c:pt>
                <c:pt idx="115">
                  <c:v>0.39500000000000002</c:v>
                </c:pt>
                <c:pt idx="116">
                  <c:v>0.49</c:v>
                </c:pt>
                <c:pt idx="117">
                  <c:v>0.73799999999999999</c:v>
                </c:pt>
                <c:pt idx="118">
                  <c:v>0.28199999999999997</c:v>
                </c:pt>
                <c:pt idx="119">
                  <c:v>0.33300000000000002</c:v>
                </c:pt>
                <c:pt idx="120">
                  <c:v>0.65300000000000002</c:v>
                </c:pt>
                <c:pt idx="121">
                  <c:v>0.69299999999999995</c:v>
                </c:pt>
                <c:pt idx="122">
                  <c:v>0.28100000000000003</c:v>
                </c:pt>
                <c:pt idx="123">
                  <c:v>0.78300000000000003</c:v>
                </c:pt>
                <c:pt idx="124">
                  <c:v>0.33500000000000002</c:v>
                </c:pt>
                <c:pt idx="125">
                  <c:v>0.19900000000000001</c:v>
                </c:pt>
                <c:pt idx="126">
                  <c:v>0.315</c:v>
                </c:pt>
                <c:pt idx="127">
                  <c:v>0.58899999999999997</c:v>
                </c:pt>
                <c:pt idx="128">
                  <c:v>0.21</c:v>
                </c:pt>
                <c:pt idx="129">
                  <c:v>0.63700000000000001</c:v>
                </c:pt>
                <c:pt idx="130">
                  <c:v>0.14699999999999999</c:v>
                </c:pt>
                <c:pt idx="131">
                  <c:v>0.45100000000000001</c:v>
                </c:pt>
                <c:pt idx="132">
                  <c:v>0.33600000000000002</c:v>
                </c:pt>
                <c:pt idx="133">
                  <c:v>7.8E-2</c:v>
                </c:pt>
                <c:pt idx="134">
                  <c:v>0.28000000000000003</c:v>
                </c:pt>
                <c:pt idx="135">
                  <c:v>0.621</c:v>
                </c:pt>
                <c:pt idx="136">
                  <c:v>0.59099999999999997</c:v>
                </c:pt>
                <c:pt idx="137">
                  <c:v>0.753</c:v>
                </c:pt>
                <c:pt idx="138">
                  <c:v>0.41599999999999998</c:v>
                </c:pt>
                <c:pt idx="139">
                  <c:v>0.66900000000000004</c:v>
                </c:pt>
                <c:pt idx="140">
                  <c:v>0.34300000000000003</c:v>
                </c:pt>
                <c:pt idx="141">
                  <c:v>0.79200000000000004</c:v>
                </c:pt>
                <c:pt idx="142">
                  <c:v>0.38300000000000001</c:v>
                </c:pt>
                <c:pt idx="143">
                  <c:v>0.435</c:v>
                </c:pt>
                <c:pt idx="144">
                  <c:v>0.40100000000000002</c:v>
                </c:pt>
                <c:pt idx="145">
                  <c:v>0.434</c:v>
                </c:pt>
                <c:pt idx="146">
                  <c:v>0.21299999999999999</c:v>
                </c:pt>
                <c:pt idx="147">
                  <c:v>6.7000000000000004E-2</c:v>
                </c:pt>
                <c:pt idx="148">
                  <c:v>0.66</c:v>
                </c:pt>
                <c:pt idx="149">
                  <c:v>0.36299999999999999</c:v>
                </c:pt>
                <c:pt idx="150">
                  <c:v>0.24099999999999999</c:v>
                </c:pt>
                <c:pt idx="151">
                  <c:v>0.35</c:v>
                </c:pt>
                <c:pt idx="152">
                  <c:v>0.38900000000000001</c:v>
                </c:pt>
                <c:pt idx="153">
                  <c:v>0.36599999999999999</c:v>
                </c:pt>
                <c:pt idx="154">
                  <c:v>0.51600000000000001</c:v>
                </c:pt>
                <c:pt idx="155">
                  <c:v>0.32500000000000001</c:v>
                </c:pt>
                <c:pt idx="156">
                  <c:v>0.47299999999999998</c:v>
                </c:pt>
                <c:pt idx="157">
                  <c:v>0.372</c:v>
                </c:pt>
                <c:pt idx="158">
                  <c:v>0.40200000000000002</c:v>
                </c:pt>
                <c:pt idx="159">
                  <c:v>0.214</c:v>
                </c:pt>
                <c:pt idx="160">
                  <c:v>0.31</c:v>
                </c:pt>
                <c:pt idx="161">
                  <c:v>0.45800000000000002</c:v>
                </c:pt>
                <c:pt idx="162">
                  <c:v>0.20899999999999999</c:v>
                </c:pt>
                <c:pt idx="163">
                  <c:v>0.749</c:v>
                </c:pt>
                <c:pt idx="164">
                  <c:v>0.33</c:v>
                </c:pt>
                <c:pt idx="165">
                  <c:v>0.28899999999999998</c:v>
                </c:pt>
                <c:pt idx="166">
                  <c:v>0.23400000000000001</c:v>
                </c:pt>
                <c:pt idx="167">
                  <c:v>0.33900000000000002</c:v>
                </c:pt>
                <c:pt idx="168">
                  <c:v>0.46100000000000002</c:v>
                </c:pt>
                <c:pt idx="169">
                  <c:v>0.53300000000000003</c:v>
                </c:pt>
                <c:pt idx="170">
                  <c:v>0.20899999999999999</c:v>
                </c:pt>
                <c:pt idx="171">
                  <c:v>0.55700000000000005</c:v>
                </c:pt>
                <c:pt idx="172">
                  <c:v>0.15</c:v>
                </c:pt>
                <c:pt idx="173">
                  <c:v>0.23200000000000001</c:v>
                </c:pt>
                <c:pt idx="174">
                  <c:v>0.504</c:v>
                </c:pt>
                <c:pt idx="175">
                  <c:v>0.2</c:v>
                </c:pt>
                <c:pt idx="176">
                  <c:v>0.23</c:v>
                </c:pt>
                <c:pt idx="177">
                  <c:v>0.308</c:v>
                </c:pt>
                <c:pt idx="178">
                  <c:v>0.114</c:v>
                </c:pt>
                <c:pt idx="179">
                  <c:v>0.28499999999999998</c:v>
                </c:pt>
                <c:pt idx="180">
                  <c:v>0.38</c:v>
                </c:pt>
                <c:pt idx="181">
                  <c:v>0.187</c:v>
                </c:pt>
                <c:pt idx="182">
                  <c:v>0.29199999999999998</c:v>
                </c:pt>
                <c:pt idx="183">
                  <c:v>0.217</c:v>
                </c:pt>
                <c:pt idx="184">
                  <c:v>0.77600000000000002</c:v>
                </c:pt>
                <c:pt idx="185">
                  <c:v>0.25800000000000001</c:v>
                </c:pt>
                <c:pt idx="186">
                  <c:v>0.14000000000000001</c:v>
                </c:pt>
                <c:pt idx="187">
                  <c:v>0.27800000000000002</c:v>
                </c:pt>
                <c:pt idx="188">
                  <c:v>0.21</c:v>
                </c:pt>
                <c:pt idx="189">
                  <c:v>0.39500000000000002</c:v>
                </c:pt>
                <c:pt idx="190">
                  <c:v>0.246</c:v>
                </c:pt>
                <c:pt idx="191">
                  <c:v>0.39300000000000002</c:v>
                </c:pt>
                <c:pt idx="192">
                  <c:v>0.26800000000000002</c:v>
                </c:pt>
                <c:pt idx="193">
                  <c:v>0.28599999999999998</c:v>
                </c:pt>
                <c:pt idx="194">
                  <c:v>0.371</c:v>
                </c:pt>
                <c:pt idx="195">
                  <c:v>0.27900000000000003</c:v>
                </c:pt>
                <c:pt idx="196">
                  <c:v>0.32700000000000001</c:v>
                </c:pt>
                <c:pt idx="197">
                  <c:v>0.55200000000000005</c:v>
                </c:pt>
                <c:pt idx="198">
                  <c:v>0.30099999999999999</c:v>
                </c:pt>
                <c:pt idx="199">
                  <c:v>0.29799999999999999</c:v>
                </c:pt>
                <c:pt idx="200">
                  <c:v>0.27100000000000002</c:v>
                </c:pt>
                <c:pt idx="201">
                  <c:v>0.22</c:v>
                </c:pt>
                <c:pt idx="202">
                  <c:v>0.38200000000000001</c:v>
                </c:pt>
                <c:pt idx="203">
                  <c:v>0.25600000000000001</c:v>
                </c:pt>
                <c:pt idx="204">
                  <c:v>0.32600000000000001</c:v>
                </c:pt>
                <c:pt idx="205">
                  <c:v>0.36699999999999999</c:v>
                </c:pt>
                <c:pt idx="206">
                  <c:v>0.39800000000000002</c:v>
                </c:pt>
                <c:pt idx="207">
                  <c:v>0.223</c:v>
                </c:pt>
                <c:pt idx="208">
                  <c:v>0.39700000000000002</c:v>
                </c:pt>
                <c:pt idx="209">
                  <c:v>9.9000000000000005E-2</c:v>
                </c:pt>
                <c:pt idx="210">
                  <c:v>0.379</c:v>
                </c:pt>
                <c:pt idx="211">
                  <c:v>0.26400000000000001</c:v>
                </c:pt>
                <c:pt idx="212">
                  <c:v>0.216</c:v>
                </c:pt>
                <c:pt idx="213">
                  <c:v>0.16</c:v>
                </c:pt>
                <c:pt idx="214">
                  <c:v>0.114</c:v>
                </c:pt>
                <c:pt idx="215">
                  <c:v>0.14299999999999999</c:v>
                </c:pt>
                <c:pt idx="216">
                  <c:v>0.19700000000000001</c:v>
                </c:pt>
                <c:pt idx="217">
                  <c:v>5.3999999999999999E-2</c:v>
                </c:pt>
                <c:pt idx="218">
                  <c:v>0.115</c:v>
                </c:pt>
                <c:pt idx="219">
                  <c:v>0.371</c:v>
                </c:pt>
                <c:pt idx="220">
                  <c:v>0.08</c:v>
                </c:pt>
                <c:pt idx="221">
                  <c:v>0.10100000000000001</c:v>
                </c:pt>
                <c:pt idx="222">
                  <c:v>0.27</c:v>
                </c:pt>
                <c:pt idx="223">
                  <c:v>4.8000000000000001E-2</c:v>
                </c:pt>
                <c:pt idx="224">
                  <c:v>0.14199999999999999</c:v>
                </c:pt>
                <c:pt idx="225">
                  <c:v>6.2E-2</c:v>
                </c:pt>
                <c:pt idx="226">
                  <c:v>0.14399999999999999</c:v>
                </c:pt>
                <c:pt idx="227">
                  <c:v>3.9E-2</c:v>
                </c:pt>
                <c:pt idx="228">
                  <c:v>6.2E-2</c:v>
                </c:pt>
                <c:pt idx="229">
                  <c:v>8.5000000000000006E-2</c:v>
                </c:pt>
                <c:pt idx="230">
                  <c:v>0.18099999999999999</c:v>
                </c:pt>
                <c:pt idx="231">
                  <c:v>9.0999999999999998E-2</c:v>
                </c:pt>
                <c:pt idx="232">
                  <c:v>7.4999999999999997E-2</c:v>
                </c:pt>
                <c:pt idx="233">
                  <c:v>3.4000000000000002E-2</c:v>
                </c:pt>
                <c:pt idx="234">
                  <c:v>4.1000000000000002E-2</c:v>
                </c:pt>
                <c:pt idx="235">
                  <c:v>8.5999999999999993E-2</c:v>
                </c:pt>
                <c:pt idx="236">
                  <c:v>0.21199999999999999</c:v>
                </c:pt>
                <c:pt idx="237">
                  <c:v>0.13900000000000001</c:v>
                </c:pt>
                <c:pt idx="238">
                  <c:v>3.4000000000000002E-2</c:v>
                </c:pt>
                <c:pt idx="239">
                  <c:v>0.121</c:v>
                </c:pt>
                <c:pt idx="240">
                  <c:v>0.10100000000000001</c:v>
                </c:pt>
                <c:pt idx="241">
                  <c:v>0.216</c:v>
                </c:pt>
                <c:pt idx="242">
                  <c:v>9.7000000000000003E-2</c:v>
                </c:pt>
                <c:pt idx="243">
                  <c:v>0.23599999999999999</c:v>
                </c:pt>
                <c:pt idx="244">
                  <c:v>6.7000000000000004E-2</c:v>
                </c:pt>
                <c:pt idx="245">
                  <c:v>0.28199999999999997</c:v>
                </c:pt>
                <c:pt idx="246">
                  <c:v>0.1</c:v>
                </c:pt>
                <c:pt idx="247">
                  <c:v>7.3999999999999996E-2</c:v>
                </c:pt>
                <c:pt idx="248">
                  <c:v>0.17699999999999999</c:v>
                </c:pt>
                <c:pt idx="249">
                  <c:v>9.8000000000000004E-2</c:v>
                </c:pt>
                <c:pt idx="250">
                  <c:v>0.124</c:v>
                </c:pt>
                <c:pt idx="251">
                  <c:v>0.46400000000000002</c:v>
                </c:pt>
                <c:pt idx="252">
                  <c:v>0.28399999999999997</c:v>
                </c:pt>
                <c:pt idx="253">
                  <c:v>0.122</c:v>
                </c:pt>
                <c:pt idx="254">
                  <c:v>6.3E-2</c:v>
                </c:pt>
                <c:pt idx="255">
                  <c:v>0.14599999999999999</c:v>
                </c:pt>
                <c:pt idx="256">
                  <c:v>0.34399999999999997</c:v>
                </c:pt>
                <c:pt idx="257">
                  <c:v>0.127</c:v>
                </c:pt>
                <c:pt idx="258">
                  <c:v>0.182</c:v>
                </c:pt>
                <c:pt idx="259">
                  <c:v>0.315</c:v>
                </c:pt>
                <c:pt idx="260">
                  <c:v>0.14899999999999999</c:v>
                </c:pt>
                <c:pt idx="261">
                  <c:v>0.11</c:v>
                </c:pt>
                <c:pt idx="262">
                  <c:v>0.109</c:v>
                </c:pt>
                <c:pt idx="263">
                  <c:v>0.48099999999999998</c:v>
                </c:pt>
                <c:pt idx="264">
                  <c:v>0.24099999999999999</c:v>
                </c:pt>
                <c:pt idx="265">
                  <c:v>0.17699999999999999</c:v>
                </c:pt>
                <c:pt idx="266">
                  <c:v>0.222</c:v>
                </c:pt>
                <c:pt idx="267">
                  <c:v>0.25900000000000001</c:v>
                </c:pt>
                <c:pt idx="268">
                  <c:v>0.23300000000000001</c:v>
                </c:pt>
                <c:pt idx="269">
                  <c:v>0.16300000000000001</c:v>
                </c:pt>
                <c:pt idx="270">
                  <c:v>0.19</c:v>
                </c:pt>
                <c:pt idx="271">
                  <c:v>0.104</c:v>
                </c:pt>
                <c:pt idx="272">
                  <c:v>0.1</c:v>
                </c:pt>
                <c:pt idx="273">
                  <c:v>0.112</c:v>
                </c:pt>
                <c:pt idx="274">
                  <c:v>0.151</c:v>
                </c:pt>
                <c:pt idx="275">
                  <c:v>0.29699999999999999</c:v>
                </c:pt>
                <c:pt idx="276">
                  <c:v>0.13</c:v>
                </c:pt>
                <c:pt idx="277">
                  <c:v>0.19500000000000001</c:v>
                </c:pt>
                <c:pt idx="278">
                  <c:v>0.11799999999999999</c:v>
                </c:pt>
                <c:pt idx="279">
                  <c:v>6.9000000000000006E-2</c:v>
                </c:pt>
                <c:pt idx="280">
                  <c:v>0.22900000000000001</c:v>
                </c:pt>
                <c:pt idx="281">
                  <c:v>0.16800000000000001</c:v>
                </c:pt>
                <c:pt idx="282">
                  <c:v>0.35499999999999998</c:v>
                </c:pt>
                <c:pt idx="283">
                  <c:v>0.09</c:v>
                </c:pt>
                <c:pt idx="284">
                  <c:v>0.308</c:v>
                </c:pt>
                <c:pt idx="285">
                  <c:v>0.215</c:v>
                </c:pt>
                <c:pt idx="286">
                  <c:v>0.18</c:v>
                </c:pt>
                <c:pt idx="287">
                  <c:v>0.10299999999999999</c:v>
                </c:pt>
                <c:pt idx="288">
                  <c:v>8.6999999999999994E-2</c:v>
                </c:pt>
                <c:pt idx="289">
                  <c:v>0.14099999999999999</c:v>
                </c:pt>
                <c:pt idx="290">
                  <c:v>0.36699999999999999</c:v>
                </c:pt>
                <c:pt idx="291">
                  <c:v>0.79300000000000004</c:v>
                </c:pt>
                <c:pt idx="292">
                  <c:v>0.28699999999999998</c:v>
                </c:pt>
                <c:pt idx="293">
                  <c:v>0.27500000000000002</c:v>
                </c:pt>
                <c:pt idx="294">
                  <c:v>0.50700000000000001</c:v>
                </c:pt>
                <c:pt idx="295">
                  <c:v>0.14199999999999999</c:v>
                </c:pt>
                <c:pt idx="296">
                  <c:v>0.26500000000000001</c:v>
                </c:pt>
                <c:pt idx="297">
                  <c:v>0.438</c:v>
                </c:pt>
                <c:pt idx="298">
                  <c:v>0.52100000000000002</c:v>
                </c:pt>
                <c:pt idx="299">
                  <c:v>0.315</c:v>
                </c:pt>
                <c:pt idx="300">
                  <c:v>0.247</c:v>
                </c:pt>
                <c:pt idx="301">
                  <c:v>0.36799999999999999</c:v>
                </c:pt>
                <c:pt idx="302">
                  <c:v>0.26</c:v>
                </c:pt>
                <c:pt idx="303">
                  <c:v>0.254</c:v>
                </c:pt>
                <c:pt idx="304">
                  <c:v>0.29799999999999999</c:v>
                </c:pt>
                <c:pt idx="305">
                  <c:v>0.20300000000000001</c:v>
                </c:pt>
                <c:pt idx="306">
                  <c:v>9.6000000000000002E-2</c:v>
                </c:pt>
                <c:pt idx="307">
                  <c:v>0.32800000000000001</c:v>
                </c:pt>
                <c:pt idx="308">
                  <c:v>0.30299999999999999</c:v>
                </c:pt>
                <c:pt idx="309">
                  <c:v>0.316</c:v>
                </c:pt>
                <c:pt idx="310">
                  <c:v>0.27100000000000002</c:v>
                </c:pt>
                <c:pt idx="311">
                  <c:v>0.28999999999999998</c:v>
                </c:pt>
                <c:pt idx="312">
                  <c:v>0.20599999999999999</c:v>
                </c:pt>
                <c:pt idx="313">
                  <c:v>0.879</c:v>
                </c:pt>
                <c:pt idx="314">
                  <c:v>0.20599999999999999</c:v>
                </c:pt>
                <c:pt idx="315">
                  <c:v>0.28299999999999997</c:v>
                </c:pt>
                <c:pt idx="316">
                  <c:v>0.111</c:v>
                </c:pt>
                <c:pt idx="317">
                  <c:v>0.32</c:v>
                </c:pt>
                <c:pt idx="318">
                  <c:v>0.38600000000000001</c:v>
                </c:pt>
                <c:pt idx="319">
                  <c:v>0.42599999999999999</c:v>
                </c:pt>
                <c:pt idx="320">
                  <c:v>0.373</c:v>
                </c:pt>
                <c:pt idx="321">
                  <c:v>7.8E-2</c:v>
                </c:pt>
                <c:pt idx="322">
                  <c:v>0.26300000000000001</c:v>
                </c:pt>
                <c:pt idx="323">
                  <c:v>0.28000000000000003</c:v>
                </c:pt>
                <c:pt idx="324">
                  <c:v>1.091</c:v>
                </c:pt>
                <c:pt idx="325">
                  <c:v>0.183</c:v>
                </c:pt>
                <c:pt idx="326">
                  <c:v>0.18</c:v>
                </c:pt>
                <c:pt idx="327">
                  <c:v>8.5000000000000006E-2</c:v>
                </c:pt>
                <c:pt idx="328">
                  <c:v>0.33</c:v>
                </c:pt>
                <c:pt idx="329">
                  <c:v>0.17199999999999999</c:v>
                </c:pt>
                <c:pt idx="330">
                  <c:v>0.115</c:v>
                </c:pt>
                <c:pt idx="331">
                  <c:v>8.5999999999999993E-2</c:v>
                </c:pt>
                <c:pt idx="332">
                  <c:v>0.25800000000000001</c:v>
                </c:pt>
                <c:pt idx="333">
                  <c:v>0.124</c:v>
                </c:pt>
                <c:pt idx="334">
                  <c:v>0.38</c:v>
                </c:pt>
                <c:pt idx="335">
                  <c:v>0.22900000000000001</c:v>
                </c:pt>
                <c:pt idx="336">
                  <c:v>0.309</c:v>
                </c:pt>
                <c:pt idx="337">
                  <c:v>0.53900000000000003</c:v>
                </c:pt>
                <c:pt idx="338">
                  <c:v>0.28100000000000003</c:v>
                </c:pt>
                <c:pt idx="339">
                  <c:v>0.2</c:v>
                </c:pt>
                <c:pt idx="340">
                  <c:v>0.45100000000000001</c:v>
                </c:pt>
                <c:pt idx="341">
                  <c:v>0.54</c:v>
                </c:pt>
                <c:pt idx="342">
                  <c:v>0.21199999999999999</c:v>
                </c:pt>
                <c:pt idx="343">
                  <c:v>0.86</c:v>
                </c:pt>
                <c:pt idx="344">
                  <c:v>0.115</c:v>
                </c:pt>
                <c:pt idx="345">
                  <c:v>0.35499999999999998</c:v>
                </c:pt>
                <c:pt idx="346">
                  <c:v>0.46800000000000003</c:v>
                </c:pt>
                <c:pt idx="347">
                  <c:v>0.40699999999999997</c:v>
                </c:pt>
                <c:pt idx="348">
                  <c:v>0.19</c:v>
                </c:pt>
                <c:pt idx="349">
                  <c:v>0.432</c:v>
                </c:pt>
                <c:pt idx="350">
                  <c:v>8.6999999999999994E-2</c:v>
                </c:pt>
                <c:pt idx="351">
                  <c:v>0.40400000000000003</c:v>
                </c:pt>
                <c:pt idx="352">
                  <c:v>0.29599999999999999</c:v>
                </c:pt>
                <c:pt idx="353">
                  <c:v>9.8000000000000004E-2</c:v>
                </c:pt>
                <c:pt idx="354">
                  <c:v>0.223</c:v>
                </c:pt>
                <c:pt idx="355">
                  <c:v>0.60099999999999998</c:v>
                </c:pt>
                <c:pt idx="356">
                  <c:v>0.433</c:v>
                </c:pt>
                <c:pt idx="357">
                  <c:v>0.158</c:v>
                </c:pt>
                <c:pt idx="358">
                  <c:v>0.35699999999999998</c:v>
                </c:pt>
                <c:pt idx="359">
                  <c:v>0.45400000000000001</c:v>
                </c:pt>
                <c:pt idx="360">
                  <c:v>0.246</c:v>
                </c:pt>
                <c:pt idx="361">
                  <c:v>0.65900000000000003</c:v>
                </c:pt>
                <c:pt idx="362">
                  <c:v>0.34799999999999998</c:v>
                </c:pt>
                <c:pt idx="363">
                  <c:v>0.441</c:v>
                </c:pt>
                <c:pt idx="364">
                  <c:v>0.36399999999999999</c:v>
                </c:pt>
                <c:pt idx="365">
                  <c:v>0.32700000000000001</c:v>
                </c:pt>
                <c:pt idx="366">
                  <c:v>0.221</c:v>
                </c:pt>
                <c:pt idx="367">
                  <c:v>0.10199999999999999</c:v>
                </c:pt>
                <c:pt idx="368">
                  <c:v>0.3</c:v>
                </c:pt>
                <c:pt idx="369">
                  <c:v>0.32900000000000001</c:v>
                </c:pt>
                <c:pt idx="370">
                  <c:v>0.224</c:v>
                </c:pt>
                <c:pt idx="371">
                  <c:v>0.33700000000000002</c:v>
                </c:pt>
                <c:pt idx="372">
                  <c:v>0.29499999999999998</c:v>
                </c:pt>
                <c:pt idx="373">
                  <c:v>0.311</c:v>
                </c:pt>
                <c:pt idx="374">
                  <c:v>0.45200000000000001</c:v>
                </c:pt>
                <c:pt idx="375">
                  <c:v>0.309</c:v>
                </c:pt>
                <c:pt idx="376">
                  <c:v>0.54800000000000004</c:v>
                </c:pt>
                <c:pt idx="377">
                  <c:v>0.46600000000000003</c:v>
                </c:pt>
                <c:pt idx="378">
                  <c:v>0.42299999999999999</c:v>
                </c:pt>
                <c:pt idx="379">
                  <c:v>0.21099999999999999</c:v>
                </c:pt>
                <c:pt idx="380">
                  <c:v>0.36299999999999999</c:v>
                </c:pt>
                <c:pt idx="381">
                  <c:v>0.38500000000000001</c:v>
                </c:pt>
                <c:pt idx="382">
                  <c:v>0.33800000000000002</c:v>
                </c:pt>
                <c:pt idx="383">
                  <c:v>0.84299999999999997</c:v>
                </c:pt>
                <c:pt idx="384">
                  <c:v>0.36299999999999999</c:v>
                </c:pt>
                <c:pt idx="385">
                  <c:v>0.248</c:v>
                </c:pt>
                <c:pt idx="386">
                  <c:v>0.28899999999999998</c:v>
                </c:pt>
                <c:pt idx="387">
                  <c:v>0.442</c:v>
                </c:pt>
                <c:pt idx="388">
                  <c:v>0.64800000000000002</c:v>
                </c:pt>
                <c:pt idx="389">
                  <c:v>0.42899999999999999</c:v>
                </c:pt>
                <c:pt idx="390">
                  <c:v>0.17899999999999999</c:v>
                </c:pt>
                <c:pt idx="391">
                  <c:v>0.38500000000000001</c:v>
                </c:pt>
                <c:pt idx="392">
                  <c:v>0.156</c:v>
                </c:pt>
                <c:pt idx="393">
                  <c:v>0.33300000000000002</c:v>
                </c:pt>
                <c:pt idx="394">
                  <c:v>0.499</c:v>
                </c:pt>
                <c:pt idx="395">
                  <c:v>0.16800000000000001</c:v>
                </c:pt>
                <c:pt idx="396">
                  <c:v>0.26</c:v>
                </c:pt>
                <c:pt idx="397">
                  <c:v>0.308</c:v>
                </c:pt>
                <c:pt idx="398">
                  <c:v>0.29499999999999998</c:v>
                </c:pt>
                <c:pt idx="399">
                  <c:v>0.23699999999999999</c:v>
                </c:pt>
                <c:pt idx="400">
                  <c:v>0.27400000000000002</c:v>
                </c:pt>
                <c:pt idx="401">
                  <c:v>8.4000000000000005E-2</c:v>
                </c:pt>
                <c:pt idx="402">
                  <c:v>0.41099999999999998</c:v>
                </c:pt>
                <c:pt idx="403">
                  <c:v>0.10100000000000001</c:v>
                </c:pt>
                <c:pt idx="404">
                  <c:v>0.78600000000000003</c:v>
                </c:pt>
                <c:pt idx="405">
                  <c:v>0.29099999999999998</c:v>
                </c:pt>
                <c:pt idx="406">
                  <c:v>0.20799999999999999</c:v>
                </c:pt>
                <c:pt idx="407">
                  <c:v>0.314</c:v>
                </c:pt>
                <c:pt idx="408">
                  <c:v>0.23300000000000001</c:v>
                </c:pt>
                <c:pt idx="409">
                  <c:v>0.56299999999999994</c:v>
                </c:pt>
                <c:pt idx="410">
                  <c:v>0.40699999999999997</c:v>
                </c:pt>
                <c:pt idx="411">
                  <c:v>0.32100000000000001</c:v>
                </c:pt>
                <c:pt idx="412">
                  <c:v>0.29899999999999999</c:v>
                </c:pt>
                <c:pt idx="413">
                  <c:v>0.40899999999999997</c:v>
                </c:pt>
                <c:pt idx="414">
                  <c:v>0.438</c:v>
                </c:pt>
                <c:pt idx="415">
                  <c:v>0.501</c:v>
                </c:pt>
                <c:pt idx="416">
                  <c:v>0.46400000000000002</c:v>
                </c:pt>
                <c:pt idx="417">
                  <c:v>0.32</c:v>
                </c:pt>
                <c:pt idx="418">
                  <c:v>0.32</c:v>
                </c:pt>
                <c:pt idx="419">
                  <c:v>0.14199999999999999</c:v>
                </c:pt>
                <c:pt idx="420">
                  <c:v>0.33400000000000002</c:v>
                </c:pt>
                <c:pt idx="421">
                  <c:v>0.43099999999999999</c:v>
                </c:pt>
                <c:pt idx="422">
                  <c:v>0.161</c:v>
                </c:pt>
                <c:pt idx="423">
                  <c:v>0.56999999999999995</c:v>
                </c:pt>
                <c:pt idx="424">
                  <c:v>0.57999999999999996</c:v>
                </c:pt>
                <c:pt idx="425">
                  <c:v>0.60799999999999998</c:v>
                </c:pt>
                <c:pt idx="426">
                  <c:v>0.65</c:v>
                </c:pt>
                <c:pt idx="427">
                  <c:v>0.315</c:v>
                </c:pt>
                <c:pt idx="428">
                  <c:v>0.56899999999999995</c:v>
                </c:pt>
                <c:pt idx="429">
                  <c:v>0.27</c:v>
                </c:pt>
                <c:pt idx="430">
                  <c:v>0.54600000000000004</c:v>
                </c:pt>
                <c:pt idx="431">
                  <c:v>0.46600000000000003</c:v>
                </c:pt>
                <c:pt idx="432">
                  <c:v>0.51400000000000001</c:v>
                </c:pt>
                <c:pt idx="433">
                  <c:v>0.28299999999999997</c:v>
                </c:pt>
                <c:pt idx="434">
                  <c:v>0.24399999999999999</c:v>
                </c:pt>
                <c:pt idx="435">
                  <c:v>0.56999999999999995</c:v>
                </c:pt>
                <c:pt idx="436">
                  <c:v>0.73299999999999998</c:v>
                </c:pt>
                <c:pt idx="437">
                  <c:v>0.26200000000000001</c:v>
                </c:pt>
                <c:pt idx="438">
                  <c:v>0.38500000000000001</c:v>
                </c:pt>
                <c:pt idx="439">
                  <c:v>0.60699999999999998</c:v>
                </c:pt>
              </c:numCache>
            </c:numRef>
          </c:xVal>
          <c:yVal>
            <c:numRef>
              <c:f>(Sheet3!$C$2:$C$221,Sheet3!$F$2:$F$221)</c:f>
              <c:numCache>
                <c:formatCode>General</c:formatCode>
                <c:ptCount val="440"/>
                <c:pt idx="0">
                  <c:v>135720</c:v>
                </c:pt>
                <c:pt idx="1">
                  <c:v>146323</c:v>
                </c:pt>
                <c:pt idx="2">
                  <c:v>154200</c:v>
                </c:pt>
                <c:pt idx="3">
                  <c:v>135048</c:v>
                </c:pt>
                <c:pt idx="4">
                  <c:v>437958</c:v>
                </c:pt>
                <c:pt idx="5">
                  <c:v>131850</c:v>
                </c:pt>
                <c:pt idx="6">
                  <c:v>96307</c:v>
                </c:pt>
                <c:pt idx="7">
                  <c:v>143902</c:v>
                </c:pt>
                <c:pt idx="8">
                  <c:v>156093</c:v>
                </c:pt>
                <c:pt idx="9">
                  <c:v>145969</c:v>
                </c:pt>
                <c:pt idx="10">
                  <c:v>486219</c:v>
                </c:pt>
                <c:pt idx="11">
                  <c:v>111078</c:v>
                </c:pt>
                <c:pt idx="12">
                  <c:v>197892</c:v>
                </c:pt>
                <c:pt idx="13">
                  <c:v>114217</c:v>
                </c:pt>
                <c:pt idx="14">
                  <c:v>159845</c:v>
                </c:pt>
                <c:pt idx="15">
                  <c:v>202800</c:v>
                </c:pt>
                <c:pt idx="16">
                  <c:v>229813</c:v>
                </c:pt>
                <c:pt idx="17">
                  <c:v>300138</c:v>
                </c:pt>
                <c:pt idx="18">
                  <c:v>138374</c:v>
                </c:pt>
                <c:pt idx="19">
                  <c:v>153009</c:v>
                </c:pt>
                <c:pt idx="20">
                  <c:v>154026</c:v>
                </c:pt>
                <c:pt idx="21">
                  <c:v>94486</c:v>
                </c:pt>
                <c:pt idx="22">
                  <c:v>162543</c:v>
                </c:pt>
                <c:pt idx="23">
                  <c:v>92081</c:v>
                </c:pt>
                <c:pt idx="24">
                  <c:v>139405</c:v>
                </c:pt>
                <c:pt idx="25">
                  <c:v>412058</c:v>
                </c:pt>
                <c:pt idx="26">
                  <c:v>184567</c:v>
                </c:pt>
                <c:pt idx="27">
                  <c:v>121907</c:v>
                </c:pt>
                <c:pt idx="28">
                  <c:v>232373</c:v>
                </c:pt>
                <c:pt idx="29">
                  <c:v>165138</c:v>
                </c:pt>
                <c:pt idx="30">
                  <c:v>182964</c:v>
                </c:pt>
                <c:pt idx="31">
                  <c:v>369954</c:v>
                </c:pt>
                <c:pt idx="32">
                  <c:v>128797</c:v>
                </c:pt>
                <c:pt idx="33">
                  <c:v>120286</c:v>
                </c:pt>
                <c:pt idx="34">
                  <c:v>66168</c:v>
                </c:pt>
                <c:pt idx="35">
                  <c:v>200076</c:v>
                </c:pt>
                <c:pt idx="36">
                  <c:v>221429</c:v>
                </c:pt>
                <c:pt idx="37">
                  <c:v>123579</c:v>
                </c:pt>
                <c:pt idx="38">
                  <c:v>202151</c:v>
                </c:pt>
                <c:pt idx="39">
                  <c:v>273838</c:v>
                </c:pt>
                <c:pt idx="40">
                  <c:v>154649</c:v>
                </c:pt>
                <c:pt idx="41">
                  <c:v>134334</c:v>
                </c:pt>
                <c:pt idx="42">
                  <c:v>106987</c:v>
                </c:pt>
                <c:pt idx="43">
                  <c:v>330492</c:v>
                </c:pt>
                <c:pt idx="44">
                  <c:v>206091</c:v>
                </c:pt>
                <c:pt idx="45">
                  <c:v>156260</c:v>
                </c:pt>
                <c:pt idx="46">
                  <c:v>236437</c:v>
                </c:pt>
                <c:pt idx="47">
                  <c:v>170301</c:v>
                </c:pt>
                <c:pt idx="48">
                  <c:v>194156</c:v>
                </c:pt>
                <c:pt idx="49">
                  <c:v>200948</c:v>
                </c:pt>
                <c:pt idx="50">
                  <c:v>194201</c:v>
                </c:pt>
                <c:pt idx="51">
                  <c:v>213507</c:v>
                </c:pt>
                <c:pt idx="52">
                  <c:v>137596</c:v>
                </c:pt>
                <c:pt idx="53">
                  <c:v>197834</c:v>
                </c:pt>
                <c:pt idx="54">
                  <c:v>203780</c:v>
                </c:pt>
                <c:pt idx="55">
                  <c:v>216658</c:v>
                </c:pt>
                <c:pt idx="56">
                  <c:v>114259</c:v>
                </c:pt>
                <c:pt idx="57">
                  <c:v>169510</c:v>
                </c:pt>
                <c:pt idx="58">
                  <c:v>102896</c:v>
                </c:pt>
                <c:pt idx="59">
                  <c:v>129799</c:v>
                </c:pt>
                <c:pt idx="60">
                  <c:v>205341</c:v>
                </c:pt>
                <c:pt idx="61">
                  <c:v>158019</c:v>
                </c:pt>
                <c:pt idx="62">
                  <c:v>227146</c:v>
                </c:pt>
                <c:pt idx="63">
                  <c:v>102564</c:v>
                </c:pt>
                <c:pt idx="64">
                  <c:v>234755</c:v>
                </c:pt>
                <c:pt idx="65">
                  <c:v>187765</c:v>
                </c:pt>
                <c:pt idx="66">
                  <c:v>138281</c:v>
                </c:pt>
                <c:pt idx="67">
                  <c:v>113305</c:v>
                </c:pt>
                <c:pt idx="68">
                  <c:v>120149</c:v>
                </c:pt>
                <c:pt idx="69">
                  <c:v>208359</c:v>
                </c:pt>
                <c:pt idx="70">
                  <c:v>91823</c:v>
                </c:pt>
                <c:pt idx="71">
                  <c:v>293648</c:v>
                </c:pt>
                <c:pt idx="72">
                  <c:v>148028</c:v>
                </c:pt>
                <c:pt idx="73">
                  <c:v>212491</c:v>
                </c:pt>
                <c:pt idx="74">
                  <c:v>234194</c:v>
                </c:pt>
                <c:pt idx="75">
                  <c:v>149590</c:v>
                </c:pt>
                <c:pt idx="76">
                  <c:v>152977</c:v>
                </c:pt>
                <c:pt idx="77">
                  <c:v>200536</c:v>
                </c:pt>
                <c:pt idx="78">
                  <c:v>107116</c:v>
                </c:pt>
                <c:pt idx="79">
                  <c:v>274386</c:v>
                </c:pt>
                <c:pt idx="80">
                  <c:v>199578</c:v>
                </c:pt>
                <c:pt idx="81">
                  <c:v>207636</c:v>
                </c:pt>
                <c:pt idx="82">
                  <c:v>188160</c:v>
                </c:pt>
                <c:pt idx="83">
                  <c:v>153837</c:v>
                </c:pt>
                <c:pt idx="84">
                  <c:v>205668</c:v>
                </c:pt>
                <c:pt idx="85">
                  <c:v>167590</c:v>
                </c:pt>
                <c:pt idx="86">
                  <c:v>90247</c:v>
                </c:pt>
                <c:pt idx="87">
                  <c:v>177447</c:v>
                </c:pt>
                <c:pt idx="88">
                  <c:v>181017</c:v>
                </c:pt>
                <c:pt idx="89">
                  <c:v>175871</c:v>
                </c:pt>
                <c:pt idx="90">
                  <c:v>117816</c:v>
                </c:pt>
                <c:pt idx="91">
                  <c:v>146981</c:v>
                </c:pt>
                <c:pt idx="92">
                  <c:v>141133</c:v>
                </c:pt>
                <c:pt idx="93">
                  <c:v>344137</c:v>
                </c:pt>
                <c:pt idx="94">
                  <c:v>149882</c:v>
                </c:pt>
                <c:pt idx="95">
                  <c:v>221226</c:v>
                </c:pt>
                <c:pt idx="96">
                  <c:v>218835</c:v>
                </c:pt>
                <c:pt idx="97">
                  <c:v>194743</c:v>
                </c:pt>
                <c:pt idx="98">
                  <c:v>200856</c:v>
                </c:pt>
                <c:pt idx="99">
                  <c:v>192889</c:v>
                </c:pt>
                <c:pt idx="100">
                  <c:v>217447</c:v>
                </c:pt>
                <c:pt idx="101">
                  <c:v>46874</c:v>
                </c:pt>
                <c:pt idx="102">
                  <c:v>203110</c:v>
                </c:pt>
                <c:pt idx="103">
                  <c:v>185892</c:v>
                </c:pt>
                <c:pt idx="104">
                  <c:v>376024</c:v>
                </c:pt>
                <c:pt idx="105">
                  <c:v>141121</c:v>
                </c:pt>
                <c:pt idx="106">
                  <c:v>113035</c:v>
                </c:pt>
                <c:pt idx="107">
                  <c:v>131513</c:v>
                </c:pt>
                <c:pt idx="108">
                  <c:v>194955</c:v>
                </c:pt>
                <c:pt idx="109">
                  <c:v>98427</c:v>
                </c:pt>
                <c:pt idx="110">
                  <c:v>86897</c:v>
                </c:pt>
                <c:pt idx="111">
                  <c:v>81596</c:v>
                </c:pt>
                <c:pt idx="112">
                  <c:v>133275</c:v>
                </c:pt>
                <c:pt idx="113">
                  <c:v>119094</c:v>
                </c:pt>
                <c:pt idx="114">
                  <c:v>204780</c:v>
                </c:pt>
                <c:pt idx="115">
                  <c:v>129488</c:v>
                </c:pt>
                <c:pt idx="116">
                  <c:v>179752</c:v>
                </c:pt>
                <c:pt idx="117">
                  <c:v>235902</c:v>
                </c:pt>
                <c:pt idx="118">
                  <c:v>161596</c:v>
                </c:pt>
                <c:pt idx="119">
                  <c:v>162725</c:v>
                </c:pt>
                <c:pt idx="120">
                  <c:v>202807</c:v>
                </c:pt>
                <c:pt idx="121">
                  <c:v>210098</c:v>
                </c:pt>
                <c:pt idx="122">
                  <c:v>100051</c:v>
                </c:pt>
                <c:pt idx="123">
                  <c:v>173563</c:v>
                </c:pt>
                <c:pt idx="124">
                  <c:v>91841</c:v>
                </c:pt>
                <c:pt idx="125">
                  <c:v>158669</c:v>
                </c:pt>
                <c:pt idx="126">
                  <c:v>142418</c:v>
                </c:pt>
                <c:pt idx="127">
                  <c:v>169732</c:v>
                </c:pt>
                <c:pt idx="128">
                  <c:v>111415</c:v>
                </c:pt>
                <c:pt idx="129">
                  <c:v>186687</c:v>
                </c:pt>
                <c:pt idx="130">
                  <c:v>83509</c:v>
                </c:pt>
                <c:pt idx="131">
                  <c:v>152738</c:v>
                </c:pt>
                <c:pt idx="132">
                  <c:v>131986</c:v>
                </c:pt>
                <c:pt idx="133">
                  <c:v>51851</c:v>
                </c:pt>
                <c:pt idx="134">
                  <c:v>110262</c:v>
                </c:pt>
                <c:pt idx="135">
                  <c:v>182068</c:v>
                </c:pt>
                <c:pt idx="136">
                  <c:v>169473</c:v>
                </c:pt>
                <c:pt idx="137">
                  <c:v>161806</c:v>
                </c:pt>
                <c:pt idx="138">
                  <c:v>126990</c:v>
                </c:pt>
                <c:pt idx="139">
                  <c:v>188985</c:v>
                </c:pt>
                <c:pt idx="140">
                  <c:v>98624</c:v>
                </c:pt>
                <c:pt idx="141">
                  <c:v>220664</c:v>
                </c:pt>
                <c:pt idx="142">
                  <c:v>141208</c:v>
                </c:pt>
                <c:pt idx="143">
                  <c:v>142484</c:v>
                </c:pt>
                <c:pt idx="144">
                  <c:v>129472</c:v>
                </c:pt>
                <c:pt idx="145">
                  <c:v>153941</c:v>
                </c:pt>
                <c:pt idx="146">
                  <c:v>91192</c:v>
                </c:pt>
                <c:pt idx="147">
                  <c:v>49184</c:v>
                </c:pt>
                <c:pt idx="148">
                  <c:v>112114</c:v>
                </c:pt>
                <c:pt idx="149">
                  <c:v>142086</c:v>
                </c:pt>
                <c:pt idx="150">
                  <c:v>109415</c:v>
                </c:pt>
                <c:pt idx="151">
                  <c:v>113857</c:v>
                </c:pt>
                <c:pt idx="152">
                  <c:v>122055</c:v>
                </c:pt>
                <c:pt idx="153">
                  <c:v>140691</c:v>
                </c:pt>
                <c:pt idx="154">
                  <c:v>178429</c:v>
                </c:pt>
                <c:pt idx="155">
                  <c:v>145180</c:v>
                </c:pt>
                <c:pt idx="156">
                  <c:v>180262</c:v>
                </c:pt>
                <c:pt idx="157">
                  <c:v>166473</c:v>
                </c:pt>
                <c:pt idx="158">
                  <c:v>151157</c:v>
                </c:pt>
                <c:pt idx="159">
                  <c:v>90573</c:v>
                </c:pt>
                <c:pt idx="160">
                  <c:v>131617</c:v>
                </c:pt>
                <c:pt idx="161">
                  <c:v>175548</c:v>
                </c:pt>
                <c:pt idx="162">
                  <c:v>96734</c:v>
                </c:pt>
                <c:pt idx="163">
                  <c:v>225868</c:v>
                </c:pt>
                <c:pt idx="164">
                  <c:v>164333</c:v>
                </c:pt>
                <c:pt idx="165">
                  <c:v>110802</c:v>
                </c:pt>
                <c:pt idx="166">
                  <c:v>114277</c:v>
                </c:pt>
                <c:pt idx="167">
                  <c:v>162812</c:v>
                </c:pt>
                <c:pt idx="168">
                  <c:v>166411</c:v>
                </c:pt>
                <c:pt idx="169">
                  <c:v>120843</c:v>
                </c:pt>
                <c:pt idx="170">
                  <c:v>78949</c:v>
                </c:pt>
                <c:pt idx="171">
                  <c:v>215066</c:v>
                </c:pt>
                <c:pt idx="172">
                  <c:v>52839</c:v>
                </c:pt>
                <c:pt idx="173">
                  <c:v>113877</c:v>
                </c:pt>
                <c:pt idx="174">
                  <c:v>153538</c:v>
                </c:pt>
                <c:pt idx="175">
                  <c:v>70894</c:v>
                </c:pt>
                <c:pt idx="176">
                  <c:v>78452</c:v>
                </c:pt>
                <c:pt idx="177">
                  <c:v>102720</c:v>
                </c:pt>
                <c:pt idx="178">
                  <c:v>161008</c:v>
                </c:pt>
                <c:pt idx="179">
                  <c:v>111358</c:v>
                </c:pt>
                <c:pt idx="180">
                  <c:v>101462</c:v>
                </c:pt>
                <c:pt idx="181">
                  <c:v>65399</c:v>
                </c:pt>
                <c:pt idx="182">
                  <c:v>106003</c:v>
                </c:pt>
                <c:pt idx="183">
                  <c:v>61708</c:v>
                </c:pt>
                <c:pt idx="184">
                  <c:v>185841</c:v>
                </c:pt>
                <c:pt idx="185">
                  <c:v>106245</c:v>
                </c:pt>
                <c:pt idx="186">
                  <c:v>63187</c:v>
                </c:pt>
                <c:pt idx="187">
                  <c:v>111148</c:v>
                </c:pt>
                <c:pt idx="188">
                  <c:v>75690</c:v>
                </c:pt>
                <c:pt idx="189">
                  <c:v>132350</c:v>
                </c:pt>
                <c:pt idx="190">
                  <c:v>96994</c:v>
                </c:pt>
                <c:pt idx="191">
                  <c:v>132632</c:v>
                </c:pt>
                <c:pt idx="192">
                  <c:v>87128</c:v>
                </c:pt>
                <c:pt idx="193">
                  <c:v>86200</c:v>
                </c:pt>
                <c:pt idx="194">
                  <c:v>117265</c:v>
                </c:pt>
                <c:pt idx="195">
                  <c:v>117697</c:v>
                </c:pt>
                <c:pt idx="196">
                  <c:v>133627</c:v>
                </c:pt>
                <c:pt idx="197">
                  <c:v>124015</c:v>
                </c:pt>
                <c:pt idx="198">
                  <c:v>99680</c:v>
                </c:pt>
                <c:pt idx="199">
                  <c:v>115304</c:v>
                </c:pt>
                <c:pt idx="200">
                  <c:v>112679</c:v>
                </c:pt>
                <c:pt idx="201">
                  <c:v>102074</c:v>
                </c:pt>
                <c:pt idx="202">
                  <c:v>60446</c:v>
                </c:pt>
                <c:pt idx="203">
                  <c:v>56136</c:v>
                </c:pt>
                <c:pt idx="204">
                  <c:v>107864</c:v>
                </c:pt>
                <c:pt idx="205">
                  <c:v>127724</c:v>
                </c:pt>
                <c:pt idx="206">
                  <c:v>128863</c:v>
                </c:pt>
                <c:pt idx="207">
                  <c:v>81103</c:v>
                </c:pt>
                <c:pt idx="208">
                  <c:v>108983</c:v>
                </c:pt>
                <c:pt idx="209">
                  <c:v>58809</c:v>
                </c:pt>
                <c:pt idx="210">
                  <c:v>108172</c:v>
                </c:pt>
                <c:pt idx="211">
                  <c:v>90478</c:v>
                </c:pt>
                <c:pt idx="212">
                  <c:v>95157</c:v>
                </c:pt>
                <c:pt idx="213">
                  <c:v>71313</c:v>
                </c:pt>
                <c:pt idx="214">
                  <c:v>36602</c:v>
                </c:pt>
                <c:pt idx="215">
                  <c:v>58956</c:v>
                </c:pt>
                <c:pt idx="216">
                  <c:v>67912</c:v>
                </c:pt>
                <c:pt idx="217">
                  <c:v>27474</c:v>
                </c:pt>
                <c:pt idx="218">
                  <c:v>31534</c:v>
                </c:pt>
                <c:pt idx="219">
                  <c:v>33576</c:v>
                </c:pt>
                <c:pt idx="220">
                  <c:v>0</c:v>
                </c:pt>
                <c:pt idx="221">
                  <c:v>3549</c:v>
                </c:pt>
                <c:pt idx="222">
                  <c:v>4589</c:v>
                </c:pt>
                <c:pt idx="223">
                  <c:v>7464</c:v>
                </c:pt>
                <c:pt idx="224">
                  <c:v>26627</c:v>
                </c:pt>
                <c:pt idx="225">
                  <c:v>8050</c:v>
                </c:pt>
                <c:pt idx="226">
                  <c:v>6157</c:v>
                </c:pt>
                <c:pt idx="227">
                  <c:v>10028</c:v>
                </c:pt>
                <c:pt idx="228">
                  <c:v>11620</c:v>
                </c:pt>
                <c:pt idx="229">
                  <c:v>11647</c:v>
                </c:pt>
                <c:pt idx="230">
                  <c:v>38976</c:v>
                </c:pt>
                <c:pt idx="231">
                  <c:v>11162</c:v>
                </c:pt>
                <c:pt idx="232">
                  <c:v>24239</c:v>
                </c:pt>
                <c:pt idx="233">
                  <c:v>14158</c:v>
                </c:pt>
                <c:pt idx="234">
                  <c:v>21672</c:v>
                </c:pt>
                <c:pt idx="235">
                  <c:v>27707</c:v>
                </c:pt>
                <c:pt idx="236">
                  <c:v>31951</c:v>
                </c:pt>
                <c:pt idx="237">
                  <c:v>41843</c:v>
                </c:pt>
                <c:pt idx="238">
                  <c:v>19309</c:v>
                </c:pt>
                <c:pt idx="239">
                  <c:v>21626</c:v>
                </c:pt>
                <c:pt idx="240">
                  <c:v>22069</c:v>
                </c:pt>
                <c:pt idx="241">
                  <c:v>13798</c:v>
                </c:pt>
                <c:pt idx="242">
                  <c:v>24149</c:v>
                </c:pt>
                <c:pt idx="243">
                  <c:v>14858</c:v>
                </c:pt>
                <c:pt idx="244">
                  <c:v>23484</c:v>
                </c:pt>
                <c:pt idx="245">
                  <c:v>75680</c:v>
                </c:pt>
                <c:pt idx="246">
                  <c:v>35087</c:v>
                </c:pt>
                <c:pt idx="247">
                  <c:v>25030</c:v>
                </c:pt>
                <c:pt idx="248">
                  <c:v>47776</c:v>
                </c:pt>
                <c:pt idx="249">
                  <c:v>34617</c:v>
                </c:pt>
                <c:pt idx="250">
                  <c:v>39735</c:v>
                </c:pt>
                <c:pt idx="251">
                  <c:v>84257</c:v>
                </c:pt>
                <c:pt idx="252">
                  <c:v>29797</c:v>
                </c:pt>
                <c:pt idx="253">
                  <c:v>28295</c:v>
                </c:pt>
                <c:pt idx="254">
                  <c:v>15935</c:v>
                </c:pt>
                <c:pt idx="255">
                  <c:v>48190</c:v>
                </c:pt>
                <c:pt idx="256">
                  <c:v>55774</c:v>
                </c:pt>
                <c:pt idx="257">
                  <c:v>31622</c:v>
                </c:pt>
                <c:pt idx="258">
                  <c:v>52456</c:v>
                </c:pt>
                <c:pt idx="259">
                  <c:v>71110</c:v>
                </c:pt>
                <c:pt idx="260">
                  <c:v>40760</c:v>
                </c:pt>
                <c:pt idx="261">
                  <c:v>36574</c:v>
                </c:pt>
                <c:pt idx="262">
                  <c:v>29292</c:v>
                </c:pt>
                <c:pt idx="263">
                  <c:v>93572</c:v>
                </c:pt>
                <c:pt idx="264">
                  <c:v>59715</c:v>
                </c:pt>
                <c:pt idx="265">
                  <c:v>46620</c:v>
                </c:pt>
                <c:pt idx="266">
                  <c:v>71518</c:v>
                </c:pt>
                <c:pt idx="267">
                  <c:v>52440</c:v>
                </c:pt>
                <c:pt idx="268">
                  <c:v>60331</c:v>
                </c:pt>
                <c:pt idx="269">
                  <c:v>63311</c:v>
                </c:pt>
                <c:pt idx="270">
                  <c:v>62949</c:v>
                </c:pt>
                <c:pt idx="271">
                  <c:v>70055</c:v>
                </c:pt>
                <c:pt idx="272">
                  <c:v>45613</c:v>
                </c:pt>
                <c:pt idx="273">
                  <c:v>65672</c:v>
                </c:pt>
                <c:pt idx="274">
                  <c:v>68106</c:v>
                </c:pt>
                <c:pt idx="275">
                  <c:v>73742</c:v>
                </c:pt>
                <c:pt idx="276">
                  <c:v>39117</c:v>
                </c:pt>
                <c:pt idx="277">
                  <c:v>58251</c:v>
                </c:pt>
                <c:pt idx="278">
                  <c:v>36010</c:v>
                </c:pt>
                <c:pt idx="279">
                  <c:v>45690</c:v>
                </c:pt>
                <c:pt idx="280">
                  <c:v>72996</c:v>
                </c:pt>
                <c:pt idx="281">
                  <c:v>56307</c:v>
                </c:pt>
                <c:pt idx="282">
                  <c:v>81954</c:v>
                </c:pt>
                <c:pt idx="283">
                  <c:v>37009</c:v>
                </c:pt>
                <c:pt idx="284">
                  <c:v>85314</c:v>
                </c:pt>
                <c:pt idx="285">
                  <c:v>69302</c:v>
                </c:pt>
                <c:pt idx="286">
                  <c:v>51106</c:v>
                </c:pt>
                <c:pt idx="287">
                  <c:v>42390</c:v>
                </c:pt>
                <c:pt idx="288">
                  <c:v>45541</c:v>
                </c:pt>
                <c:pt idx="289">
                  <c:v>82280</c:v>
                </c:pt>
                <c:pt idx="290">
                  <c:v>36513</c:v>
                </c:pt>
                <c:pt idx="291">
                  <c:v>116768</c:v>
                </c:pt>
                <c:pt idx="292">
                  <c:v>59163</c:v>
                </c:pt>
                <c:pt idx="293">
                  <c:v>87301</c:v>
                </c:pt>
                <c:pt idx="294">
                  <c:v>96900</c:v>
                </c:pt>
                <c:pt idx="295">
                  <c:v>61914</c:v>
                </c:pt>
                <c:pt idx="296">
                  <c:v>63445</c:v>
                </c:pt>
                <c:pt idx="297">
                  <c:v>83633</c:v>
                </c:pt>
                <c:pt idx="298">
                  <c:v>44803</c:v>
                </c:pt>
                <c:pt idx="299">
                  <c:v>114838</c:v>
                </c:pt>
                <c:pt idx="300">
                  <c:v>85035</c:v>
                </c:pt>
                <c:pt idx="301">
                  <c:v>88612</c:v>
                </c:pt>
                <c:pt idx="302">
                  <c:v>82341</c:v>
                </c:pt>
                <c:pt idx="303">
                  <c:v>67461</c:v>
                </c:pt>
                <c:pt idx="304">
                  <c:v>91032</c:v>
                </c:pt>
                <c:pt idx="305">
                  <c:v>74267</c:v>
                </c:pt>
                <c:pt idx="306">
                  <c:v>40358</c:v>
                </c:pt>
                <c:pt idx="307">
                  <c:v>79519</c:v>
                </c:pt>
                <c:pt idx="308">
                  <c:v>81162</c:v>
                </c:pt>
                <c:pt idx="309">
                  <c:v>79101</c:v>
                </c:pt>
                <c:pt idx="310">
                  <c:v>53319</c:v>
                </c:pt>
                <c:pt idx="311">
                  <c:v>67111</c:v>
                </c:pt>
                <c:pt idx="312">
                  <c:v>64931</c:v>
                </c:pt>
                <c:pt idx="313">
                  <c:v>159434</c:v>
                </c:pt>
                <c:pt idx="314">
                  <c:v>69615</c:v>
                </c:pt>
                <c:pt idx="315">
                  <c:v>103100</c:v>
                </c:pt>
                <c:pt idx="316">
                  <c:v>102804</c:v>
                </c:pt>
                <c:pt idx="317">
                  <c:v>92447</c:v>
                </c:pt>
                <c:pt idx="318">
                  <c:v>95445</c:v>
                </c:pt>
                <c:pt idx="319">
                  <c:v>96128</c:v>
                </c:pt>
                <c:pt idx="320">
                  <c:v>108380</c:v>
                </c:pt>
                <c:pt idx="321">
                  <c:v>23375</c:v>
                </c:pt>
                <c:pt idx="322">
                  <c:v>101356</c:v>
                </c:pt>
                <c:pt idx="323">
                  <c:v>93445</c:v>
                </c:pt>
                <c:pt idx="324">
                  <c:v>189314</c:v>
                </c:pt>
                <c:pt idx="325">
                  <c:v>71765</c:v>
                </c:pt>
                <c:pt idx="326">
                  <c:v>57731</c:v>
                </c:pt>
                <c:pt idx="327">
                  <c:v>67931</c:v>
                </c:pt>
                <c:pt idx="328">
                  <c:v>101134</c:v>
                </c:pt>
                <c:pt idx="329">
                  <c:v>51992</c:v>
                </c:pt>
                <c:pt idx="330">
                  <c:v>45967</c:v>
                </c:pt>
                <c:pt idx="331">
                  <c:v>43654</c:v>
                </c:pt>
                <c:pt idx="332">
                  <c:v>71655</c:v>
                </c:pt>
                <c:pt idx="333">
                  <c:v>64622</c:v>
                </c:pt>
                <c:pt idx="334">
                  <c:v>112608</c:v>
                </c:pt>
                <c:pt idx="335">
                  <c:v>72140</c:v>
                </c:pt>
                <c:pt idx="336">
                  <c:v>100597</c:v>
                </c:pt>
                <c:pt idx="337">
                  <c:v>132162</c:v>
                </c:pt>
                <c:pt idx="338">
                  <c:v>91453</c:v>
                </c:pt>
                <c:pt idx="339">
                  <c:v>93009</c:v>
                </c:pt>
                <c:pt idx="340">
                  <c:v>116990</c:v>
                </c:pt>
                <c:pt idx="341">
                  <c:v>122300</c:v>
                </c:pt>
                <c:pt idx="342">
                  <c:v>58533</c:v>
                </c:pt>
                <c:pt idx="343">
                  <c:v>101797</c:v>
                </c:pt>
                <c:pt idx="344">
                  <c:v>54351</c:v>
                </c:pt>
                <c:pt idx="345">
                  <c:v>94792</c:v>
                </c:pt>
                <c:pt idx="346">
                  <c:v>86392</c:v>
                </c:pt>
                <c:pt idx="347">
                  <c:v>102983</c:v>
                </c:pt>
                <c:pt idx="348">
                  <c:v>67923</c:v>
                </c:pt>
                <c:pt idx="349">
                  <c:v>114901</c:v>
                </c:pt>
                <c:pt idx="350">
                  <c:v>51547</c:v>
                </c:pt>
                <c:pt idx="351">
                  <c:v>94285</c:v>
                </c:pt>
                <c:pt idx="352">
                  <c:v>81507</c:v>
                </c:pt>
                <c:pt idx="353">
                  <c:v>32666</c:v>
                </c:pt>
                <c:pt idx="354">
                  <c:v>69676</c:v>
                </c:pt>
                <c:pt idx="355">
                  <c:v>115224</c:v>
                </c:pt>
                <c:pt idx="356">
                  <c:v>108423</c:v>
                </c:pt>
                <c:pt idx="357">
                  <c:v>105369</c:v>
                </c:pt>
                <c:pt idx="358">
                  <c:v>82742</c:v>
                </c:pt>
                <c:pt idx="359">
                  <c:v>124388</c:v>
                </c:pt>
                <c:pt idx="360">
                  <c:v>65504</c:v>
                </c:pt>
                <c:pt idx="361">
                  <c:v>146906</c:v>
                </c:pt>
                <c:pt idx="362">
                  <c:v>96351</c:v>
                </c:pt>
                <c:pt idx="363">
                  <c:v>99056</c:v>
                </c:pt>
                <c:pt idx="364">
                  <c:v>90719</c:v>
                </c:pt>
                <c:pt idx="365">
                  <c:v>107906</c:v>
                </c:pt>
                <c:pt idx="366">
                  <c:v>65326</c:v>
                </c:pt>
                <c:pt idx="367">
                  <c:v>35284</c:v>
                </c:pt>
                <c:pt idx="368">
                  <c:v>80577</c:v>
                </c:pt>
                <c:pt idx="369">
                  <c:v>103072</c:v>
                </c:pt>
                <c:pt idx="370">
                  <c:v>80107</c:v>
                </c:pt>
                <c:pt idx="371">
                  <c:v>83477</c:v>
                </c:pt>
                <c:pt idx="372">
                  <c:v>89626</c:v>
                </c:pt>
                <c:pt idx="373">
                  <c:v>103864</c:v>
                </c:pt>
                <c:pt idx="374">
                  <c:v>132128</c:v>
                </c:pt>
                <c:pt idx="375">
                  <c:v>107515</c:v>
                </c:pt>
                <c:pt idx="376">
                  <c:v>135253</c:v>
                </c:pt>
                <c:pt idx="377">
                  <c:v>127123</c:v>
                </c:pt>
                <c:pt idx="378">
                  <c:v>115975</c:v>
                </c:pt>
                <c:pt idx="379">
                  <c:v>70198</c:v>
                </c:pt>
                <c:pt idx="380">
                  <c:v>102831</c:v>
                </c:pt>
                <c:pt idx="381">
                  <c:v>137281</c:v>
                </c:pt>
                <c:pt idx="382">
                  <c:v>75695</c:v>
                </c:pt>
                <c:pt idx="383">
                  <c:v>177283</c:v>
                </c:pt>
                <c:pt idx="384">
                  <c:v>129024</c:v>
                </c:pt>
                <c:pt idx="385">
                  <c:v>87443</c:v>
                </c:pt>
                <c:pt idx="386">
                  <c:v>91214</c:v>
                </c:pt>
                <c:pt idx="387">
                  <c:v>132744</c:v>
                </c:pt>
                <c:pt idx="388">
                  <c:v>135870</c:v>
                </c:pt>
                <c:pt idx="389">
                  <c:v>98791</c:v>
                </c:pt>
                <c:pt idx="390">
                  <c:v>64666</c:v>
                </c:pt>
                <c:pt idx="391">
                  <c:v>179233</c:v>
                </c:pt>
                <c:pt idx="392">
                  <c:v>44443</c:v>
                </c:pt>
                <c:pt idx="393">
                  <c:v>97136</c:v>
                </c:pt>
                <c:pt idx="394">
                  <c:v>131465</c:v>
                </c:pt>
                <c:pt idx="395">
                  <c:v>60749</c:v>
                </c:pt>
                <c:pt idx="396">
                  <c:v>69572</c:v>
                </c:pt>
                <c:pt idx="397">
                  <c:v>91746</c:v>
                </c:pt>
                <c:pt idx="398">
                  <c:v>144339</c:v>
                </c:pt>
                <c:pt idx="399">
                  <c:v>100341</c:v>
                </c:pt>
                <c:pt idx="400">
                  <c:v>92134</c:v>
                </c:pt>
                <c:pt idx="401">
                  <c:v>59402</c:v>
                </c:pt>
                <c:pt idx="402">
                  <c:v>96369</c:v>
                </c:pt>
                <c:pt idx="403">
                  <c:v>58039</c:v>
                </c:pt>
                <c:pt idx="404">
                  <c:v>177933</c:v>
                </c:pt>
                <c:pt idx="405">
                  <c:v>103601</c:v>
                </c:pt>
                <c:pt idx="406">
                  <c:v>61970</c:v>
                </c:pt>
                <c:pt idx="407">
                  <c:v>109476</c:v>
                </c:pt>
                <c:pt idx="408">
                  <c:v>76556</c:v>
                </c:pt>
                <c:pt idx="409">
                  <c:v>133882</c:v>
                </c:pt>
                <c:pt idx="410">
                  <c:v>98346</c:v>
                </c:pt>
                <c:pt idx="411">
                  <c:v>138492</c:v>
                </c:pt>
                <c:pt idx="412">
                  <c:v>91239</c:v>
                </c:pt>
                <c:pt idx="413">
                  <c:v>91446</c:v>
                </c:pt>
                <c:pt idx="414">
                  <c:v>125741</c:v>
                </c:pt>
                <c:pt idx="415">
                  <c:v>127056</c:v>
                </c:pt>
                <c:pt idx="416">
                  <c:v>145041</c:v>
                </c:pt>
                <c:pt idx="417">
                  <c:v>137310</c:v>
                </c:pt>
                <c:pt idx="418">
                  <c:v>112162</c:v>
                </c:pt>
                <c:pt idx="419">
                  <c:v>132116</c:v>
                </c:pt>
                <c:pt idx="420">
                  <c:v>131619</c:v>
                </c:pt>
                <c:pt idx="421">
                  <c:v>119312</c:v>
                </c:pt>
                <c:pt idx="422">
                  <c:v>70837</c:v>
                </c:pt>
                <c:pt idx="423">
                  <c:v>66048</c:v>
                </c:pt>
                <c:pt idx="424">
                  <c:v>127952</c:v>
                </c:pt>
                <c:pt idx="425">
                  <c:v>153428</c:v>
                </c:pt>
                <c:pt idx="426">
                  <c:v>163627</c:v>
                </c:pt>
                <c:pt idx="427">
                  <c:v>103737</c:v>
                </c:pt>
                <c:pt idx="428">
                  <c:v>139700</c:v>
                </c:pt>
                <c:pt idx="429">
                  <c:v>76676</c:v>
                </c:pt>
                <c:pt idx="430">
                  <c:v>146167</c:v>
                </c:pt>
                <c:pt idx="431">
                  <c:v>123283</c:v>
                </c:pt>
                <c:pt idx="432">
                  <c:v>133820</c:v>
                </c:pt>
                <c:pt idx="433">
                  <c:v>105908</c:v>
                </c:pt>
                <c:pt idx="434">
                  <c:v>64464</c:v>
                </c:pt>
                <c:pt idx="435">
                  <c:v>131414</c:v>
                </c:pt>
                <c:pt idx="436">
                  <c:v>167592</c:v>
                </c:pt>
                <c:pt idx="437">
                  <c:v>70293</c:v>
                </c:pt>
                <c:pt idx="438">
                  <c:v>89056</c:v>
                </c:pt>
                <c:pt idx="439">
                  <c:v>11594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F9B8-4760-8136-48234FFA336F}"/>
            </c:ext>
          </c:extLst>
        </c:ser>
        <c:ser>
          <c:idx val="1"/>
          <c:order val="1"/>
          <c:tx>
            <c:v>0mM</c:v>
          </c:tx>
          <c:spPr>
            <a:ln w="25400" cap="rnd">
              <a:noFill/>
              <a:round/>
            </a:ln>
            <a:effectLst/>
          </c:spPr>
          <c:marker>
            <c:symbol val="square"/>
            <c:size val="5"/>
            <c:spPr>
              <a:solidFill>
                <a:schemeClr val="accent6">
                  <a:lumMod val="75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3!$E$2:$E$221</c:f>
              <c:numCache>
                <c:formatCode>General</c:formatCode>
                <c:ptCount val="220"/>
                <c:pt idx="0">
                  <c:v>0.46600000000000003</c:v>
                </c:pt>
                <c:pt idx="1">
                  <c:v>0.54200000000000004</c:v>
                </c:pt>
                <c:pt idx="2">
                  <c:v>0.36199999999999999</c:v>
                </c:pt>
                <c:pt idx="3">
                  <c:v>0.40600000000000003</c:v>
                </c:pt>
                <c:pt idx="4">
                  <c:v>2.5790000000000002</c:v>
                </c:pt>
                <c:pt idx="5">
                  <c:v>0.222</c:v>
                </c:pt>
                <c:pt idx="6">
                  <c:v>0.13400000000000001</c:v>
                </c:pt>
                <c:pt idx="7">
                  <c:v>0.52100000000000002</c:v>
                </c:pt>
                <c:pt idx="8">
                  <c:v>0.55700000000000005</c:v>
                </c:pt>
                <c:pt idx="9">
                  <c:v>0.44800000000000001</c:v>
                </c:pt>
                <c:pt idx="10">
                  <c:v>2.512</c:v>
                </c:pt>
                <c:pt idx="11">
                  <c:v>0.27100000000000002</c:v>
                </c:pt>
                <c:pt idx="12">
                  <c:v>0.53500000000000003</c:v>
                </c:pt>
                <c:pt idx="13">
                  <c:v>0.17899999999999999</c:v>
                </c:pt>
                <c:pt idx="14">
                  <c:v>0.47599999999999998</c:v>
                </c:pt>
                <c:pt idx="15">
                  <c:v>0.745</c:v>
                </c:pt>
                <c:pt idx="16">
                  <c:v>0.64600000000000002</c:v>
                </c:pt>
                <c:pt idx="17">
                  <c:v>0.97299999999999998</c:v>
                </c:pt>
                <c:pt idx="18">
                  <c:v>0.25</c:v>
                </c:pt>
                <c:pt idx="19">
                  <c:v>0.45500000000000002</c:v>
                </c:pt>
                <c:pt idx="20">
                  <c:v>0.48299999999999998</c:v>
                </c:pt>
                <c:pt idx="21">
                  <c:v>0.158</c:v>
                </c:pt>
                <c:pt idx="22">
                  <c:v>0.52</c:v>
                </c:pt>
                <c:pt idx="23">
                  <c:v>0.188</c:v>
                </c:pt>
                <c:pt idx="24">
                  <c:v>0.315</c:v>
                </c:pt>
                <c:pt idx="25">
                  <c:v>1.958</c:v>
                </c:pt>
                <c:pt idx="26">
                  <c:v>0.51800000000000002</c:v>
                </c:pt>
                <c:pt idx="27">
                  <c:v>0.38900000000000001</c:v>
                </c:pt>
                <c:pt idx="28">
                  <c:v>0.97599999999999998</c:v>
                </c:pt>
                <c:pt idx="29">
                  <c:v>0.5</c:v>
                </c:pt>
                <c:pt idx="30">
                  <c:v>0.52600000000000002</c:v>
                </c:pt>
                <c:pt idx="31">
                  <c:v>2.1030000000000002</c:v>
                </c:pt>
                <c:pt idx="32">
                  <c:v>0.57699999999999996</c:v>
                </c:pt>
                <c:pt idx="33">
                  <c:v>0.30299999999999999</c:v>
                </c:pt>
                <c:pt idx="34">
                  <c:v>0.23</c:v>
                </c:pt>
                <c:pt idx="35">
                  <c:v>0.748</c:v>
                </c:pt>
                <c:pt idx="36">
                  <c:v>0.53800000000000003</c:v>
                </c:pt>
                <c:pt idx="37">
                  <c:v>0.34899999999999998</c:v>
                </c:pt>
                <c:pt idx="38">
                  <c:v>0.49099999999999999</c:v>
                </c:pt>
                <c:pt idx="39">
                  <c:v>0.8</c:v>
                </c:pt>
                <c:pt idx="40">
                  <c:v>0.39300000000000002</c:v>
                </c:pt>
                <c:pt idx="41">
                  <c:v>0.3</c:v>
                </c:pt>
                <c:pt idx="42">
                  <c:v>0.28799999999999998</c:v>
                </c:pt>
                <c:pt idx="43">
                  <c:v>2.0369999999999999</c:v>
                </c:pt>
                <c:pt idx="44">
                  <c:v>0.747</c:v>
                </c:pt>
                <c:pt idx="45">
                  <c:v>0.32</c:v>
                </c:pt>
                <c:pt idx="46">
                  <c:v>0.91800000000000004</c:v>
                </c:pt>
                <c:pt idx="47">
                  <c:v>0.497</c:v>
                </c:pt>
                <c:pt idx="48">
                  <c:v>0.78700000000000003</c:v>
                </c:pt>
                <c:pt idx="49">
                  <c:v>0.64600000000000002</c:v>
                </c:pt>
                <c:pt idx="50">
                  <c:v>0.53300000000000003</c:v>
                </c:pt>
                <c:pt idx="51">
                  <c:v>0.69299999999999995</c:v>
                </c:pt>
                <c:pt idx="52">
                  <c:v>0.33800000000000002</c:v>
                </c:pt>
                <c:pt idx="53">
                  <c:v>0.35199999999999998</c:v>
                </c:pt>
                <c:pt idx="54">
                  <c:v>0.54500000000000004</c:v>
                </c:pt>
                <c:pt idx="55">
                  <c:v>0.64700000000000002</c:v>
                </c:pt>
                <c:pt idx="56">
                  <c:v>0.316</c:v>
                </c:pt>
                <c:pt idx="57">
                  <c:v>7.8E-2</c:v>
                </c:pt>
                <c:pt idx="58">
                  <c:v>0.29199999999999998</c:v>
                </c:pt>
                <c:pt idx="59">
                  <c:v>0.3</c:v>
                </c:pt>
                <c:pt idx="60">
                  <c:v>0.58499999999999996</c:v>
                </c:pt>
                <c:pt idx="61">
                  <c:v>0.50700000000000001</c:v>
                </c:pt>
                <c:pt idx="62">
                  <c:v>0.77900000000000003</c:v>
                </c:pt>
                <c:pt idx="63">
                  <c:v>0.3</c:v>
                </c:pt>
                <c:pt idx="64">
                  <c:v>0.68600000000000005</c:v>
                </c:pt>
                <c:pt idx="65">
                  <c:v>0.505</c:v>
                </c:pt>
                <c:pt idx="66">
                  <c:v>0.38500000000000001</c:v>
                </c:pt>
                <c:pt idx="67">
                  <c:v>0.30599999999999999</c:v>
                </c:pt>
                <c:pt idx="68">
                  <c:v>0.39400000000000002</c:v>
                </c:pt>
                <c:pt idx="69">
                  <c:v>0.377</c:v>
                </c:pt>
                <c:pt idx="70">
                  <c:v>0.47</c:v>
                </c:pt>
                <c:pt idx="71">
                  <c:v>1.6559999999999999</c:v>
                </c:pt>
                <c:pt idx="72">
                  <c:v>0.55000000000000004</c:v>
                </c:pt>
                <c:pt idx="73">
                  <c:v>0.55000000000000004</c:v>
                </c:pt>
                <c:pt idx="74">
                  <c:v>0.67200000000000004</c:v>
                </c:pt>
                <c:pt idx="75">
                  <c:v>0.504</c:v>
                </c:pt>
                <c:pt idx="76">
                  <c:v>0.45500000000000002</c:v>
                </c:pt>
                <c:pt idx="77">
                  <c:v>0.69299999999999995</c:v>
                </c:pt>
                <c:pt idx="78">
                  <c:v>0.246</c:v>
                </c:pt>
                <c:pt idx="79">
                  <c:v>0.46200000000000002</c:v>
                </c:pt>
                <c:pt idx="80">
                  <c:v>0.67</c:v>
                </c:pt>
                <c:pt idx="81">
                  <c:v>0.94799999999999995</c:v>
                </c:pt>
                <c:pt idx="82">
                  <c:v>0.58099999999999996</c:v>
                </c:pt>
                <c:pt idx="83">
                  <c:v>0.505</c:v>
                </c:pt>
                <c:pt idx="84">
                  <c:v>0.41499999999999998</c:v>
                </c:pt>
                <c:pt idx="85">
                  <c:v>0.39400000000000002</c:v>
                </c:pt>
                <c:pt idx="86">
                  <c:v>0.27200000000000002</c:v>
                </c:pt>
                <c:pt idx="87">
                  <c:v>0.56000000000000005</c:v>
                </c:pt>
                <c:pt idx="88">
                  <c:v>0.59799999999999998</c:v>
                </c:pt>
                <c:pt idx="89">
                  <c:v>0.505</c:v>
                </c:pt>
                <c:pt idx="90">
                  <c:v>0.42799999999999999</c:v>
                </c:pt>
                <c:pt idx="91">
                  <c:v>0.45300000000000001</c:v>
                </c:pt>
                <c:pt idx="92">
                  <c:v>0.66400000000000003</c:v>
                </c:pt>
                <c:pt idx="93">
                  <c:v>1.9550000000000001</c:v>
                </c:pt>
                <c:pt idx="94">
                  <c:v>0.41299999999999998</c:v>
                </c:pt>
                <c:pt idx="95">
                  <c:v>0.65900000000000003</c:v>
                </c:pt>
                <c:pt idx="96">
                  <c:v>0.183</c:v>
                </c:pt>
                <c:pt idx="97">
                  <c:v>0.61899999999999999</c:v>
                </c:pt>
                <c:pt idx="98">
                  <c:v>0.81599999999999995</c:v>
                </c:pt>
                <c:pt idx="99">
                  <c:v>0.94299999999999995</c:v>
                </c:pt>
                <c:pt idx="100">
                  <c:v>0.67800000000000005</c:v>
                </c:pt>
                <c:pt idx="101">
                  <c:v>0.13900000000000001</c:v>
                </c:pt>
                <c:pt idx="102">
                  <c:v>0.58199999999999996</c:v>
                </c:pt>
                <c:pt idx="103">
                  <c:v>0.61399999999999999</c:v>
                </c:pt>
                <c:pt idx="104">
                  <c:v>2.3279999999999998</c:v>
                </c:pt>
                <c:pt idx="105">
                  <c:v>0.39700000000000002</c:v>
                </c:pt>
                <c:pt idx="106">
                  <c:v>0.254</c:v>
                </c:pt>
                <c:pt idx="107">
                  <c:v>0.33500000000000002</c:v>
                </c:pt>
                <c:pt idx="108">
                  <c:v>0.65200000000000002</c:v>
                </c:pt>
                <c:pt idx="109">
                  <c:v>0.36799999999999999</c:v>
                </c:pt>
                <c:pt idx="110">
                  <c:v>0.26600000000000001</c:v>
                </c:pt>
                <c:pt idx="111">
                  <c:v>0.153</c:v>
                </c:pt>
                <c:pt idx="112">
                  <c:v>0.34</c:v>
                </c:pt>
                <c:pt idx="113">
                  <c:v>0.32400000000000001</c:v>
                </c:pt>
                <c:pt idx="114">
                  <c:v>0.57899999999999996</c:v>
                </c:pt>
                <c:pt idx="115">
                  <c:v>0.39500000000000002</c:v>
                </c:pt>
                <c:pt idx="116">
                  <c:v>0.49</c:v>
                </c:pt>
                <c:pt idx="117">
                  <c:v>0.73799999999999999</c:v>
                </c:pt>
                <c:pt idx="118">
                  <c:v>0.28199999999999997</c:v>
                </c:pt>
                <c:pt idx="119">
                  <c:v>0.33300000000000002</c:v>
                </c:pt>
                <c:pt idx="120">
                  <c:v>0.65300000000000002</c:v>
                </c:pt>
                <c:pt idx="121">
                  <c:v>0.69299999999999995</c:v>
                </c:pt>
                <c:pt idx="122">
                  <c:v>0.28100000000000003</c:v>
                </c:pt>
                <c:pt idx="123">
                  <c:v>0.78300000000000003</c:v>
                </c:pt>
                <c:pt idx="124">
                  <c:v>0.33500000000000002</c:v>
                </c:pt>
                <c:pt idx="125">
                  <c:v>0.19900000000000001</c:v>
                </c:pt>
                <c:pt idx="126">
                  <c:v>0.315</c:v>
                </c:pt>
                <c:pt idx="127">
                  <c:v>0.58899999999999997</c:v>
                </c:pt>
                <c:pt idx="128">
                  <c:v>0.21</c:v>
                </c:pt>
                <c:pt idx="129">
                  <c:v>0.63700000000000001</c:v>
                </c:pt>
                <c:pt idx="130">
                  <c:v>0.14699999999999999</c:v>
                </c:pt>
                <c:pt idx="131">
                  <c:v>0.45100000000000001</c:v>
                </c:pt>
                <c:pt idx="132">
                  <c:v>0.33600000000000002</c:v>
                </c:pt>
                <c:pt idx="133">
                  <c:v>7.8E-2</c:v>
                </c:pt>
                <c:pt idx="134">
                  <c:v>0.28000000000000003</c:v>
                </c:pt>
                <c:pt idx="135">
                  <c:v>0.621</c:v>
                </c:pt>
                <c:pt idx="136">
                  <c:v>0.59099999999999997</c:v>
                </c:pt>
                <c:pt idx="137">
                  <c:v>0.753</c:v>
                </c:pt>
                <c:pt idx="138">
                  <c:v>0.41599999999999998</c:v>
                </c:pt>
                <c:pt idx="139">
                  <c:v>0.66900000000000004</c:v>
                </c:pt>
                <c:pt idx="140">
                  <c:v>0.34300000000000003</c:v>
                </c:pt>
                <c:pt idx="141">
                  <c:v>0.79200000000000004</c:v>
                </c:pt>
                <c:pt idx="142">
                  <c:v>0.38300000000000001</c:v>
                </c:pt>
                <c:pt idx="143">
                  <c:v>0.435</c:v>
                </c:pt>
                <c:pt idx="144">
                  <c:v>0.40100000000000002</c:v>
                </c:pt>
                <c:pt idx="145">
                  <c:v>0.434</c:v>
                </c:pt>
                <c:pt idx="146">
                  <c:v>0.21299999999999999</c:v>
                </c:pt>
                <c:pt idx="147">
                  <c:v>6.7000000000000004E-2</c:v>
                </c:pt>
                <c:pt idx="148">
                  <c:v>0.66</c:v>
                </c:pt>
                <c:pt idx="149">
                  <c:v>0.36299999999999999</c:v>
                </c:pt>
                <c:pt idx="150">
                  <c:v>0.24099999999999999</c:v>
                </c:pt>
                <c:pt idx="151">
                  <c:v>0.35</c:v>
                </c:pt>
                <c:pt idx="152">
                  <c:v>0.38900000000000001</c:v>
                </c:pt>
                <c:pt idx="153">
                  <c:v>0.36599999999999999</c:v>
                </c:pt>
                <c:pt idx="154">
                  <c:v>0.51600000000000001</c:v>
                </c:pt>
                <c:pt idx="155">
                  <c:v>0.32500000000000001</c:v>
                </c:pt>
                <c:pt idx="156">
                  <c:v>0.47299999999999998</c:v>
                </c:pt>
                <c:pt idx="157">
                  <c:v>0.372</c:v>
                </c:pt>
                <c:pt idx="158">
                  <c:v>0.40200000000000002</c:v>
                </c:pt>
                <c:pt idx="159">
                  <c:v>0.214</c:v>
                </c:pt>
                <c:pt idx="160">
                  <c:v>0.31</c:v>
                </c:pt>
                <c:pt idx="161">
                  <c:v>0.45800000000000002</c:v>
                </c:pt>
                <c:pt idx="162">
                  <c:v>0.20899999999999999</c:v>
                </c:pt>
                <c:pt idx="163">
                  <c:v>0.749</c:v>
                </c:pt>
                <c:pt idx="164">
                  <c:v>0.33</c:v>
                </c:pt>
                <c:pt idx="165">
                  <c:v>0.28899999999999998</c:v>
                </c:pt>
                <c:pt idx="166">
                  <c:v>0.23400000000000001</c:v>
                </c:pt>
                <c:pt idx="167">
                  <c:v>0.33900000000000002</c:v>
                </c:pt>
                <c:pt idx="168">
                  <c:v>0.46100000000000002</c:v>
                </c:pt>
                <c:pt idx="169">
                  <c:v>0.53300000000000003</c:v>
                </c:pt>
                <c:pt idx="170">
                  <c:v>0.20899999999999999</c:v>
                </c:pt>
                <c:pt idx="171">
                  <c:v>0.55700000000000005</c:v>
                </c:pt>
                <c:pt idx="172">
                  <c:v>0.15</c:v>
                </c:pt>
                <c:pt idx="173">
                  <c:v>0.23200000000000001</c:v>
                </c:pt>
                <c:pt idx="174">
                  <c:v>0.504</c:v>
                </c:pt>
                <c:pt idx="175">
                  <c:v>0.2</c:v>
                </c:pt>
                <c:pt idx="176">
                  <c:v>0.23</c:v>
                </c:pt>
                <c:pt idx="177">
                  <c:v>0.308</c:v>
                </c:pt>
                <c:pt idx="178">
                  <c:v>0.114</c:v>
                </c:pt>
                <c:pt idx="179">
                  <c:v>0.28499999999999998</c:v>
                </c:pt>
                <c:pt idx="180">
                  <c:v>0.38</c:v>
                </c:pt>
                <c:pt idx="181">
                  <c:v>0.187</c:v>
                </c:pt>
                <c:pt idx="182">
                  <c:v>0.29199999999999998</c:v>
                </c:pt>
                <c:pt idx="183">
                  <c:v>0.217</c:v>
                </c:pt>
                <c:pt idx="184">
                  <c:v>0.77600000000000002</c:v>
                </c:pt>
                <c:pt idx="185">
                  <c:v>0.25800000000000001</c:v>
                </c:pt>
                <c:pt idx="186">
                  <c:v>0.14000000000000001</c:v>
                </c:pt>
                <c:pt idx="187">
                  <c:v>0.27800000000000002</c:v>
                </c:pt>
                <c:pt idx="188">
                  <c:v>0.21</c:v>
                </c:pt>
                <c:pt idx="189">
                  <c:v>0.39500000000000002</c:v>
                </c:pt>
                <c:pt idx="190">
                  <c:v>0.246</c:v>
                </c:pt>
                <c:pt idx="191">
                  <c:v>0.39300000000000002</c:v>
                </c:pt>
                <c:pt idx="192">
                  <c:v>0.26800000000000002</c:v>
                </c:pt>
                <c:pt idx="193">
                  <c:v>0.28599999999999998</c:v>
                </c:pt>
                <c:pt idx="194">
                  <c:v>0.371</c:v>
                </c:pt>
                <c:pt idx="195">
                  <c:v>0.27900000000000003</c:v>
                </c:pt>
                <c:pt idx="196">
                  <c:v>0.32700000000000001</c:v>
                </c:pt>
                <c:pt idx="197">
                  <c:v>0.55200000000000005</c:v>
                </c:pt>
                <c:pt idx="198">
                  <c:v>0.30099999999999999</c:v>
                </c:pt>
                <c:pt idx="199">
                  <c:v>0.29799999999999999</c:v>
                </c:pt>
                <c:pt idx="200">
                  <c:v>0.27100000000000002</c:v>
                </c:pt>
                <c:pt idx="201">
                  <c:v>0.22</c:v>
                </c:pt>
                <c:pt idx="202">
                  <c:v>0.38200000000000001</c:v>
                </c:pt>
                <c:pt idx="203">
                  <c:v>0.25600000000000001</c:v>
                </c:pt>
                <c:pt idx="204">
                  <c:v>0.32600000000000001</c:v>
                </c:pt>
                <c:pt idx="205">
                  <c:v>0.36699999999999999</c:v>
                </c:pt>
                <c:pt idx="206">
                  <c:v>0.39800000000000002</c:v>
                </c:pt>
                <c:pt idx="207">
                  <c:v>0.223</c:v>
                </c:pt>
                <c:pt idx="208">
                  <c:v>0.39700000000000002</c:v>
                </c:pt>
                <c:pt idx="209">
                  <c:v>9.9000000000000005E-2</c:v>
                </c:pt>
                <c:pt idx="210">
                  <c:v>0.379</c:v>
                </c:pt>
                <c:pt idx="211">
                  <c:v>0.26400000000000001</c:v>
                </c:pt>
                <c:pt idx="212">
                  <c:v>0.216</c:v>
                </c:pt>
                <c:pt idx="213">
                  <c:v>0.16</c:v>
                </c:pt>
                <c:pt idx="214">
                  <c:v>0.114</c:v>
                </c:pt>
                <c:pt idx="215">
                  <c:v>0.14299999999999999</c:v>
                </c:pt>
                <c:pt idx="216">
                  <c:v>0.19700000000000001</c:v>
                </c:pt>
                <c:pt idx="217">
                  <c:v>5.3999999999999999E-2</c:v>
                </c:pt>
                <c:pt idx="218">
                  <c:v>0.115</c:v>
                </c:pt>
                <c:pt idx="219">
                  <c:v>0.371</c:v>
                </c:pt>
              </c:numCache>
            </c:numRef>
          </c:xVal>
          <c:yVal>
            <c:numRef>
              <c:f>Sheet3!$C$2:$C$221</c:f>
              <c:numCache>
                <c:formatCode>General</c:formatCode>
                <c:ptCount val="220"/>
                <c:pt idx="0">
                  <c:v>135720</c:v>
                </c:pt>
                <c:pt idx="1">
                  <c:v>146323</c:v>
                </c:pt>
                <c:pt idx="2">
                  <c:v>154200</c:v>
                </c:pt>
                <c:pt idx="3">
                  <c:v>135048</c:v>
                </c:pt>
                <c:pt idx="4">
                  <c:v>437958</c:v>
                </c:pt>
                <c:pt idx="5">
                  <c:v>131850</c:v>
                </c:pt>
                <c:pt idx="6">
                  <c:v>96307</c:v>
                </c:pt>
                <c:pt idx="7">
                  <c:v>143902</c:v>
                </c:pt>
                <c:pt idx="8">
                  <c:v>156093</c:v>
                </c:pt>
                <c:pt idx="9">
                  <c:v>145969</c:v>
                </c:pt>
                <c:pt idx="10">
                  <c:v>486219</c:v>
                </c:pt>
                <c:pt idx="11">
                  <c:v>111078</c:v>
                </c:pt>
                <c:pt idx="12">
                  <c:v>197892</c:v>
                </c:pt>
                <c:pt idx="13">
                  <c:v>114217</c:v>
                </c:pt>
                <c:pt idx="14">
                  <c:v>159845</c:v>
                </c:pt>
                <c:pt idx="15">
                  <c:v>202800</c:v>
                </c:pt>
                <c:pt idx="16">
                  <c:v>229813</c:v>
                </c:pt>
                <c:pt idx="17">
                  <c:v>300138</c:v>
                </c:pt>
                <c:pt idx="18">
                  <c:v>138374</c:v>
                </c:pt>
                <c:pt idx="19">
                  <c:v>153009</c:v>
                </c:pt>
                <c:pt idx="20">
                  <c:v>154026</c:v>
                </c:pt>
                <c:pt idx="21">
                  <c:v>94486</c:v>
                </c:pt>
                <c:pt idx="22">
                  <c:v>162543</c:v>
                </c:pt>
                <c:pt idx="23">
                  <c:v>92081</c:v>
                </c:pt>
                <c:pt idx="24">
                  <c:v>139405</c:v>
                </c:pt>
                <c:pt idx="25">
                  <c:v>412058</c:v>
                </c:pt>
                <c:pt idx="26">
                  <c:v>184567</c:v>
                </c:pt>
                <c:pt idx="27">
                  <c:v>121907</c:v>
                </c:pt>
                <c:pt idx="28">
                  <c:v>232373</c:v>
                </c:pt>
                <c:pt idx="29">
                  <c:v>165138</c:v>
                </c:pt>
                <c:pt idx="30">
                  <c:v>182964</c:v>
                </c:pt>
                <c:pt idx="31">
                  <c:v>369954</c:v>
                </c:pt>
                <c:pt idx="32">
                  <c:v>128797</c:v>
                </c:pt>
                <c:pt idx="33">
                  <c:v>120286</c:v>
                </c:pt>
                <c:pt idx="34">
                  <c:v>66168</c:v>
                </c:pt>
                <c:pt idx="35">
                  <c:v>200076</c:v>
                </c:pt>
                <c:pt idx="36">
                  <c:v>221429</c:v>
                </c:pt>
                <c:pt idx="37">
                  <c:v>123579</c:v>
                </c:pt>
                <c:pt idx="38">
                  <c:v>202151</c:v>
                </c:pt>
                <c:pt idx="39">
                  <c:v>273838</c:v>
                </c:pt>
                <c:pt idx="40">
                  <c:v>154649</c:v>
                </c:pt>
                <c:pt idx="41">
                  <c:v>134334</c:v>
                </c:pt>
                <c:pt idx="42">
                  <c:v>106987</c:v>
                </c:pt>
                <c:pt idx="43">
                  <c:v>330492</c:v>
                </c:pt>
                <c:pt idx="44">
                  <c:v>206091</c:v>
                </c:pt>
                <c:pt idx="45">
                  <c:v>156260</c:v>
                </c:pt>
                <c:pt idx="46">
                  <c:v>236437</c:v>
                </c:pt>
                <c:pt idx="47">
                  <c:v>170301</c:v>
                </c:pt>
                <c:pt idx="48">
                  <c:v>194156</c:v>
                </c:pt>
                <c:pt idx="49">
                  <c:v>200948</c:v>
                </c:pt>
                <c:pt idx="50">
                  <c:v>194201</c:v>
                </c:pt>
                <c:pt idx="51">
                  <c:v>213507</c:v>
                </c:pt>
                <c:pt idx="52">
                  <c:v>137596</c:v>
                </c:pt>
                <c:pt idx="53">
                  <c:v>197834</c:v>
                </c:pt>
                <c:pt idx="54">
                  <c:v>203780</c:v>
                </c:pt>
                <c:pt idx="55">
                  <c:v>216658</c:v>
                </c:pt>
                <c:pt idx="56">
                  <c:v>114259</c:v>
                </c:pt>
                <c:pt idx="57">
                  <c:v>169510</c:v>
                </c:pt>
                <c:pt idx="58">
                  <c:v>102896</c:v>
                </c:pt>
                <c:pt idx="59">
                  <c:v>129799</c:v>
                </c:pt>
                <c:pt idx="60">
                  <c:v>205341</c:v>
                </c:pt>
                <c:pt idx="61">
                  <c:v>158019</c:v>
                </c:pt>
                <c:pt idx="62">
                  <c:v>227146</c:v>
                </c:pt>
                <c:pt idx="63">
                  <c:v>102564</c:v>
                </c:pt>
                <c:pt idx="64">
                  <c:v>234755</c:v>
                </c:pt>
                <c:pt idx="65">
                  <c:v>187765</c:v>
                </c:pt>
                <c:pt idx="66">
                  <c:v>138281</c:v>
                </c:pt>
                <c:pt idx="67">
                  <c:v>113305</c:v>
                </c:pt>
                <c:pt idx="68">
                  <c:v>120149</c:v>
                </c:pt>
                <c:pt idx="69">
                  <c:v>208359</c:v>
                </c:pt>
                <c:pt idx="70">
                  <c:v>91823</c:v>
                </c:pt>
                <c:pt idx="71">
                  <c:v>293648</c:v>
                </c:pt>
                <c:pt idx="72">
                  <c:v>148028</c:v>
                </c:pt>
                <c:pt idx="73">
                  <c:v>212491</c:v>
                </c:pt>
                <c:pt idx="74">
                  <c:v>234194</c:v>
                </c:pt>
                <c:pt idx="75">
                  <c:v>149590</c:v>
                </c:pt>
                <c:pt idx="76">
                  <c:v>152977</c:v>
                </c:pt>
                <c:pt idx="77">
                  <c:v>200536</c:v>
                </c:pt>
                <c:pt idx="78">
                  <c:v>107116</c:v>
                </c:pt>
                <c:pt idx="79">
                  <c:v>274386</c:v>
                </c:pt>
                <c:pt idx="80">
                  <c:v>199578</c:v>
                </c:pt>
                <c:pt idx="81">
                  <c:v>207636</c:v>
                </c:pt>
                <c:pt idx="82">
                  <c:v>188160</c:v>
                </c:pt>
                <c:pt idx="83">
                  <c:v>153837</c:v>
                </c:pt>
                <c:pt idx="84">
                  <c:v>205668</c:v>
                </c:pt>
                <c:pt idx="85">
                  <c:v>167590</c:v>
                </c:pt>
                <c:pt idx="86">
                  <c:v>90247</c:v>
                </c:pt>
                <c:pt idx="87">
                  <c:v>177447</c:v>
                </c:pt>
                <c:pt idx="88">
                  <c:v>181017</c:v>
                </c:pt>
                <c:pt idx="89">
                  <c:v>175871</c:v>
                </c:pt>
                <c:pt idx="90">
                  <c:v>117816</c:v>
                </c:pt>
                <c:pt idx="91">
                  <c:v>146981</c:v>
                </c:pt>
                <c:pt idx="92">
                  <c:v>141133</c:v>
                </c:pt>
                <c:pt idx="93">
                  <c:v>344137</c:v>
                </c:pt>
                <c:pt idx="94">
                  <c:v>149882</c:v>
                </c:pt>
                <c:pt idx="95">
                  <c:v>221226</c:v>
                </c:pt>
                <c:pt idx="96">
                  <c:v>218835</c:v>
                </c:pt>
                <c:pt idx="97">
                  <c:v>194743</c:v>
                </c:pt>
                <c:pt idx="98">
                  <c:v>200856</c:v>
                </c:pt>
                <c:pt idx="99">
                  <c:v>192889</c:v>
                </c:pt>
                <c:pt idx="100">
                  <c:v>217447</c:v>
                </c:pt>
                <c:pt idx="101">
                  <c:v>46874</c:v>
                </c:pt>
                <c:pt idx="102">
                  <c:v>203110</c:v>
                </c:pt>
                <c:pt idx="103">
                  <c:v>185892</c:v>
                </c:pt>
                <c:pt idx="104">
                  <c:v>376024</c:v>
                </c:pt>
                <c:pt idx="105">
                  <c:v>141121</c:v>
                </c:pt>
                <c:pt idx="106">
                  <c:v>113035</c:v>
                </c:pt>
                <c:pt idx="107">
                  <c:v>131513</c:v>
                </c:pt>
                <c:pt idx="108">
                  <c:v>194955</c:v>
                </c:pt>
                <c:pt idx="109">
                  <c:v>98427</c:v>
                </c:pt>
                <c:pt idx="110">
                  <c:v>86897</c:v>
                </c:pt>
                <c:pt idx="111">
                  <c:v>81596</c:v>
                </c:pt>
                <c:pt idx="112">
                  <c:v>133275</c:v>
                </c:pt>
                <c:pt idx="113">
                  <c:v>119094</c:v>
                </c:pt>
                <c:pt idx="114">
                  <c:v>204780</c:v>
                </c:pt>
                <c:pt idx="115">
                  <c:v>129488</c:v>
                </c:pt>
                <c:pt idx="116">
                  <c:v>179752</c:v>
                </c:pt>
                <c:pt idx="117">
                  <c:v>235902</c:v>
                </c:pt>
                <c:pt idx="118">
                  <c:v>161596</c:v>
                </c:pt>
                <c:pt idx="119">
                  <c:v>162725</c:v>
                </c:pt>
                <c:pt idx="120">
                  <c:v>202807</c:v>
                </c:pt>
                <c:pt idx="121">
                  <c:v>210098</c:v>
                </c:pt>
                <c:pt idx="122">
                  <c:v>100051</c:v>
                </c:pt>
                <c:pt idx="123">
                  <c:v>173563</c:v>
                </c:pt>
                <c:pt idx="124">
                  <c:v>91841</c:v>
                </c:pt>
                <c:pt idx="125">
                  <c:v>158669</c:v>
                </c:pt>
                <c:pt idx="126">
                  <c:v>142418</c:v>
                </c:pt>
                <c:pt idx="127">
                  <c:v>169732</c:v>
                </c:pt>
                <c:pt idx="128">
                  <c:v>111415</c:v>
                </c:pt>
                <c:pt idx="129">
                  <c:v>186687</c:v>
                </c:pt>
                <c:pt idx="130">
                  <c:v>83509</c:v>
                </c:pt>
                <c:pt idx="131">
                  <c:v>152738</c:v>
                </c:pt>
                <c:pt idx="132">
                  <c:v>131986</c:v>
                </c:pt>
                <c:pt idx="133">
                  <c:v>51851</c:v>
                </c:pt>
                <c:pt idx="134">
                  <c:v>110262</c:v>
                </c:pt>
                <c:pt idx="135">
                  <c:v>182068</c:v>
                </c:pt>
                <c:pt idx="136">
                  <c:v>169473</c:v>
                </c:pt>
                <c:pt idx="137">
                  <c:v>161806</c:v>
                </c:pt>
                <c:pt idx="138">
                  <c:v>126990</c:v>
                </c:pt>
                <c:pt idx="139">
                  <c:v>188985</c:v>
                </c:pt>
                <c:pt idx="140">
                  <c:v>98624</c:v>
                </c:pt>
                <c:pt idx="141">
                  <c:v>220664</c:v>
                </c:pt>
                <c:pt idx="142">
                  <c:v>141208</c:v>
                </c:pt>
                <c:pt idx="143">
                  <c:v>142484</c:v>
                </c:pt>
                <c:pt idx="144">
                  <c:v>129472</c:v>
                </c:pt>
                <c:pt idx="145">
                  <c:v>153941</c:v>
                </c:pt>
                <c:pt idx="146">
                  <c:v>91192</c:v>
                </c:pt>
                <c:pt idx="147">
                  <c:v>49184</c:v>
                </c:pt>
                <c:pt idx="148">
                  <c:v>112114</c:v>
                </c:pt>
                <c:pt idx="149">
                  <c:v>142086</c:v>
                </c:pt>
                <c:pt idx="150">
                  <c:v>109415</c:v>
                </c:pt>
                <c:pt idx="151">
                  <c:v>113857</c:v>
                </c:pt>
                <c:pt idx="152">
                  <c:v>122055</c:v>
                </c:pt>
                <c:pt idx="153">
                  <c:v>140691</c:v>
                </c:pt>
                <c:pt idx="154">
                  <c:v>178429</c:v>
                </c:pt>
                <c:pt idx="155">
                  <c:v>145180</c:v>
                </c:pt>
                <c:pt idx="156">
                  <c:v>180262</c:v>
                </c:pt>
                <c:pt idx="157">
                  <c:v>166473</c:v>
                </c:pt>
                <c:pt idx="158">
                  <c:v>151157</c:v>
                </c:pt>
                <c:pt idx="159">
                  <c:v>90573</c:v>
                </c:pt>
                <c:pt idx="160">
                  <c:v>131617</c:v>
                </c:pt>
                <c:pt idx="161">
                  <c:v>175548</c:v>
                </c:pt>
                <c:pt idx="162">
                  <c:v>96734</c:v>
                </c:pt>
                <c:pt idx="163">
                  <c:v>225868</c:v>
                </c:pt>
                <c:pt idx="164">
                  <c:v>164333</c:v>
                </c:pt>
                <c:pt idx="165">
                  <c:v>110802</c:v>
                </c:pt>
                <c:pt idx="166">
                  <c:v>114277</c:v>
                </c:pt>
                <c:pt idx="167">
                  <c:v>162812</c:v>
                </c:pt>
                <c:pt idx="168">
                  <c:v>166411</c:v>
                </c:pt>
                <c:pt idx="169">
                  <c:v>120843</c:v>
                </c:pt>
                <c:pt idx="170">
                  <c:v>78949</c:v>
                </c:pt>
                <c:pt idx="171">
                  <c:v>215066</c:v>
                </c:pt>
                <c:pt idx="172">
                  <c:v>52839</c:v>
                </c:pt>
                <c:pt idx="173">
                  <c:v>113877</c:v>
                </c:pt>
                <c:pt idx="174">
                  <c:v>153538</c:v>
                </c:pt>
                <c:pt idx="175">
                  <c:v>70894</c:v>
                </c:pt>
                <c:pt idx="176">
                  <c:v>78452</c:v>
                </c:pt>
                <c:pt idx="177">
                  <c:v>102720</c:v>
                </c:pt>
                <c:pt idx="178">
                  <c:v>161008</c:v>
                </c:pt>
                <c:pt idx="179">
                  <c:v>111358</c:v>
                </c:pt>
                <c:pt idx="180">
                  <c:v>101462</c:v>
                </c:pt>
                <c:pt idx="181">
                  <c:v>65399</c:v>
                </c:pt>
                <c:pt idx="182">
                  <c:v>106003</c:v>
                </c:pt>
                <c:pt idx="183">
                  <c:v>61708</c:v>
                </c:pt>
                <c:pt idx="184">
                  <c:v>185841</c:v>
                </c:pt>
                <c:pt idx="185">
                  <c:v>106245</c:v>
                </c:pt>
                <c:pt idx="186">
                  <c:v>63187</c:v>
                </c:pt>
                <c:pt idx="187">
                  <c:v>111148</c:v>
                </c:pt>
                <c:pt idx="188">
                  <c:v>75690</c:v>
                </c:pt>
                <c:pt idx="189">
                  <c:v>132350</c:v>
                </c:pt>
                <c:pt idx="190">
                  <c:v>96994</c:v>
                </c:pt>
                <c:pt idx="191">
                  <c:v>132632</c:v>
                </c:pt>
                <c:pt idx="192">
                  <c:v>87128</c:v>
                </c:pt>
                <c:pt idx="193">
                  <c:v>86200</c:v>
                </c:pt>
                <c:pt idx="194">
                  <c:v>117265</c:v>
                </c:pt>
                <c:pt idx="195">
                  <c:v>117697</c:v>
                </c:pt>
                <c:pt idx="196">
                  <c:v>133627</c:v>
                </c:pt>
                <c:pt idx="197">
                  <c:v>124015</c:v>
                </c:pt>
                <c:pt idx="198">
                  <c:v>99680</c:v>
                </c:pt>
                <c:pt idx="199">
                  <c:v>115304</c:v>
                </c:pt>
                <c:pt idx="200">
                  <c:v>112679</c:v>
                </c:pt>
                <c:pt idx="201">
                  <c:v>102074</c:v>
                </c:pt>
                <c:pt idx="202">
                  <c:v>60446</c:v>
                </c:pt>
                <c:pt idx="203">
                  <c:v>56136</c:v>
                </c:pt>
                <c:pt idx="204">
                  <c:v>107864</c:v>
                </c:pt>
                <c:pt idx="205">
                  <c:v>127724</c:v>
                </c:pt>
                <c:pt idx="206">
                  <c:v>128863</c:v>
                </c:pt>
                <c:pt idx="207">
                  <c:v>81103</c:v>
                </c:pt>
                <c:pt idx="208">
                  <c:v>108983</c:v>
                </c:pt>
                <c:pt idx="209">
                  <c:v>58809</c:v>
                </c:pt>
                <c:pt idx="210">
                  <c:v>108172</c:v>
                </c:pt>
                <c:pt idx="211">
                  <c:v>90478</c:v>
                </c:pt>
                <c:pt idx="212">
                  <c:v>95157</c:v>
                </c:pt>
                <c:pt idx="213">
                  <c:v>71313</c:v>
                </c:pt>
                <c:pt idx="214">
                  <c:v>36602</c:v>
                </c:pt>
                <c:pt idx="215">
                  <c:v>58956</c:v>
                </c:pt>
                <c:pt idx="216">
                  <c:v>67912</c:v>
                </c:pt>
                <c:pt idx="217">
                  <c:v>27474</c:v>
                </c:pt>
                <c:pt idx="218">
                  <c:v>31534</c:v>
                </c:pt>
                <c:pt idx="219">
                  <c:v>3357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F9B8-4760-8136-48234FFA336F}"/>
            </c:ext>
          </c:extLst>
        </c:ser>
        <c:ser>
          <c:idx val="2"/>
          <c:order val="2"/>
          <c:tx>
            <c:v>250mM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6"/>
            <c:spPr>
              <a:solidFill>
                <a:schemeClr val="accent2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3!$H$2:$H$221</c:f>
              <c:numCache>
                <c:formatCode>General</c:formatCode>
                <c:ptCount val="220"/>
                <c:pt idx="0">
                  <c:v>0.08</c:v>
                </c:pt>
                <c:pt idx="1">
                  <c:v>0.10100000000000001</c:v>
                </c:pt>
                <c:pt idx="2">
                  <c:v>0.27</c:v>
                </c:pt>
                <c:pt idx="3">
                  <c:v>4.8000000000000001E-2</c:v>
                </c:pt>
                <c:pt idx="4">
                  <c:v>0.14199999999999999</c:v>
                </c:pt>
                <c:pt idx="5">
                  <c:v>6.2E-2</c:v>
                </c:pt>
                <c:pt idx="6">
                  <c:v>0.14399999999999999</c:v>
                </c:pt>
                <c:pt idx="7">
                  <c:v>3.9E-2</c:v>
                </c:pt>
                <c:pt idx="8">
                  <c:v>6.2E-2</c:v>
                </c:pt>
                <c:pt idx="9">
                  <c:v>8.5000000000000006E-2</c:v>
                </c:pt>
                <c:pt idx="10">
                  <c:v>0.18099999999999999</c:v>
                </c:pt>
                <c:pt idx="11">
                  <c:v>9.0999999999999998E-2</c:v>
                </c:pt>
                <c:pt idx="12">
                  <c:v>7.4999999999999997E-2</c:v>
                </c:pt>
                <c:pt idx="13">
                  <c:v>3.4000000000000002E-2</c:v>
                </c:pt>
                <c:pt idx="14">
                  <c:v>4.1000000000000002E-2</c:v>
                </c:pt>
                <c:pt idx="15">
                  <c:v>8.5999999999999993E-2</c:v>
                </c:pt>
                <c:pt idx="16">
                  <c:v>0.21199999999999999</c:v>
                </c:pt>
                <c:pt idx="17">
                  <c:v>0.13900000000000001</c:v>
                </c:pt>
                <c:pt idx="18">
                  <c:v>3.4000000000000002E-2</c:v>
                </c:pt>
                <c:pt idx="19">
                  <c:v>0.121</c:v>
                </c:pt>
                <c:pt idx="20">
                  <c:v>0.10100000000000001</c:v>
                </c:pt>
                <c:pt idx="21">
                  <c:v>0.216</c:v>
                </c:pt>
                <c:pt idx="22">
                  <c:v>9.7000000000000003E-2</c:v>
                </c:pt>
                <c:pt idx="23">
                  <c:v>0.23599999999999999</c:v>
                </c:pt>
                <c:pt idx="24">
                  <c:v>6.7000000000000004E-2</c:v>
                </c:pt>
                <c:pt idx="25">
                  <c:v>0.28199999999999997</c:v>
                </c:pt>
                <c:pt idx="26">
                  <c:v>0.1</c:v>
                </c:pt>
                <c:pt idx="27">
                  <c:v>7.3999999999999996E-2</c:v>
                </c:pt>
                <c:pt idx="28">
                  <c:v>0.17699999999999999</c:v>
                </c:pt>
                <c:pt idx="29">
                  <c:v>9.8000000000000004E-2</c:v>
                </c:pt>
                <c:pt idx="30">
                  <c:v>0.124</c:v>
                </c:pt>
                <c:pt idx="31">
                  <c:v>0.46400000000000002</c:v>
                </c:pt>
                <c:pt idx="32">
                  <c:v>0.28399999999999997</c:v>
                </c:pt>
                <c:pt idx="33">
                  <c:v>0.122</c:v>
                </c:pt>
                <c:pt idx="34">
                  <c:v>6.3E-2</c:v>
                </c:pt>
                <c:pt idx="35">
                  <c:v>0.14599999999999999</c:v>
                </c:pt>
                <c:pt idx="36">
                  <c:v>0.34399999999999997</c:v>
                </c:pt>
                <c:pt idx="37">
                  <c:v>0.127</c:v>
                </c:pt>
                <c:pt idx="38">
                  <c:v>0.182</c:v>
                </c:pt>
                <c:pt idx="39">
                  <c:v>0.315</c:v>
                </c:pt>
                <c:pt idx="40">
                  <c:v>0.14899999999999999</c:v>
                </c:pt>
                <c:pt idx="41">
                  <c:v>0.11</c:v>
                </c:pt>
                <c:pt idx="42">
                  <c:v>0.109</c:v>
                </c:pt>
                <c:pt idx="43">
                  <c:v>0.48099999999999998</c:v>
                </c:pt>
                <c:pt idx="44">
                  <c:v>0.24099999999999999</c:v>
                </c:pt>
                <c:pt idx="45">
                  <c:v>0.17699999999999999</c:v>
                </c:pt>
                <c:pt idx="46">
                  <c:v>0.222</c:v>
                </c:pt>
                <c:pt idx="47">
                  <c:v>0.25900000000000001</c:v>
                </c:pt>
                <c:pt idx="48">
                  <c:v>0.23300000000000001</c:v>
                </c:pt>
                <c:pt idx="49">
                  <c:v>0.16300000000000001</c:v>
                </c:pt>
                <c:pt idx="50">
                  <c:v>0.19</c:v>
                </c:pt>
                <c:pt idx="51">
                  <c:v>0.104</c:v>
                </c:pt>
                <c:pt idx="52">
                  <c:v>0.1</c:v>
                </c:pt>
                <c:pt idx="53">
                  <c:v>0.112</c:v>
                </c:pt>
                <c:pt idx="54">
                  <c:v>0.151</c:v>
                </c:pt>
                <c:pt idx="55">
                  <c:v>0.29699999999999999</c:v>
                </c:pt>
                <c:pt idx="56">
                  <c:v>0.13</c:v>
                </c:pt>
                <c:pt idx="57">
                  <c:v>0.19500000000000001</c:v>
                </c:pt>
                <c:pt idx="58">
                  <c:v>0.11799999999999999</c:v>
                </c:pt>
                <c:pt idx="59">
                  <c:v>6.9000000000000006E-2</c:v>
                </c:pt>
                <c:pt idx="60">
                  <c:v>0.22900000000000001</c:v>
                </c:pt>
                <c:pt idx="61">
                  <c:v>0.16800000000000001</c:v>
                </c:pt>
                <c:pt idx="62">
                  <c:v>0.35499999999999998</c:v>
                </c:pt>
                <c:pt idx="63">
                  <c:v>0.09</c:v>
                </c:pt>
                <c:pt idx="64">
                  <c:v>0.308</c:v>
                </c:pt>
                <c:pt idx="65">
                  <c:v>0.215</c:v>
                </c:pt>
                <c:pt idx="66">
                  <c:v>0.18</c:v>
                </c:pt>
                <c:pt idx="67">
                  <c:v>0.10299999999999999</c:v>
                </c:pt>
                <c:pt idx="68">
                  <c:v>8.6999999999999994E-2</c:v>
                </c:pt>
                <c:pt idx="69">
                  <c:v>0.14099999999999999</c:v>
                </c:pt>
                <c:pt idx="70">
                  <c:v>0.36699999999999999</c:v>
                </c:pt>
                <c:pt idx="71">
                  <c:v>0.79300000000000004</c:v>
                </c:pt>
                <c:pt idx="72">
                  <c:v>0.28699999999999998</c:v>
                </c:pt>
                <c:pt idx="73">
                  <c:v>0.27500000000000002</c:v>
                </c:pt>
                <c:pt idx="74">
                  <c:v>0.50700000000000001</c:v>
                </c:pt>
                <c:pt idx="75">
                  <c:v>0.14199999999999999</c:v>
                </c:pt>
                <c:pt idx="76">
                  <c:v>0.26500000000000001</c:v>
                </c:pt>
                <c:pt idx="77">
                  <c:v>0.438</c:v>
                </c:pt>
                <c:pt idx="78">
                  <c:v>0.52100000000000002</c:v>
                </c:pt>
                <c:pt idx="79">
                  <c:v>0.315</c:v>
                </c:pt>
                <c:pt idx="80">
                  <c:v>0.247</c:v>
                </c:pt>
                <c:pt idx="81">
                  <c:v>0.36799999999999999</c:v>
                </c:pt>
                <c:pt idx="82">
                  <c:v>0.26</c:v>
                </c:pt>
                <c:pt idx="83">
                  <c:v>0.254</c:v>
                </c:pt>
                <c:pt idx="84">
                  <c:v>0.29799999999999999</c:v>
                </c:pt>
                <c:pt idx="85">
                  <c:v>0.20300000000000001</c:v>
                </c:pt>
                <c:pt idx="86">
                  <c:v>9.6000000000000002E-2</c:v>
                </c:pt>
                <c:pt idx="87">
                  <c:v>0.32800000000000001</c:v>
                </c:pt>
                <c:pt idx="88">
                  <c:v>0.30299999999999999</c:v>
                </c:pt>
                <c:pt idx="89">
                  <c:v>0.316</c:v>
                </c:pt>
                <c:pt idx="90">
                  <c:v>0.27100000000000002</c:v>
                </c:pt>
                <c:pt idx="91">
                  <c:v>0.28999999999999998</c:v>
                </c:pt>
                <c:pt idx="92">
                  <c:v>0.20599999999999999</c:v>
                </c:pt>
                <c:pt idx="93">
                  <c:v>0.879</c:v>
                </c:pt>
                <c:pt idx="94">
                  <c:v>0.20599999999999999</c:v>
                </c:pt>
                <c:pt idx="95">
                  <c:v>0.28299999999999997</c:v>
                </c:pt>
                <c:pt idx="96">
                  <c:v>0.111</c:v>
                </c:pt>
                <c:pt idx="97">
                  <c:v>0.32</c:v>
                </c:pt>
                <c:pt idx="98">
                  <c:v>0.38600000000000001</c:v>
                </c:pt>
                <c:pt idx="99">
                  <c:v>0.42599999999999999</c:v>
                </c:pt>
                <c:pt idx="100">
                  <c:v>0.373</c:v>
                </c:pt>
                <c:pt idx="101">
                  <c:v>7.8E-2</c:v>
                </c:pt>
                <c:pt idx="102">
                  <c:v>0.26300000000000001</c:v>
                </c:pt>
                <c:pt idx="103">
                  <c:v>0.28000000000000003</c:v>
                </c:pt>
                <c:pt idx="104">
                  <c:v>1.091</c:v>
                </c:pt>
                <c:pt idx="105">
                  <c:v>0.183</c:v>
                </c:pt>
                <c:pt idx="106">
                  <c:v>0.18</c:v>
                </c:pt>
                <c:pt idx="107">
                  <c:v>8.5000000000000006E-2</c:v>
                </c:pt>
                <c:pt idx="108">
                  <c:v>0.33</c:v>
                </c:pt>
                <c:pt idx="109">
                  <c:v>0.17199999999999999</c:v>
                </c:pt>
                <c:pt idx="110">
                  <c:v>0.115</c:v>
                </c:pt>
                <c:pt idx="111">
                  <c:v>8.5999999999999993E-2</c:v>
                </c:pt>
                <c:pt idx="112">
                  <c:v>0.25800000000000001</c:v>
                </c:pt>
                <c:pt idx="113">
                  <c:v>0.124</c:v>
                </c:pt>
                <c:pt idx="114">
                  <c:v>0.38</c:v>
                </c:pt>
                <c:pt idx="115">
                  <c:v>0.22900000000000001</c:v>
                </c:pt>
                <c:pt idx="116">
                  <c:v>0.309</c:v>
                </c:pt>
                <c:pt idx="117">
                  <c:v>0.53900000000000003</c:v>
                </c:pt>
                <c:pt idx="118">
                  <c:v>0.28100000000000003</c:v>
                </c:pt>
                <c:pt idx="119">
                  <c:v>0.2</c:v>
                </c:pt>
                <c:pt idx="120">
                  <c:v>0.45100000000000001</c:v>
                </c:pt>
                <c:pt idx="121">
                  <c:v>0.54</c:v>
                </c:pt>
                <c:pt idx="122">
                  <c:v>0.21199999999999999</c:v>
                </c:pt>
                <c:pt idx="123">
                  <c:v>0.86</c:v>
                </c:pt>
                <c:pt idx="124">
                  <c:v>0.115</c:v>
                </c:pt>
                <c:pt idx="125">
                  <c:v>0.35499999999999998</c:v>
                </c:pt>
                <c:pt idx="126">
                  <c:v>0.46800000000000003</c:v>
                </c:pt>
                <c:pt idx="127">
                  <c:v>0.40699999999999997</c:v>
                </c:pt>
                <c:pt idx="128">
                  <c:v>0.19</c:v>
                </c:pt>
                <c:pt idx="129">
                  <c:v>0.432</c:v>
                </c:pt>
                <c:pt idx="130">
                  <c:v>8.6999999999999994E-2</c:v>
                </c:pt>
                <c:pt idx="131">
                  <c:v>0.40400000000000003</c:v>
                </c:pt>
                <c:pt idx="132">
                  <c:v>0.29599999999999999</c:v>
                </c:pt>
                <c:pt idx="133">
                  <c:v>9.8000000000000004E-2</c:v>
                </c:pt>
                <c:pt idx="134">
                  <c:v>0.223</c:v>
                </c:pt>
                <c:pt idx="135">
                  <c:v>0.60099999999999998</c:v>
                </c:pt>
                <c:pt idx="136">
                  <c:v>0.433</c:v>
                </c:pt>
                <c:pt idx="137">
                  <c:v>0.158</c:v>
                </c:pt>
                <c:pt idx="138">
                  <c:v>0.35699999999999998</c:v>
                </c:pt>
                <c:pt idx="139">
                  <c:v>0.45400000000000001</c:v>
                </c:pt>
                <c:pt idx="140">
                  <c:v>0.246</c:v>
                </c:pt>
                <c:pt idx="141">
                  <c:v>0.65900000000000003</c:v>
                </c:pt>
                <c:pt idx="142">
                  <c:v>0.34799999999999998</c:v>
                </c:pt>
                <c:pt idx="143">
                  <c:v>0.441</c:v>
                </c:pt>
                <c:pt idx="144">
                  <c:v>0.36399999999999999</c:v>
                </c:pt>
                <c:pt idx="145">
                  <c:v>0.32700000000000001</c:v>
                </c:pt>
                <c:pt idx="146">
                  <c:v>0.221</c:v>
                </c:pt>
                <c:pt idx="147">
                  <c:v>0.10199999999999999</c:v>
                </c:pt>
                <c:pt idx="148">
                  <c:v>0.3</c:v>
                </c:pt>
                <c:pt idx="149">
                  <c:v>0.32900000000000001</c:v>
                </c:pt>
                <c:pt idx="150">
                  <c:v>0.224</c:v>
                </c:pt>
                <c:pt idx="151">
                  <c:v>0.33700000000000002</c:v>
                </c:pt>
                <c:pt idx="152">
                  <c:v>0.29499999999999998</c:v>
                </c:pt>
                <c:pt idx="153">
                  <c:v>0.311</c:v>
                </c:pt>
                <c:pt idx="154">
                  <c:v>0.45200000000000001</c:v>
                </c:pt>
                <c:pt idx="155">
                  <c:v>0.309</c:v>
                </c:pt>
                <c:pt idx="156">
                  <c:v>0.54800000000000004</c:v>
                </c:pt>
                <c:pt idx="157">
                  <c:v>0.46600000000000003</c:v>
                </c:pt>
                <c:pt idx="158">
                  <c:v>0.42299999999999999</c:v>
                </c:pt>
                <c:pt idx="159">
                  <c:v>0.21099999999999999</c:v>
                </c:pt>
                <c:pt idx="160">
                  <c:v>0.36299999999999999</c:v>
                </c:pt>
                <c:pt idx="161">
                  <c:v>0.38500000000000001</c:v>
                </c:pt>
                <c:pt idx="162">
                  <c:v>0.33800000000000002</c:v>
                </c:pt>
                <c:pt idx="163">
                  <c:v>0.84299999999999997</c:v>
                </c:pt>
                <c:pt idx="164">
                  <c:v>0.36299999999999999</c:v>
                </c:pt>
                <c:pt idx="165">
                  <c:v>0.248</c:v>
                </c:pt>
                <c:pt idx="166">
                  <c:v>0.28899999999999998</c:v>
                </c:pt>
                <c:pt idx="167">
                  <c:v>0.442</c:v>
                </c:pt>
                <c:pt idx="168">
                  <c:v>0.64800000000000002</c:v>
                </c:pt>
                <c:pt idx="169">
                  <c:v>0.42899999999999999</c:v>
                </c:pt>
                <c:pt idx="170">
                  <c:v>0.17899999999999999</c:v>
                </c:pt>
                <c:pt idx="171">
                  <c:v>0.38500000000000001</c:v>
                </c:pt>
                <c:pt idx="172">
                  <c:v>0.156</c:v>
                </c:pt>
                <c:pt idx="173">
                  <c:v>0.33300000000000002</c:v>
                </c:pt>
                <c:pt idx="174">
                  <c:v>0.499</c:v>
                </c:pt>
                <c:pt idx="175">
                  <c:v>0.16800000000000001</c:v>
                </c:pt>
                <c:pt idx="176">
                  <c:v>0.26</c:v>
                </c:pt>
                <c:pt idx="177">
                  <c:v>0.308</c:v>
                </c:pt>
                <c:pt idx="178">
                  <c:v>0.29499999999999998</c:v>
                </c:pt>
                <c:pt idx="179">
                  <c:v>0.23699999999999999</c:v>
                </c:pt>
                <c:pt idx="180">
                  <c:v>0.27400000000000002</c:v>
                </c:pt>
                <c:pt idx="181">
                  <c:v>8.4000000000000005E-2</c:v>
                </c:pt>
                <c:pt idx="182">
                  <c:v>0.41099999999999998</c:v>
                </c:pt>
                <c:pt idx="183">
                  <c:v>0.10100000000000001</c:v>
                </c:pt>
                <c:pt idx="184">
                  <c:v>0.78600000000000003</c:v>
                </c:pt>
                <c:pt idx="185">
                  <c:v>0.29099999999999998</c:v>
                </c:pt>
                <c:pt idx="186">
                  <c:v>0.20799999999999999</c:v>
                </c:pt>
                <c:pt idx="187">
                  <c:v>0.314</c:v>
                </c:pt>
                <c:pt idx="188">
                  <c:v>0.23300000000000001</c:v>
                </c:pt>
                <c:pt idx="189">
                  <c:v>0.56299999999999994</c:v>
                </c:pt>
                <c:pt idx="190">
                  <c:v>0.40699999999999997</c:v>
                </c:pt>
                <c:pt idx="191">
                  <c:v>0.32100000000000001</c:v>
                </c:pt>
                <c:pt idx="192">
                  <c:v>0.29899999999999999</c:v>
                </c:pt>
                <c:pt idx="193">
                  <c:v>0.40899999999999997</c:v>
                </c:pt>
                <c:pt idx="194">
                  <c:v>0.438</c:v>
                </c:pt>
                <c:pt idx="195">
                  <c:v>0.501</c:v>
                </c:pt>
                <c:pt idx="196">
                  <c:v>0.46400000000000002</c:v>
                </c:pt>
                <c:pt idx="197">
                  <c:v>0.32</c:v>
                </c:pt>
                <c:pt idx="198">
                  <c:v>0.32</c:v>
                </c:pt>
                <c:pt idx="199">
                  <c:v>0.14199999999999999</c:v>
                </c:pt>
                <c:pt idx="200">
                  <c:v>0.33400000000000002</c:v>
                </c:pt>
                <c:pt idx="201">
                  <c:v>0.43099999999999999</c:v>
                </c:pt>
                <c:pt idx="202">
                  <c:v>0.161</c:v>
                </c:pt>
                <c:pt idx="203">
                  <c:v>0.56999999999999995</c:v>
                </c:pt>
                <c:pt idx="204">
                  <c:v>0.57999999999999996</c:v>
                </c:pt>
                <c:pt idx="205">
                  <c:v>0.60799999999999998</c:v>
                </c:pt>
                <c:pt idx="206">
                  <c:v>0.65</c:v>
                </c:pt>
                <c:pt idx="207">
                  <c:v>0.315</c:v>
                </c:pt>
                <c:pt idx="208">
                  <c:v>0.56899999999999995</c:v>
                </c:pt>
                <c:pt idx="209">
                  <c:v>0.27</c:v>
                </c:pt>
                <c:pt idx="210">
                  <c:v>0.54600000000000004</c:v>
                </c:pt>
                <c:pt idx="211">
                  <c:v>0.46600000000000003</c:v>
                </c:pt>
                <c:pt idx="212">
                  <c:v>0.51400000000000001</c:v>
                </c:pt>
                <c:pt idx="213">
                  <c:v>0.28299999999999997</c:v>
                </c:pt>
                <c:pt idx="214">
                  <c:v>0.24399999999999999</c:v>
                </c:pt>
                <c:pt idx="215">
                  <c:v>0.56999999999999995</c:v>
                </c:pt>
                <c:pt idx="216">
                  <c:v>0.73299999999999998</c:v>
                </c:pt>
                <c:pt idx="217">
                  <c:v>0.26200000000000001</c:v>
                </c:pt>
                <c:pt idx="218">
                  <c:v>0.38500000000000001</c:v>
                </c:pt>
                <c:pt idx="219">
                  <c:v>0.60699999999999998</c:v>
                </c:pt>
              </c:numCache>
            </c:numRef>
          </c:xVal>
          <c:yVal>
            <c:numRef>
              <c:f>Sheet3!$F$2:$F$221</c:f>
              <c:numCache>
                <c:formatCode>General</c:formatCode>
                <c:ptCount val="220"/>
                <c:pt idx="0">
                  <c:v>0</c:v>
                </c:pt>
                <c:pt idx="1">
                  <c:v>3549</c:v>
                </c:pt>
                <c:pt idx="2">
                  <c:v>4589</c:v>
                </c:pt>
                <c:pt idx="3">
                  <c:v>7464</c:v>
                </c:pt>
                <c:pt idx="4">
                  <c:v>26627</c:v>
                </c:pt>
                <c:pt idx="5">
                  <c:v>8050</c:v>
                </c:pt>
                <c:pt idx="6">
                  <c:v>6157</c:v>
                </c:pt>
                <c:pt idx="7">
                  <c:v>10028</c:v>
                </c:pt>
                <c:pt idx="8">
                  <c:v>11620</c:v>
                </c:pt>
                <c:pt idx="9">
                  <c:v>11647</c:v>
                </c:pt>
                <c:pt idx="10">
                  <c:v>38976</c:v>
                </c:pt>
                <c:pt idx="11">
                  <c:v>11162</c:v>
                </c:pt>
                <c:pt idx="12">
                  <c:v>24239</c:v>
                </c:pt>
                <c:pt idx="13">
                  <c:v>14158</c:v>
                </c:pt>
                <c:pt idx="14">
                  <c:v>21672</c:v>
                </c:pt>
                <c:pt idx="15">
                  <c:v>27707</c:v>
                </c:pt>
                <c:pt idx="16">
                  <c:v>31951</c:v>
                </c:pt>
                <c:pt idx="17">
                  <c:v>41843</c:v>
                </c:pt>
                <c:pt idx="18">
                  <c:v>19309</c:v>
                </c:pt>
                <c:pt idx="19">
                  <c:v>21626</c:v>
                </c:pt>
                <c:pt idx="20">
                  <c:v>22069</c:v>
                </c:pt>
                <c:pt idx="21">
                  <c:v>13798</c:v>
                </c:pt>
                <c:pt idx="22">
                  <c:v>24149</c:v>
                </c:pt>
                <c:pt idx="23">
                  <c:v>14858</c:v>
                </c:pt>
                <c:pt idx="24">
                  <c:v>23484</c:v>
                </c:pt>
                <c:pt idx="25">
                  <c:v>75680</c:v>
                </c:pt>
                <c:pt idx="26">
                  <c:v>35087</c:v>
                </c:pt>
                <c:pt idx="27">
                  <c:v>25030</c:v>
                </c:pt>
                <c:pt idx="28">
                  <c:v>47776</c:v>
                </c:pt>
                <c:pt idx="29">
                  <c:v>34617</c:v>
                </c:pt>
                <c:pt idx="30">
                  <c:v>39735</c:v>
                </c:pt>
                <c:pt idx="31">
                  <c:v>84257</c:v>
                </c:pt>
                <c:pt idx="32">
                  <c:v>29797</c:v>
                </c:pt>
                <c:pt idx="33">
                  <c:v>28295</c:v>
                </c:pt>
                <c:pt idx="34">
                  <c:v>15935</c:v>
                </c:pt>
                <c:pt idx="35">
                  <c:v>48190</c:v>
                </c:pt>
                <c:pt idx="36">
                  <c:v>55774</c:v>
                </c:pt>
                <c:pt idx="37">
                  <c:v>31622</c:v>
                </c:pt>
                <c:pt idx="38">
                  <c:v>52456</c:v>
                </c:pt>
                <c:pt idx="39">
                  <c:v>71110</c:v>
                </c:pt>
                <c:pt idx="40">
                  <c:v>40760</c:v>
                </c:pt>
                <c:pt idx="41">
                  <c:v>36574</c:v>
                </c:pt>
                <c:pt idx="42">
                  <c:v>29292</c:v>
                </c:pt>
                <c:pt idx="43">
                  <c:v>93572</c:v>
                </c:pt>
                <c:pt idx="44">
                  <c:v>59715</c:v>
                </c:pt>
                <c:pt idx="45">
                  <c:v>46620</c:v>
                </c:pt>
                <c:pt idx="46">
                  <c:v>71518</c:v>
                </c:pt>
                <c:pt idx="47">
                  <c:v>52440</c:v>
                </c:pt>
                <c:pt idx="48">
                  <c:v>60331</c:v>
                </c:pt>
                <c:pt idx="49">
                  <c:v>63311</c:v>
                </c:pt>
                <c:pt idx="50">
                  <c:v>62949</c:v>
                </c:pt>
                <c:pt idx="51">
                  <c:v>70055</c:v>
                </c:pt>
                <c:pt idx="52">
                  <c:v>45613</c:v>
                </c:pt>
                <c:pt idx="53">
                  <c:v>65672</c:v>
                </c:pt>
                <c:pt idx="54">
                  <c:v>68106</c:v>
                </c:pt>
                <c:pt idx="55">
                  <c:v>73742</c:v>
                </c:pt>
                <c:pt idx="56">
                  <c:v>39117</c:v>
                </c:pt>
                <c:pt idx="57">
                  <c:v>58251</c:v>
                </c:pt>
                <c:pt idx="58">
                  <c:v>36010</c:v>
                </c:pt>
                <c:pt idx="59">
                  <c:v>45690</c:v>
                </c:pt>
                <c:pt idx="60">
                  <c:v>72996</c:v>
                </c:pt>
                <c:pt idx="61">
                  <c:v>56307</c:v>
                </c:pt>
                <c:pt idx="62">
                  <c:v>81954</c:v>
                </c:pt>
                <c:pt idx="63">
                  <c:v>37009</c:v>
                </c:pt>
                <c:pt idx="64">
                  <c:v>85314</c:v>
                </c:pt>
                <c:pt idx="65">
                  <c:v>69302</c:v>
                </c:pt>
                <c:pt idx="66">
                  <c:v>51106</c:v>
                </c:pt>
                <c:pt idx="67">
                  <c:v>42390</c:v>
                </c:pt>
                <c:pt idx="68">
                  <c:v>45541</c:v>
                </c:pt>
                <c:pt idx="69">
                  <c:v>82280</c:v>
                </c:pt>
                <c:pt idx="70">
                  <c:v>36513</c:v>
                </c:pt>
                <c:pt idx="71">
                  <c:v>116768</c:v>
                </c:pt>
                <c:pt idx="72">
                  <c:v>59163</c:v>
                </c:pt>
                <c:pt idx="73">
                  <c:v>87301</c:v>
                </c:pt>
                <c:pt idx="74">
                  <c:v>96900</c:v>
                </c:pt>
                <c:pt idx="75">
                  <c:v>61914</c:v>
                </c:pt>
                <c:pt idx="76">
                  <c:v>63445</c:v>
                </c:pt>
                <c:pt idx="77">
                  <c:v>83633</c:v>
                </c:pt>
                <c:pt idx="78">
                  <c:v>44803</c:v>
                </c:pt>
                <c:pt idx="79">
                  <c:v>114838</c:v>
                </c:pt>
                <c:pt idx="80">
                  <c:v>85035</c:v>
                </c:pt>
                <c:pt idx="81">
                  <c:v>88612</c:v>
                </c:pt>
                <c:pt idx="82">
                  <c:v>82341</c:v>
                </c:pt>
                <c:pt idx="83">
                  <c:v>67461</c:v>
                </c:pt>
                <c:pt idx="84">
                  <c:v>91032</c:v>
                </c:pt>
                <c:pt idx="85">
                  <c:v>74267</c:v>
                </c:pt>
                <c:pt idx="86">
                  <c:v>40358</c:v>
                </c:pt>
                <c:pt idx="87">
                  <c:v>79519</c:v>
                </c:pt>
                <c:pt idx="88">
                  <c:v>81162</c:v>
                </c:pt>
                <c:pt idx="89">
                  <c:v>79101</c:v>
                </c:pt>
                <c:pt idx="90">
                  <c:v>53319</c:v>
                </c:pt>
                <c:pt idx="91">
                  <c:v>67111</c:v>
                </c:pt>
                <c:pt idx="92">
                  <c:v>64931</c:v>
                </c:pt>
                <c:pt idx="93">
                  <c:v>159434</c:v>
                </c:pt>
                <c:pt idx="94">
                  <c:v>69615</c:v>
                </c:pt>
                <c:pt idx="95">
                  <c:v>103100</c:v>
                </c:pt>
                <c:pt idx="96">
                  <c:v>102804</c:v>
                </c:pt>
                <c:pt idx="97">
                  <c:v>92447</c:v>
                </c:pt>
                <c:pt idx="98">
                  <c:v>95445</c:v>
                </c:pt>
                <c:pt idx="99">
                  <c:v>96128</c:v>
                </c:pt>
                <c:pt idx="100">
                  <c:v>108380</c:v>
                </c:pt>
                <c:pt idx="101">
                  <c:v>23375</c:v>
                </c:pt>
                <c:pt idx="102">
                  <c:v>101356</c:v>
                </c:pt>
                <c:pt idx="103">
                  <c:v>93445</c:v>
                </c:pt>
                <c:pt idx="104">
                  <c:v>189314</c:v>
                </c:pt>
                <c:pt idx="105">
                  <c:v>71765</c:v>
                </c:pt>
                <c:pt idx="106">
                  <c:v>57731</c:v>
                </c:pt>
                <c:pt idx="107">
                  <c:v>67931</c:v>
                </c:pt>
                <c:pt idx="108">
                  <c:v>101134</c:v>
                </c:pt>
                <c:pt idx="109">
                  <c:v>51992</c:v>
                </c:pt>
                <c:pt idx="110">
                  <c:v>45967</c:v>
                </c:pt>
                <c:pt idx="111">
                  <c:v>43654</c:v>
                </c:pt>
                <c:pt idx="112">
                  <c:v>71655</c:v>
                </c:pt>
                <c:pt idx="113">
                  <c:v>64622</c:v>
                </c:pt>
                <c:pt idx="114">
                  <c:v>112608</c:v>
                </c:pt>
                <c:pt idx="115">
                  <c:v>72140</c:v>
                </c:pt>
                <c:pt idx="116">
                  <c:v>100597</c:v>
                </c:pt>
                <c:pt idx="117">
                  <c:v>132162</c:v>
                </c:pt>
                <c:pt idx="118">
                  <c:v>91453</c:v>
                </c:pt>
                <c:pt idx="119">
                  <c:v>93009</c:v>
                </c:pt>
                <c:pt idx="120">
                  <c:v>116990</c:v>
                </c:pt>
                <c:pt idx="121">
                  <c:v>122300</c:v>
                </c:pt>
                <c:pt idx="122">
                  <c:v>58533</c:v>
                </c:pt>
                <c:pt idx="123">
                  <c:v>101797</c:v>
                </c:pt>
                <c:pt idx="124">
                  <c:v>54351</c:v>
                </c:pt>
                <c:pt idx="125">
                  <c:v>94792</c:v>
                </c:pt>
                <c:pt idx="126">
                  <c:v>86392</c:v>
                </c:pt>
                <c:pt idx="127">
                  <c:v>102983</c:v>
                </c:pt>
                <c:pt idx="128">
                  <c:v>67923</c:v>
                </c:pt>
                <c:pt idx="129">
                  <c:v>114901</c:v>
                </c:pt>
                <c:pt idx="130">
                  <c:v>51547</c:v>
                </c:pt>
                <c:pt idx="131">
                  <c:v>94285</c:v>
                </c:pt>
                <c:pt idx="132">
                  <c:v>81507</c:v>
                </c:pt>
                <c:pt idx="133">
                  <c:v>32666</c:v>
                </c:pt>
                <c:pt idx="134">
                  <c:v>69676</c:v>
                </c:pt>
                <c:pt idx="135">
                  <c:v>115224</c:v>
                </c:pt>
                <c:pt idx="136">
                  <c:v>108423</c:v>
                </c:pt>
                <c:pt idx="137">
                  <c:v>105369</c:v>
                </c:pt>
                <c:pt idx="138">
                  <c:v>82742</c:v>
                </c:pt>
                <c:pt idx="139">
                  <c:v>124388</c:v>
                </c:pt>
                <c:pt idx="140">
                  <c:v>65504</c:v>
                </c:pt>
                <c:pt idx="141">
                  <c:v>146906</c:v>
                </c:pt>
                <c:pt idx="142">
                  <c:v>96351</c:v>
                </c:pt>
                <c:pt idx="143">
                  <c:v>99056</c:v>
                </c:pt>
                <c:pt idx="144">
                  <c:v>90719</c:v>
                </c:pt>
                <c:pt idx="145">
                  <c:v>107906</c:v>
                </c:pt>
                <c:pt idx="146">
                  <c:v>65326</c:v>
                </c:pt>
                <c:pt idx="147">
                  <c:v>35284</c:v>
                </c:pt>
                <c:pt idx="148">
                  <c:v>80577</c:v>
                </c:pt>
                <c:pt idx="149">
                  <c:v>103072</c:v>
                </c:pt>
                <c:pt idx="150">
                  <c:v>80107</c:v>
                </c:pt>
                <c:pt idx="151">
                  <c:v>83477</c:v>
                </c:pt>
                <c:pt idx="152">
                  <c:v>89626</c:v>
                </c:pt>
                <c:pt idx="153">
                  <c:v>103864</c:v>
                </c:pt>
                <c:pt idx="154">
                  <c:v>132128</c:v>
                </c:pt>
                <c:pt idx="155">
                  <c:v>107515</c:v>
                </c:pt>
                <c:pt idx="156">
                  <c:v>135253</c:v>
                </c:pt>
                <c:pt idx="157">
                  <c:v>127123</c:v>
                </c:pt>
                <c:pt idx="158">
                  <c:v>115975</c:v>
                </c:pt>
                <c:pt idx="159">
                  <c:v>70198</c:v>
                </c:pt>
                <c:pt idx="160">
                  <c:v>102831</c:v>
                </c:pt>
                <c:pt idx="161">
                  <c:v>137281</c:v>
                </c:pt>
                <c:pt idx="162">
                  <c:v>75695</c:v>
                </c:pt>
                <c:pt idx="163">
                  <c:v>177283</c:v>
                </c:pt>
                <c:pt idx="164">
                  <c:v>129024</c:v>
                </c:pt>
                <c:pt idx="165">
                  <c:v>87443</c:v>
                </c:pt>
                <c:pt idx="166">
                  <c:v>91214</c:v>
                </c:pt>
                <c:pt idx="167">
                  <c:v>132744</c:v>
                </c:pt>
                <c:pt idx="168">
                  <c:v>135870</c:v>
                </c:pt>
                <c:pt idx="169">
                  <c:v>98791</c:v>
                </c:pt>
                <c:pt idx="170">
                  <c:v>64666</c:v>
                </c:pt>
                <c:pt idx="171">
                  <c:v>179233</c:v>
                </c:pt>
                <c:pt idx="172">
                  <c:v>44443</c:v>
                </c:pt>
                <c:pt idx="173">
                  <c:v>97136</c:v>
                </c:pt>
                <c:pt idx="174">
                  <c:v>131465</c:v>
                </c:pt>
                <c:pt idx="175">
                  <c:v>60749</c:v>
                </c:pt>
                <c:pt idx="176">
                  <c:v>69572</c:v>
                </c:pt>
                <c:pt idx="177">
                  <c:v>91746</c:v>
                </c:pt>
                <c:pt idx="178">
                  <c:v>144339</c:v>
                </c:pt>
                <c:pt idx="179">
                  <c:v>100341</c:v>
                </c:pt>
                <c:pt idx="180">
                  <c:v>92134</c:v>
                </c:pt>
                <c:pt idx="181">
                  <c:v>59402</c:v>
                </c:pt>
                <c:pt idx="182">
                  <c:v>96369</c:v>
                </c:pt>
                <c:pt idx="183">
                  <c:v>58039</c:v>
                </c:pt>
                <c:pt idx="184">
                  <c:v>177933</c:v>
                </c:pt>
                <c:pt idx="185">
                  <c:v>103601</c:v>
                </c:pt>
                <c:pt idx="186">
                  <c:v>61970</c:v>
                </c:pt>
                <c:pt idx="187">
                  <c:v>109476</c:v>
                </c:pt>
                <c:pt idx="188">
                  <c:v>76556</c:v>
                </c:pt>
                <c:pt idx="189">
                  <c:v>133882</c:v>
                </c:pt>
                <c:pt idx="190">
                  <c:v>98346</c:v>
                </c:pt>
                <c:pt idx="191">
                  <c:v>138492</c:v>
                </c:pt>
                <c:pt idx="192">
                  <c:v>91239</c:v>
                </c:pt>
                <c:pt idx="193">
                  <c:v>91446</c:v>
                </c:pt>
                <c:pt idx="194">
                  <c:v>125741</c:v>
                </c:pt>
                <c:pt idx="195">
                  <c:v>127056</c:v>
                </c:pt>
                <c:pt idx="196">
                  <c:v>145041</c:v>
                </c:pt>
                <c:pt idx="197">
                  <c:v>137310</c:v>
                </c:pt>
                <c:pt idx="198">
                  <c:v>112162</c:v>
                </c:pt>
                <c:pt idx="199">
                  <c:v>132116</c:v>
                </c:pt>
                <c:pt idx="200">
                  <c:v>131619</c:v>
                </c:pt>
                <c:pt idx="201">
                  <c:v>119312</c:v>
                </c:pt>
                <c:pt idx="202">
                  <c:v>70837</c:v>
                </c:pt>
                <c:pt idx="203">
                  <c:v>66048</c:v>
                </c:pt>
                <c:pt idx="204">
                  <c:v>127952</c:v>
                </c:pt>
                <c:pt idx="205">
                  <c:v>153428</c:v>
                </c:pt>
                <c:pt idx="206">
                  <c:v>163627</c:v>
                </c:pt>
                <c:pt idx="207">
                  <c:v>103737</c:v>
                </c:pt>
                <c:pt idx="208">
                  <c:v>139700</c:v>
                </c:pt>
                <c:pt idx="209">
                  <c:v>76676</c:v>
                </c:pt>
                <c:pt idx="210">
                  <c:v>146167</c:v>
                </c:pt>
                <c:pt idx="211">
                  <c:v>123283</c:v>
                </c:pt>
                <c:pt idx="212">
                  <c:v>133820</c:v>
                </c:pt>
                <c:pt idx="213">
                  <c:v>105908</c:v>
                </c:pt>
                <c:pt idx="214">
                  <c:v>64464</c:v>
                </c:pt>
                <c:pt idx="215">
                  <c:v>131414</c:v>
                </c:pt>
                <c:pt idx="216">
                  <c:v>167592</c:v>
                </c:pt>
                <c:pt idx="217">
                  <c:v>70293</c:v>
                </c:pt>
                <c:pt idx="218">
                  <c:v>89056</c:v>
                </c:pt>
                <c:pt idx="219">
                  <c:v>11594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F9B8-4760-8136-48234FFA336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40378656"/>
        <c:axId val="740378984"/>
      </c:scatterChart>
      <c:valAx>
        <c:axId val="74037865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AU"/>
                  <a:t>Dry Biomass (g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740378984"/>
        <c:crosses val="autoZero"/>
        <c:crossBetween val="midCat"/>
      </c:valAx>
      <c:valAx>
        <c:axId val="740378984"/>
        <c:scaling>
          <c:orientation val="minMax"/>
          <c:max val="5000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AU"/>
                  <a:t>Estimated Shoot Biomass (000 Pixels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740378656"/>
        <c:crosses val="autoZero"/>
        <c:crossBetween val="midCat"/>
        <c:majorUnit val="100000"/>
        <c:dispUnits>
          <c:builtInUnit val="thousands"/>
        </c:dispUnits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L$5:$L$16</c:f>
                <c:numCache>
                  <c:formatCode>General</c:formatCode>
                  <c:ptCount val="12"/>
                  <c:pt idx="0">
                    <c:v>0.42610463897060907</c:v>
                  </c:pt>
                  <c:pt idx="1">
                    <c:v>0.15444123533064133</c:v>
                  </c:pt>
                  <c:pt idx="2">
                    <c:v>0.21534484435118564</c:v>
                  </c:pt>
                  <c:pt idx="3">
                    <c:v>2.0664650439283458</c:v>
                  </c:pt>
                  <c:pt idx="4">
                    <c:v>15.794232421291536</c:v>
                  </c:pt>
                  <c:pt idx="5">
                    <c:v>5.3796098390312679</c:v>
                  </c:pt>
                  <c:pt idx="6">
                    <c:v>6.6142270901444018</c:v>
                  </c:pt>
                  <c:pt idx="7">
                    <c:v>12.840755429490905</c:v>
                  </c:pt>
                  <c:pt idx="8">
                    <c:v>20.589026203295777</c:v>
                  </c:pt>
                  <c:pt idx="9">
                    <c:v>10.795925157206302</c:v>
                  </c:pt>
                  <c:pt idx="10">
                    <c:v>18.586446674929558</c:v>
                  </c:pt>
                  <c:pt idx="11">
                    <c:v>20.452481512031735</c:v>
                  </c:pt>
                </c:numCache>
              </c:numRef>
            </c:plus>
            <c:minus>
              <c:numRef>
                <c:f>Sheet1!$L$5:$L$16</c:f>
                <c:numCache>
                  <c:formatCode>General</c:formatCode>
                  <c:ptCount val="12"/>
                  <c:pt idx="0">
                    <c:v>0.42610463897060907</c:v>
                  </c:pt>
                  <c:pt idx="1">
                    <c:v>0.15444123533064133</c:v>
                  </c:pt>
                  <c:pt idx="2">
                    <c:v>0.21534484435118564</c:v>
                  </c:pt>
                  <c:pt idx="3">
                    <c:v>2.0664650439283458</c:v>
                  </c:pt>
                  <c:pt idx="4">
                    <c:v>15.794232421291536</c:v>
                  </c:pt>
                  <c:pt idx="5">
                    <c:v>5.3796098390312679</c:v>
                  </c:pt>
                  <c:pt idx="6">
                    <c:v>6.6142270901444018</c:v>
                  </c:pt>
                  <c:pt idx="7">
                    <c:v>12.840755429490905</c:v>
                  </c:pt>
                  <c:pt idx="8">
                    <c:v>20.589026203295777</c:v>
                  </c:pt>
                  <c:pt idx="9">
                    <c:v>10.795925157206302</c:v>
                  </c:pt>
                  <c:pt idx="10">
                    <c:v>18.586446674929558</c:v>
                  </c:pt>
                  <c:pt idx="11">
                    <c:v>20.45248151203173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Sheet1!$C$5:$D$16</c:f>
              <c:multiLvlStrCache>
                <c:ptCount val="12"/>
                <c:lvl>
                  <c:pt idx="0">
                    <c:v>0 - 5cm</c:v>
                  </c:pt>
                  <c:pt idx="1">
                    <c:v>6 -10cm</c:v>
                  </c:pt>
                  <c:pt idx="2">
                    <c:v>11 -16cm</c:v>
                  </c:pt>
                  <c:pt idx="3">
                    <c:v>0 - 5cm</c:v>
                  </c:pt>
                  <c:pt idx="4">
                    <c:v>6 -10cm</c:v>
                  </c:pt>
                  <c:pt idx="5">
                    <c:v>11 -16cm</c:v>
                  </c:pt>
                  <c:pt idx="6">
                    <c:v>0 - 5cm</c:v>
                  </c:pt>
                  <c:pt idx="7">
                    <c:v>6 -10cm</c:v>
                  </c:pt>
                  <c:pt idx="8">
                    <c:v>11 -16cm</c:v>
                  </c:pt>
                  <c:pt idx="9">
                    <c:v>0 - 5cm</c:v>
                  </c:pt>
                  <c:pt idx="10">
                    <c:v>6 -10cm</c:v>
                  </c:pt>
                  <c:pt idx="11">
                    <c:v>11 -16cm</c:v>
                  </c:pt>
                </c:lvl>
                <c:lvl>
                  <c:pt idx="0">
                    <c:v>0</c:v>
                  </c:pt>
                  <c:pt idx="3">
                    <c:v>125</c:v>
                  </c:pt>
                  <c:pt idx="6">
                    <c:v>250</c:v>
                  </c:pt>
                  <c:pt idx="9">
                    <c:v>350</c:v>
                  </c:pt>
                </c:lvl>
              </c:multiLvlStrCache>
            </c:multiLvlStrRef>
          </c:cat>
          <c:val>
            <c:numRef>
              <c:f>Sheet1!$E$5:$E$16</c:f>
              <c:numCache>
                <c:formatCode>General</c:formatCode>
                <c:ptCount val="12"/>
                <c:pt idx="0">
                  <c:v>4.1421875000000004</c:v>
                </c:pt>
                <c:pt idx="1">
                  <c:v>3.3359375</c:v>
                </c:pt>
                <c:pt idx="2">
                  <c:v>3.8140624999999999</c:v>
                </c:pt>
                <c:pt idx="3">
                  <c:v>48.041666666666664</c:v>
                </c:pt>
                <c:pt idx="4">
                  <c:v>146.53333333333333</c:v>
                </c:pt>
                <c:pt idx="5">
                  <c:v>223.36666666666667</c:v>
                </c:pt>
                <c:pt idx="6">
                  <c:v>102.25</c:v>
                </c:pt>
                <c:pt idx="7">
                  <c:v>259.45</c:v>
                </c:pt>
                <c:pt idx="8">
                  <c:v>393.50000000000006</c:v>
                </c:pt>
                <c:pt idx="9">
                  <c:v>163.4</c:v>
                </c:pt>
                <c:pt idx="10">
                  <c:v>373.79999999999995</c:v>
                </c:pt>
                <c:pt idx="11">
                  <c:v>470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726-408A-96E7-F35A2FB4C70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020995960"/>
        <c:axId val="2020995304"/>
      </c:barChart>
      <c:catAx>
        <c:axId val="2020995960"/>
        <c:scaling>
          <c:orientation val="minMax"/>
        </c:scaling>
        <c:delete val="0"/>
        <c:axPos val="b"/>
        <c:numFmt formatCode="General" sourceLinked="1"/>
        <c:majorTickMark val="out"/>
        <c:minorTickMark val="out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020995304"/>
        <c:crosses val="autoZero"/>
        <c:auto val="1"/>
        <c:lblAlgn val="ctr"/>
        <c:lblOffset val="100"/>
        <c:noMultiLvlLbl val="0"/>
      </c:catAx>
      <c:valAx>
        <c:axId val="20209953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0209959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>
              <a:lumMod val="95000"/>
              <a:lumOff val="5000"/>
            </a:schemeClr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47DEA98-329A-42F8-8389-9834BF710481}" type="datetimeFigureOut">
              <a:rPr lang="en-AU" smtClean="0"/>
              <a:t>16/05/2021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4F53335-D530-47FA-A3B2-513CCE843C4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041956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90254B-7BBC-401F-8330-529FFA4DB7EA}" type="datetimeFigureOut">
              <a:rPr lang="en-AU" smtClean="0"/>
              <a:t>16/05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CC427-DD37-48AC-BED0-4FC8E9962D2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099560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90254B-7BBC-401F-8330-529FFA4DB7EA}" type="datetimeFigureOut">
              <a:rPr lang="en-AU" smtClean="0"/>
              <a:t>16/05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CC427-DD37-48AC-BED0-4FC8E9962D2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528864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90254B-7BBC-401F-8330-529FFA4DB7EA}" type="datetimeFigureOut">
              <a:rPr lang="en-AU" smtClean="0"/>
              <a:t>16/05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CC427-DD37-48AC-BED0-4FC8E9962D2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16808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90254B-7BBC-401F-8330-529FFA4DB7EA}" type="datetimeFigureOut">
              <a:rPr lang="en-AU" smtClean="0"/>
              <a:t>16/05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CC427-DD37-48AC-BED0-4FC8E9962D2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622865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90254B-7BBC-401F-8330-529FFA4DB7EA}" type="datetimeFigureOut">
              <a:rPr lang="en-AU" smtClean="0"/>
              <a:t>16/05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CC427-DD37-48AC-BED0-4FC8E9962D2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280400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90254B-7BBC-401F-8330-529FFA4DB7EA}" type="datetimeFigureOut">
              <a:rPr lang="en-AU" smtClean="0"/>
              <a:t>16/05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CC427-DD37-48AC-BED0-4FC8E9962D2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606532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90254B-7BBC-401F-8330-529FFA4DB7EA}" type="datetimeFigureOut">
              <a:rPr lang="en-AU" smtClean="0"/>
              <a:t>16/05/2021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CC427-DD37-48AC-BED0-4FC8E9962D2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856453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90254B-7BBC-401F-8330-529FFA4DB7EA}" type="datetimeFigureOut">
              <a:rPr lang="en-AU" smtClean="0"/>
              <a:t>16/05/2021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CC427-DD37-48AC-BED0-4FC8E9962D2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007684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90254B-7BBC-401F-8330-529FFA4DB7EA}" type="datetimeFigureOut">
              <a:rPr lang="en-AU" smtClean="0"/>
              <a:t>16/05/2021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CC427-DD37-48AC-BED0-4FC8E9962D2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781079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90254B-7BBC-401F-8330-529FFA4DB7EA}" type="datetimeFigureOut">
              <a:rPr lang="en-AU" smtClean="0"/>
              <a:t>16/05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CC427-DD37-48AC-BED0-4FC8E9962D2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595892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90254B-7BBC-401F-8330-529FFA4DB7EA}" type="datetimeFigureOut">
              <a:rPr lang="en-AU" smtClean="0"/>
              <a:t>16/05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CC427-DD37-48AC-BED0-4FC8E9962D2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562115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90254B-7BBC-401F-8330-529FFA4DB7EA}" type="datetimeFigureOut">
              <a:rPr lang="en-AU" smtClean="0"/>
              <a:t>16/05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0CC427-DD37-48AC-BED0-4FC8E9962D2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805616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2824535D-8A34-433D-94A9-606CF04400F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11802154"/>
              </p:ext>
            </p:extLst>
          </p:nvPr>
        </p:nvGraphicFramePr>
        <p:xfrm>
          <a:off x="270269" y="688214"/>
          <a:ext cx="3158735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BA1D84E8-D40D-404A-82BF-8F8C4EC746F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65137329"/>
              </p:ext>
            </p:extLst>
          </p:nvPr>
        </p:nvGraphicFramePr>
        <p:xfrm>
          <a:off x="3429005" y="688214"/>
          <a:ext cx="3158735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id="{4B67F386-1CA9-47DA-AD80-C3E122686181}"/>
              </a:ext>
            </a:extLst>
          </p:cNvPr>
          <p:cNvSpPr txBox="1"/>
          <p:nvPr/>
        </p:nvSpPr>
        <p:spPr>
          <a:xfrm>
            <a:off x="181639" y="543582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0D368D0-3438-416D-B60F-FEECC96880E1}"/>
              </a:ext>
            </a:extLst>
          </p:cNvPr>
          <p:cNvSpPr txBox="1"/>
          <p:nvPr/>
        </p:nvSpPr>
        <p:spPr>
          <a:xfrm>
            <a:off x="3486325" y="543580"/>
            <a:ext cx="4235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EEE3FFE-1C4D-4254-BB5F-4E50E8AB330F}"/>
              </a:ext>
            </a:extLst>
          </p:cNvPr>
          <p:cNvSpPr txBox="1"/>
          <p:nvPr/>
        </p:nvSpPr>
        <p:spPr>
          <a:xfrm>
            <a:off x="392637" y="3507038"/>
            <a:ext cx="612714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: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s between measured and estimated shoot biomass of diverse safflower genotypes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A) For fresh biomass and (B) dry biomass of 200 diverse safflower genotypes grown under control (0 mM NaCl) and salt (250 mM NaCl) treatments, harvested at 36 DAS. </a:t>
            </a:r>
          </a:p>
        </p:txBody>
      </p:sp>
    </p:spTree>
    <p:extLst>
      <p:ext uri="{BB962C8B-B14F-4D97-AF65-F5344CB8AC3E}">
        <p14:creationId xmlns:p14="http://schemas.microsoft.com/office/powerpoint/2010/main" val="17141784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396520BD-90B6-4A3E-AA4E-61FF814544D7}"/>
              </a:ext>
            </a:extLst>
          </p:cNvPr>
          <p:cNvSpPr txBox="1"/>
          <p:nvPr/>
        </p:nvSpPr>
        <p:spPr>
          <a:xfrm rot="16200000">
            <a:off x="-771535" y="1938514"/>
            <a:ext cx="208422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b="1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oil Na</a:t>
            </a:r>
            <a:r>
              <a:rPr lang="en-AU" sz="1000" b="1" baseline="30000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AU" sz="1000" b="1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Content (µM Na</a:t>
            </a:r>
            <a:r>
              <a:rPr lang="en-AU" sz="1000" b="1" baseline="30000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  </a:t>
            </a:r>
            <a:r>
              <a:rPr lang="en-AU" sz="1000" b="1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AU" sz="1000" b="1" baseline="30000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AU" sz="1000" b="1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DW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1F54084-EC5D-44F3-87F8-95952926DEB7}"/>
              </a:ext>
            </a:extLst>
          </p:cNvPr>
          <p:cNvSpPr txBox="1"/>
          <p:nvPr/>
        </p:nvSpPr>
        <p:spPr>
          <a:xfrm>
            <a:off x="2119594" y="3568527"/>
            <a:ext cx="28777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A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pplied salt (NaCl) concentrations (mM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93C4AD5-F523-47A9-AAE2-73BBD2F085C4}"/>
              </a:ext>
            </a:extLst>
          </p:cNvPr>
          <p:cNvSpPr txBox="1"/>
          <p:nvPr/>
        </p:nvSpPr>
        <p:spPr>
          <a:xfrm>
            <a:off x="743696" y="3960170"/>
            <a:ext cx="552301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: 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asurement of sodium at three depths of soil in pots for four salt treatments at the end of the experiment, 36 DAS. Data represented as mean ± SEM</a:t>
            </a:r>
          </a:p>
        </p:txBody>
      </p:sp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B6E06077-0B3C-4C2C-AFD6-91417C8F512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16532329"/>
              </p:ext>
            </p:extLst>
          </p:nvPr>
        </p:nvGraphicFramePr>
        <p:xfrm>
          <a:off x="409078" y="835971"/>
          <a:ext cx="6000751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912F9330-864A-413E-885B-D4C69CE30BFD}"/>
              </a:ext>
            </a:extLst>
          </p:cNvPr>
          <p:cNvSpPr txBox="1"/>
          <p:nvPr/>
        </p:nvSpPr>
        <p:spPr>
          <a:xfrm>
            <a:off x="1435394" y="3337706"/>
            <a:ext cx="42530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0A6BF1A-0D98-460E-9E8C-3F22960BFDB3}"/>
              </a:ext>
            </a:extLst>
          </p:cNvPr>
          <p:cNvSpPr txBox="1"/>
          <p:nvPr/>
        </p:nvSpPr>
        <p:spPr>
          <a:xfrm>
            <a:off x="2853081" y="3330611"/>
            <a:ext cx="42530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42A1997-B701-47D1-AE64-4521009C02CA}"/>
              </a:ext>
            </a:extLst>
          </p:cNvPr>
          <p:cNvSpPr txBox="1"/>
          <p:nvPr/>
        </p:nvSpPr>
        <p:spPr>
          <a:xfrm>
            <a:off x="4228238" y="3334149"/>
            <a:ext cx="42530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1511A5D-4516-4C7B-959A-5C6E1A523FFB}"/>
              </a:ext>
            </a:extLst>
          </p:cNvPr>
          <p:cNvSpPr txBox="1"/>
          <p:nvPr/>
        </p:nvSpPr>
        <p:spPr>
          <a:xfrm>
            <a:off x="5603392" y="3337695"/>
            <a:ext cx="42530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</a:p>
        </p:txBody>
      </p:sp>
    </p:spTree>
    <p:extLst>
      <p:ext uri="{BB962C8B-B14F-4D97-AF65-F5344CB8AC3E}">
        <p14:creationId xmlns:p14="http://schemas.microsoft.com/office/powerpoint/2010/main" val="25554324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135AD8AC-DA1C-42E9-A1D5-DA620355F7BD}"/>
              </a:ext>
            </a:extLst>
          </p:cNvPr>
          <p:cNvGraphicFramePr>
            <a:graphicFrameLocks noGrp="1"/>
          </p:cNvGraphicFramePr>
          <p:nvPr/>
        </p:nvGraphicFramePr>
        <p:xfrm>
          <a:off x="249717" y="655702"/>
          <a:ext cx="6325200" cy="3547111"/>
        </p:xfrm>
        <a:graphic>
          <a:graphicData uri="http://schemas.openxmlformats.org/drawingml/2006/table">
            <a:tbl>
              <a:tblPr/>
              <a:tblGrid>
                <a:gridCol w="770848">
                  <a:extLst>
                    <a:ext uri="{9D8B030D-6E8A-4147-A177-3AD203B41FA5}">
                      <a16:colId xmlns:a16="http://schemas.microsoft.com/office/drawing/2014/main" val="408119151"/>
                    </a:ext>
                  </a:extLst>
                </a:gridCol>
                <a:gridCol w="694294">
                  <a:extLst>
                    <a:ext uri="{9D8B030D-6E8A-4147-A177-3AD203B41FA5}">
                      <a16:colId xmlns:a16="http://schemas.microsoft.com/office/drawing/2014/main" val="3324313370"/>
                    </a:ext>
                  </a:extLst>
                </a:gridCol>
                <a:gridCol w="694294">
                  <a:extLst>
                    <a:ext uri="{9D8B030D-6E8A-4147-A177-3AD203B41FA5}">
                      <a16:colId xmlns:a16="http://schemas.microsoft.com/office/drawing/2014/main" val="1571865117"/>
                    </a:ext>
                  </a:extLst>
                </a:gridCol>
                <a:gridCol w="694294">
                  <a:extLst>
                    <a:ext uri="{9D8B030D-6E8A-4147-A177-3AD203B41FA5}">
                      <a16:colId xmlns:a16="http://schemas.microsoft.com/office/drawing/2014/main" val="330281891"/>
                    </a:ext>
                  </a:extLst>
                </a:gridCol>
                <a:gridCol w="694294">
                  <a:extLst>
                    <a:ext uri="{9D8B030D-6E8A-4147-A177-3AD203B41FA5}">
                      <a16:colId xmlns:a16="http://schemas.microsoft.com/office/drawing/2014/main" val="1402907345"/>
                    </a:ext>
                  </a:extLst>
                </a:gridCol>
                <a:gridCol w="694294">
                  <a:extLst>
                    <a:ext uri="{9D8B030D-6E8A-4147-A177-3AD203B41FA5}">
                      <a16:colId xmlns:a16="http://schemas.microsoft.com/office/drawing/2014/main" val="1348254811"/>
                    </a:ext>
                  </a:extLst>
                </a:gridCol>
                <a:gridCol w="694294">
                  <a:extLst>
                    <a:ext uri="{9D8B030D-6E8A-4147-A177-3AD203B41FA5}">
                      <a16:colId xmlns:a16="http://schemas.microsoft.com/office/drawing/2014/main" val="1862788873"/>
                    </a:ext>
                  </a:extLst>
                </a:gridCol>
                <a:gridCol w="694294">
                  <a:extLst>
                    <a:ext uri="{9D8B030D-6E8A-4147-A177-3AD203B41FA5}">
                      <a16:colId xmlns:a16="http://schemas.microsoft.com/office/drawing/2014/main" val="2252687974"/>
                    </a:ext>
                  </a:extLst>
                </a:gridCol>
                <a:gridCol w="694294">
                  <a:extLst>
                    <a:ext uri="{9D8B030D-6E8A-4147-A177-3AD203B41FA5}">
                      <a16:colId xmlns:a16="http://schemas.microsoft.com/office/drawing/2014/main" val="868461993"/>
                    </a:ext>
                  </a:extLst>
                </a:gridCol>
              </a:tblGrid>
              <a:tr h="409575"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I-ESB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VI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AI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I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I-DB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r>
                        <a:rPr lang="en-AU" sz="12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</a:p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rd &amp; 4th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r>
                        <a:rPr lang="en-AU" sz="12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    1st &amp; 2n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</a:t>
                      </a:r>
                      <a:r>
                        <a:rPr lang="en-AU" sz="12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Na</a:t>
                      </a:r>
                      <a:r>
                        <a:rPr lang="en-AU" sz="12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rd &amp; 4th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20271230"/>
                  </a:ext>
                </a:extLst>
              </a:tr>
              <a:tr h="95250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VI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*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6AC18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90128497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5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AC18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3417950"/>
                  </a:ext>
                </a:extLst>
              </a:tr>
              <a:tr h="95250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AI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*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6DC2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*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79C7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26983579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3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DC28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6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9C78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9384404"/>
                  </a:ext>
                </a:extLst>
              </a:tr>
              <a:tr h="95250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I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*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69C1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*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*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78C78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0966933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6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9C1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7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8C78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1731008"/>
                  </a:ext>
                </a:extLst>
              </a:tr>
              <a:tr h="95250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I-DB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*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1D7B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*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BDE3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*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0D7A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*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BAE2C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74232971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0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1D7B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2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DE3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1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0D7A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4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AE2C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18451713"/>
                  </a:ext>
                </a:extLst>
              </a:tr>
              <a:tr h="109538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r>
                        <a:rPr lang="en-AU" sz="12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</a:p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rd &amp; 4th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3F9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EF7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BFCF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6FA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05271561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3F9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0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F7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FCF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6FA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35501975"/>
                  </a:ext>
                </a:extLst>
              </a:tr>
              <a:tr h="109538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r>
                        <a:rPr lang="en-AU" sz="12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    1st &amp; 2n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*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AEEE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CF6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*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BE8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F5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*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6EDD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*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B9E1C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09569623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EE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CF6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3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BE8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3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F5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6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EDD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5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E1C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2428281"/>
                  </a:ext>
                </a:extLst>
              </a:tr>
              <a:tr h="204788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</a:t>
                      </a:r>
                      <a:r>
                        <a:rPr lang="en-AU" sz="12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Na</a:t>
                      </a:r>
                      <a:r>
                        <a:rPr lang="en-AU" sz="12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    3rd &amp; 4th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4F9F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5F9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AFCF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*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7BC89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*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B0DD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02103841"/>
                  </a:ext>
                </a:extLst>
              </a:tr>
              <a:tr h="204788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F9F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5F9F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FCF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4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BC89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1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0DD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96143141"/>
                  </a:ext>
                </a:extLst>
              </a:tr>
              <a:tr h="209550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</a:t>
                      </a:r>
                      <a:r>
                        <a:rPr lang="en-AU" sz="12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Na</a:t>
                      </a:r>
                      <a:r>
                        <a:rPr lang="en-AU" sz="12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 1st &amp; 2n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FF7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BFCF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F4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AFCF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EF7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*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EE3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*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89CE9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*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9DBB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39195887"/>
                  </a:ext>
                </a:extLst>
              </a:tr>
              <a:tr h="209550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0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FF7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FCF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5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F4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FCF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1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F7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1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EE3C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5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9CE9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5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BB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6992192"/>
                  </a:ext>
                </a:extLst>
              </a:tr>
            </a:tbl>
          </a:graphicData>
        </a:graphic>
      </p:graphicFrame>
      <p:sp>
        <p:nvSpPr>
          <p:cNvPr id="7" name="Rectangle 6">
            <a:extLst>
              <a:ext uri="{FF2B5EF4-FFF2-40B4-BE49-F238E27FC236}">
                <a16:creationId xmlns:a16="http://schemas.microsoft.com/office/drawing/2014/main" id="{E2A806DD-9BBD-4471-878F-36B6CC62C551}"/>
              </a:ext>
            </a:extLst>
          </p:cNvPr>
          <p:cNvSpPr/>
          <p:nvPr/>
        </p:nvSpPr>
        <p:spPr>
          <a:xfrm>
            <a:off x="266400" y="4399844"/>
            <a:ext cx="6325200" cy="282910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AU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3: Correlation matrix of the performance of genotypes against stress and ion content related indices. </a:t>
            </a:r>
            <a:r>
              <a:rPr lang="en-AU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rrelation matrix showing the performance of morphological and ion content related traits under control and stress levels. Values in the correlation matrix values are correlation coefficients (r), with * indicating: *** P &lt; 0.001, ** P &lt; 0.01, * P &lt; 0.05, and no mark indicating no significance. STI-ESB, salt tolerance index derived from estimated shoot biomass; DVI, digital volume index; CHAI, convex hull index;  PHI, plant height index; STI-DB, salt tolerance index derived from manual dry biomass, Na</a:t>
            </a:r>
            <a:r>
              <a:rPr lang="en-AU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AU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3</a:t>
            </a:r>
            <a:r>
              <a:rPr lang="en-AU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d</a:t>
            </a:r>
            <a:r>
              <a:rPr lang="en-AU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&amp; 4</a:t>
            </a:r>
            <a:r>
              <a:rPr lang="en-AU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</a:t>
            </a:r>
            <a:r>
              <a:rPr lang="en-AU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change in sodium (Na</a:t>
            </a:r>
            <a:r>
              <a:rPr lang="en-AU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AU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content in the 3</a:t>
            </a:r>
            <a:r>
              <a:rPr lang="en-AU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d</a:t>
            </a:r>
            <a:r>
              <a:rPr lang="en-AU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&amp; 4</a:t>
            </a:r>
            <a:r>
              <a:rPr lang="en-AU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</a:t>
            </a:r>
            <a:r>
              <a:rPr lang="en-AU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eaves; Na</a:t>
            </a:r>
            <a:r>
              <a:rPr lang="en-AU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AU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1</a:t>
            </a:r>
            <a:r>
              <a:rPr lang="en-AU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</a:t>
            </a:r>
            <a:r>
              <a:rPr lang="en-AU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&amp; 2</a:t>
            </a:r>
            <a:r>
              <a:rPr lang="en-AU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d</a:t>
            </a:r>
            <a:r>
              <a:rPr lang="en-AU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change in Na</a:t>
            </a:r>
            <a:r>
              <a:rPr lang="en-AU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AU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ontent in the 1</a:t>
            </a:r>
            <a:r>
              <a:rPr lang="en-AU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</a:t>
            </a:r>
            <a:r>
              <a:rPr lang="en-AU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&amp; 2</a:t>
            </a:r>
            <a:r>
              <a:rPr lang="en-AU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d</a:t>
            </a:r>
            <a:r>
              <a:rPr lang="en-AU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youngest leaves; K</a:t>
            </a:r>
            <a:r>
              <a:rPr lang="en-AU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AU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/Na</a:t>
            </a:r>
            <a:r>
              <a:rPr lang="en-AU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 </a:t>
            </a:r>
            <a:r>
              <a:rPr lang="en-AU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AU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d</a:t>
            </a:r>
            <a:r>
              <a:rPr lang="en-AU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&amp; 4</a:t>
            </a:r>
            <a:r>
              <a:rPr lang="en-AU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</a:t>
            </a:r>
            <a:r>
              <a:rPr lang="en-AU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potassium (K</a:t>
            </a:r>
            <a:r>
              <a:rPr lang="en-AU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AU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to Na</a:t>
            </a:r>
            <a:r>
              <a:rPr lang="en-AU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AU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ratio at 250 mM treatment in the 3</a:t>
            </a:r>
            <a:r>
              <a:rPr lang="en-AU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d</a:t>
            </a:r>
            <a:r>
              <a:rPr lang="en-AU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&amp; 4</a:t>
            </a:r>
            <a:r>
              <a:rPr lang="en-AU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</a:t>
            </a:r>
            <a:r>
              <a:rPr lang="en-AU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eaves; K</a:t>
            </a:r>
            <a:r>
              <a:rPr lang="en-AU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AU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/Na</a:t>
            </a:r>
            <a:r>
              <a:rPr lang="en-AU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 </a:t>
            </a:r>
            <a:r>
              <a:rPr lang="en-AU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AU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</a:t>
            </a:r>
            <a:r>
              <a:rPr lang="en-AU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&amp; 2</a:t>
            </a:r>
            <a:r>
              <a:rPr lang="en-AU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d</a:t>
            </a:r>
            <a:r>
              <a:rPr lang="en-AU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K</a:t>
            </a:r>
            <a:r>
              <a:rPr lang="en-AU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AU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o Na</a:t>
            </a:r>
            <a:r>
              <a:rPr lang="en-AU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AU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ratio at 250 mM treatment in the 1</a:t>
            </a:r>
            <a:r>
              <a:rPr lang="en-AU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</a:t>
            </a:r>
            <a:r>
              <a:rPr lang="en-AU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&amp; 2</a:t>
            </a:r>
            <a:r>
              <a:rPr lang="en-AU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d</a:t>
            </a:r>
            <a:r>
              <a:rPr lang="en-AU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youngest leaves.</a:t>
            </a:r>
            <a:endParaRPr lang="en-AU" sz="1200" dirty="0">
              <a:latin typeface="Times New Roman" panose="02020603050405020304" pitchFamily="18" charset="0"/>
              <a:ea typeface="Calibri" panose="020F0502020204030204" pitchFamily="34" charset="0"/>
              <a:cs typeface="Tunga" panose="020B0502040204020203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21666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715</TotalTime>
  <Words>458</Words>
  <Application>Microsoft Office PowerPoint</Application>
  <PresentationFormat>On-screen Show (4:3)</PresentationFormat>
  <Paragraphs>9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lant Phenomics</dc:creator>
  <cp:lastModifiedBy>Surya Kant (DJPR)</cp:lastModifiedBy>
  <cp:revision>213</cp:revision>
  <cp:lastPrinted>2018-05-31T04:47:33Z</cp:lastPrinted>
  <dcterms:created xsi:type="dcterms:W3CDTF">2016-06-25T23:26:40Z</dcterms:created>
  <dcterms:modified xsi:type="dcterms:W3CDTF">2021-05-16T04:20:48Z</dcterms:modified>
</cp:coreProperties>
</file>